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4"/>
  </p:sldMasterIdLst>
  <p:notesMasterIdLst>
    <p:notesMasterId r:id="rId6"/>
  </p:notesMasterIdLst>
  <p:handoutMasterIdLst>
    <p:handoutMasterId r:id="rId7"/>
  </p:handoutMasterIdLst>
  <p:sldIdLst>
    <p:sldId id="410" r:id="rId5"/>
  </p:sldIdLst>
  <p:sldSz cx="6858000" cy="9906000" type="A4"/>
  <p:notesSz cx="6858000" cy="9144000"/>
  <p:custDataLst>
    <p:tags r:id="rId8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85" userDrawn="1">
          <p15:clr>
            <a:srgbClr val="A4A3A4"/>
          </p15:clr>
        </p15:guide>
        <p15:guide id="3" orient="horz" pos="3154" userDrawn="1">
          <p15:clr>
            <a:srgbClr val="A4A3A4"/>
          </p15:clr>
        </p15:guide>
        <p15:guide id="4" pos="2214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90137717" name="寒雪银杏" initials="寒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096980A-64C4-EE47-9C28-6C2F474A9E50}" v="12" dt="2025-02-18T14:51:20.436"/>
    <p1510:client id="{F9D158F7-A57F-45C3-B9D5-554D24C9C5AC}" v="1" dt="2025-02-18T11:32:25.567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浅色样式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60" d="100"/>
          <a:sy n="160" d="100"/>
        </p:scale>
        <p:origin x="1068" y="-4008"/>
      </p:cViewPr>
      <p:guideLst>
        <p:guide orient="horz" pos="3085"/>
        <p:guide orient="horz" pos="3154"/>
        <p:guide pos="221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1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handoutMaster" Target="handoutMasters/handoutMaster1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openxmlformats.org/officeDocument/2006/relationships/viewProps" Target="viewProps.xml"/><Relationship Id="rId5" Type="http://schemas.openxmlformats.org/officeDocument/2006/relationships/slide" Target="slides/slide1.xml"/><Relationship Id="rId15" Type="http://schemas.microsoft.com/office/2015/10/relationships/revisionInfo" Target="revisionInfo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commentAuthors" Target="commentAuthors.xml"/><Relationship Id="rId14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moth, CJC" userId="9fd10590-716c-41f9-b907-ea3606eab60c" providerId="ADAL" clId="{E096980A-64C4-EE47-9C28-6C2F474A9E50}"/>
    <pc:docChg chg="custSel modSld">
      <pc:chgData name="Lamoth, CJC" userId="9fd10590-716c-41f9-b907-ea3606eab60c" providerId="ADAL" clId="{E096980A-64C4-EE47-9C28-6C2F474A9E50}" dt="2025-02-18T14:51:20.437" v="120" actId="20577"/>
      <pc:docMkLst>
        <pc:docMk/>
      </pc:docMkLst>
      <pc:sldChg chg="delSp modSp mod">
        <pc:chgData name="Lamoth, CJC" userId="9fd10590-716c-41f9-b907-ea3606eab60c" providerId="ADAL" clId="{E096980A-64C4-EE47-9C28-6C2F474A9E50}" dt="2025-02-18T14:51:20.437" v="120" actId="20577"/>
        <pc:sldMkLst>
          <pc:docMk/>
          <pc:sldMk cId="3117842035" sldId="410"/>
        </pc:sldMkLst>
        <pc:spChg chg="mod">
          <ac:chgData name="Lamoth, CJC" userId="9fd10590-716c-41f9-b907-ea3606eab60c" providerId="ADAL" clId="{E096980A-64C4-EE47-9C28-6C2F474A9E50}" dt="2025-02-18T11:25:34.399" v="97" actId="207"/>
          <ac:spMkLst>
            <pc:docMk/>
            <pc:sldMk cId="3117842035" sldId="410"/>
            <ac:spMk id="32" creationId="{C44C5DCB-9789-4AF4-C0CB-225F9470F953}"/>
          </ac:spMkLst>
        </pc:spChg>
        <pc:spChg chg="del">
          <ac:chgData name="Lamoth, CJC" userId="9fd10590-716c-41f9-b907-ea3606eab60c" providerId="ADAL" clId="{E096980A-64C4-EE47-9C28-6C2F474A9E50}" dt="2025-02-18T11:27:00.386" v="107" actId="478"/>
          <ac:spMkLst>
            <pc:docMk/>
            <pc:sldMk cId="3117842035" sldId="410"/>
            <ac:spMk id="33" creationId="{B6A48882-CCAC-2EB8-B00D-6CFBAC1D4243}"/>
          </ac:spMkLst>
        </pc:spChg>
        <pc:spChg chg="mod">
          <ac:chgData name="Lamoth, CJC" userId="9fd10590-716c-41f9-b907-ea3606eab60c" providerId="ADAL" clId="{E096980A-64C4-EE47-9C28-6C2F474A9E50}" dt="2025-02-18T14:51:20.437" v="120" actId="20577"/>
          <ac:spMkLst>
            <pc:docMk/>
            <pc:sldMk cId="3117842035" sldId="410"/>
            <ac:spMk id="45" creationId="{4AB6BF11-BBFB-E6F9-F205-072BBCF9A29D}"/>
          </ac:spMkLst>
        </pc:spChg>
        <pc:spChg chg="mod">
          <ac:chgData name="Lamoth, CJC" userId="9fd10590-716c-41f9-b907-ea3606eab60c" providerId="ADAL" clId="{E096980A-64C4-EE47-9C28-6C2F474A9E50}" dt="2025-02-18T11:27:03.030" v="108" actId="20577"/>
          <ac:spMkLst>
            <pc:docMk/>
            <pc:sldMk cId="3117842035" sldId="410"/>
            <ac:spMk id="217" creationId="{700C5413-2AC7-57A7-B9B8-3E86A811E356}"/>
          </ac:spMkLst>
        </pc:spChg>
        <pc:graphicFrameChg chg="modGraphic">
          <ac:chgData name="Lamoth, CJC" userId="9fd10590-716c-41f9-b907-ea3606eab60c" providerId="ADAL" clId="{E096980A-64C4-EE47-9C28-6C2F474A9E50}" dt="2025-02-18T14:51:00.509" v="112" actId="20577"/>
          <ac:graphicFrameMkLst>
            <pc:docMk/>
            <pc:sldMk cId="3117842035" sldId="410"/>
            <ac:graphicFrameMk id="10" creationId="{FDC38EC0-5D6B-B183-AE2E-E3D09F8FB677}"/>
          </ac:graphicFrameMkLst>
        </pc:graphicFrameChg>
      </pc:sldChg>
    </pc:docChg>
  </pc:docChgLst>
  <pc:docChgLst>
    <pc:chgData name="Zhang, X (bw)" userId="8c11a9ad-4ec2-408f-b77f-edf277d143b8" providerId="ADAL" clId="{917AA4CC-9489-41C4-AF82-0BBF3A8480D9}"/>
    <pc:docChg chg="undo custSel delSld modSld sldOrd">
      <pc:chgData name="Zhang, X (bw)" userId="8c11a9ad-4ec2-408f-b77f-edf277d143b8" providerId="ADAL" clId="{917AA4CC-9489-41C4-AF82-0BBF3A8480D9}" dt="2025-02-17T09:57:23.748" v="285" actId="1076"/>
      <pc:docMkLst>
        <pc:docMk/>
      </pc:docMkLst>
      <pc:sldChg chg="modSp mod">
        <pc:chgData name="Zhang, X (bw)" userId="8c11a9ad-4ec2-408f-b77f-edf277d143b8" providerId="ADAL" clId="{917AA4CC-9489-41C4-AF82-0BBF3A8480D9}" dt="2025-02-17T09:22:41.963" v="19" actId="1076"/>
        <pc:sldMkLst>
          <pc:docMk/>
          <pc:sldMk cId="0" sldId="314"/>
        </pc:sldMkLst>
        <pc:spChg chg="mod">
          <ac:chgData name="Zhang, X (bw)" userId="8c11a9ad-4ec2-408f-b77f-edf277d143b8" providerId="ADAL" clId="{917AA4CC-9489-41C4-AF82-0BBF3A8480D9}" dt="2025-02-17T09:22:24.864" v="17" actId="403"/>
          <ac:spMkLst>
            <pc:docMk/>
            <pc:sldMk cId="0" sldId="314"/>
            <ac:spMk id="9" creationId="{00000000-0000-0000-0000-000000000000}"/>
          </ac:spMkLst>
        </pc:spChg>
        <pc:spChg chg="mod">
          <ac:chgData name="Zhang, X (bw)" userId="8c11a9ad-4ec2-408f-b77f-edf277d143b8" providerId="ADAL" clId="{917AA4CC-9489-41C4-AF82-0BBF3A8480D9}" dt="2025-02-17T09:17:51.144" v="2" actId="20577"/>
          <ac:spMkLst>
            <pc:docMk/>
            <pc:sldMk cId="0" sldId="314"/>
            <ac:spMk id="16" creationId="{00000000-0000-0000-0000-000000000000}"/>
          </ac:spMkLst>
        </pc:spChg>
        <pc:spChg chg="mod">
          <ac:chgData name="Zhang, X (bw)" userId="8c11a9ad-4ec2-408f-b77f-edf277d143b8" providerId="ADAL" clId="{917AA4CC-9489-41C4-AF82-0BBF3A8480D9}" dt="2025-02-17T09:22:41.963" v="19" actId="1076"/>
          <ac:spMkLst>
            <pc:docMk/>
            <pc:sldMk cId="0" sldId="314"/>
            <ac:spMk id="20" creationId="{67B508D1-A4C1-4020-B0F0-168365E4DC04}"/>
          </ac:spMkLst>
        </pc:spChg>
        <pc:grpChg chg="mod">
          <ac:chgData name="Zhang, X (bw)" userId="8c11a9ad-4ec2-408f-b77f-edf277d143b8" providerId="ADAL" clId="{917AA4CC-9489-41C4-AF82-0BBF3A8480D9}" dt="2025-02-17T09:17:32.612" v="1" actId="255"/>
          <ac:grpSpMkLst>
            <pc:docMk/>
            <pc:sldMk cId="0" sldId="314"/>
            <ac:grpSpMk id="21" creationId="{6A829C15-6B94-4460-28D4-21EE852BF143}"/>
          </ac:grpSpMkLst>
        </pc:grpChg>
      </pc:sldChg>
      <pc:sldChg chg="delSp modSp mod ord">
        <pc:chgData name="Zhang, X (bw)" userId="8c11a9ad-4ec2-408f-b77f-edf277d143b8" providerId="ADAL" clId="{917AA4CC-9489-41C4-AF82-0BBF3A8480D9}" dt="2025-02-17T09:53:52.332" v="224"/>
        <pc:sldMkLst>
          <pc:docMk/>
          <pc:sldMk cId="3549655527" sldId="406"/>
        </pc:sldMkLst>
        <pc:spChg chg="mod topLvl">
          <ac:chgData name="Zhang, X (bw)" userId="8c11a9ad-4ec2-408f-b77f-edf277d143b8" providerId="ADAL" clId="{917AA4CC-9489-41C4-AF82-0BBF3A8480D9}" dt="2025-02-17T09:35:56.044" v="24" actId="165"/>
          <ac:spMkLst>
            <pc:docMk/>
            <pc:sldMk cId="3549655527" sldId="406"/>
            <ac:spMk id="3" creationId="{DE06E6C1-91FB-C035-2986-6A77E9024AA7}"/>
          </ac:spMkLst>
        </pc:spChg>
        <pc:spChg chg="mod topLvl">
          <ac:chgData name="Zhang, X (bw)" userId="8c11a9ad-4ec2-408f-b77f-edf277d143b8" providerId="ADAL" clId="{917AA4CC-9489-41C4-AF82-0BBF3A8480D9}" dt="2025-02-17T09:35:56.044" v="24" actId="165"/>
          <ac:spMkLst>
            <pc:docMk/>
            <pc:sldMk cId="3549655527" sldId="406"/>
            <ac:spMk id="36" creationId="{00000000-0000-0000-0000-000000000000}"/>
          </ac:spMkLst>
        </pc:spChg>
        <pc:spChg chg="mod topLvl">
          <ac:chgData name="Zhang, X (bw)" userId="8c11a9ad-4ec2-408f-b77f-edf277d143b8" providerId="ADAL" clId="{917AA4CC-9489-41C4-AF82-0BBF3A8480D9}" dt="2025-02-17T09:35:56.044" v="24" actId="165"/>
          <ac:spMkLst>
            <pc:docMk/>
            <pc:sldMk cId="3549655527" sldId="406"/>
            <ac:spMk id="39" creationId="{00000000-0000-0000-0000-000000000000}"/>
          </ac:spMkLst>
        </pc:spChg>
        <pc:spChg chg="mod">
          <ac:chgData name="Zhang, X (bw)" userId="8c11a9ad-4ec2-408f-b77f-edf277d143b8" providerId="ADAL" clId="{917AA4CC-9489-41C4-AF82-0BBF3A8480D9}" dt="2025-02-17T09:19:12.043" v="3" actId="2711"/>
          <ac:spMkLst>
            <pc:docMk/>
            <pc:sldMk cId="3549655527" sldId="406"/>
            <ac:spMk id="70" creationId="{161861FD-C719-4ABF-8E54-570E2024B5D3}"/>
          </ac:spMkLst>
        </pc:spChg>
        <pc:spChg chg="mod">
          <ac:chgData name="Zhang, X (bw)" userId="8c11a9ad-4ec2-408f-b77f-edf277d143b8" providerId="ADAL" clId="{917AA4CC-9489-41C4-AF82-0BBF3A8480D9}" dt="2025-02-17T09:19:12.043" v="3" actId="2711"/>
          <ac:spMkLst>
            <pc:docMk/>
            <pc:sldMk cId="3549655527" sldId="406"/>
            <ac:spMk id="80" creationId="{0DD3B0ED-6D16-4BE5-A37D-FEC710E01B97}"/>
          </ac:spMkLst>
        </pc:spChg>
        <pc:spChg chg="mod">
          <ac:chgData name="Zhang, X (bw)" userId="8c11a9ad-4ec2-408f-b77f-edf277d143b8" providerId="ADAL" clId="{917AA4CC-9489-41C4-AF82-0BBF3A8480D9}" dt="2025-02-17T09:19:12.043" v="3" actId="2711"/>
          <ac:spMkLst>
            <pc:docMk/>
            <pc:sldMk cId="3549655527" sldId="406"/>
            <ac:spMk id="86" creationId="{DAD3BB0E-767D-4317-927F-C5C600C8B404}"/>
          </ac:spMkLst>
        </pc:spChg>
        <pc:spChg chg="mod">
          <ac:chgData name="Zhang, X (bw)" userId="8c11a9ad-4ec2-408f-b77f-edf277d143b8" providerId="ADAL" clId="{917AA4CC-9489-41C4-AF82-0BBF3A8480D9}" dt="2025-02-17T09:19:12.043" v="3" actId="2711"/>
          <ac:spMkLst>
            <pc:docMk/>
            <pc:sldMk cId="3549655527" sldId="406"/>
            <ac:spMk id="87" creationId="{B395CA94-2DD9-4B75-A93E-911CF3BDEC38}"/>
          </ac:spMkLst>
        </pc:spChg>
        <pc:spChg chg="mod">
          <ac:chgData name="Zhang, X (bw)" userId="8c11a9ad-4ec2-408f-b77f-edf277d143b8" providerId="ADAL" clId="{917AA4CC-9489-41C4-AF82-0BBF3A8480D9}" dt="2025-02-17T09:36:18.727" v="45" actId="1035"/>
          <ac:spMkLst>
            <pc:docMk/>
            <pc:sldMk cId="3549655527" sldId="406"/>
            <ac:spMk id="100" creationId="{73BBDD0B-B63D-43C5-B992-728F1F7630AF}"/>
          </ac:spMkLst>
        </pc:spChg>
        <pc:spChg chg="mod">
          <ac:chgData name="Zhang, X (bw)" userId="8c11a9ad-4ec2-408f-b77f-edf277d143b8" providerId="ADAL" clId="{917AA4CC-9489-41C4-AF82-0BBF3A8480D9}" dt="2025-02-17T09:19:12.043" v="3" actId="2711"/>
          <ac:spMkLst>
            <pc:docMk/>
            <pc:sldMk cId="3549655527" sldId="406"/>
            <ac:spMk id="104" creationId="{3635EC34-1D7F-4D92-AAF0-E1564951BEC1}"/>
          </ac:spMkLst>
        </pc:spChg>
        <pc:spChg chg="mod">
          <ac:chgData name="Zhang, X (bw)" userId="8c11a9ad-4ec2-408f-b77f-edf277d143b8" providerId="ADAL" clId="{917AA4CC-9489-41C4-AF82-0BBF3A8480D9}" dt="2025-02-17T09:19:12.043" v="3" actId="2711"/>
          <ac:spMkLst>
            <pc:docMk/>
            <pc:sldMk cId="3549655527" sldId="406"/>
            <ac:spMk id="110" creationId="{DF4FF47E-C5BB-442E-8A0C-5ED0FE4101AB}"/>
          </ac:spMkLst>
        </pc:spChg>
        <pc:spChg chg="mod topLvl">
          <ac:chgData name="Zhang, X (bw)" userId="8c11a9ad-4ec2-408f-b77f-edf277d143b8" providerId="ADAL" clId="{917AA4CC-9489-41C4-AF82-0BBF3A8480D9}" dt="2025-02-17T09:35:56.044" v="24" actId="165"/>
          <ac:spMkLst>
            <pc:docMk/>
            <pc:sldMk cId="3549655527" sldId="406"/>
            <ac:spMk id="114" creationId="{0389C67D-A83E-4CB3-813D-55E8AADE3EC9}"/>
          </ac:spMkLst>
        </pc:spChg>
        <pc:spChg chg="mod">
          <ac:chgData name="Zhang, X (bw)" userId="8c11a9ad-4ec2-408f-b77f-edf277d143b8" providerId="ADAL" clId="{917AA4CC-9489-41C4-AF82-0BBF3A8480D9}" dt="2025-02-17T09:19:12.043" v="3" actId="2711"/>
          <ac:spMkLst>
            <pc:docMk/>
            <pc:sldMk cId="3549655527" sldId="406"/>
            <ac:spMk id="116" creationId="{0B10C69F-8233-417F-AE7E-7E6566567ABD}"/>
          </ac:spMkLst>
        </pc:spChg>
        <pc:spChg chg="mod">
          <ac:chgData name="Zhang, X (bw)" userId="8c11a9ad-4ec2-408f-b77f-edf277d143b8" providerId="ADAL" clId="{917AA4CC-9489-41C4-AF82-0BBF3A8480D9}" dt="2025-02-17T09:36:18.727" v="45" actId="1035"/>
          <ac:spMkLst>
            <pc:docMk/>
            <pc:sldMk cId="3549655527" sldId="406"/>
            <ac:spMk id="119" creationId="{6B9223EB-77CE-43B3-B152-DCEC786FD41E}"/>
          </ac:spMkLst>
        </pc:spChg>
        <pc:spChg chg="mod topLvl">
          <ac:chgData name="Zhang, X (bw)" userId="8c11a9ad-4ec2-408f-b77f-edf277d143b8" providerId="ADAL" clId="{917AA4CC-9489-41C4-AF82-0BBF3A8480D9}" dt="2025-02-17T09:35:56.044" v="24" actId="165"/>
          <ac:spMkLst>
            <pc:docMk/>
            <pc:sldMk cId="3549655527" sldId="406"/>
            <ac:spMk id="124" creationId="{68D9BC49-B69E-4E3D-A09C-96D66EEB0873}"/>
          </ac:spMkLst>
        </pc:spChg>
        <pc:spChg chg="mod">
          <ac:chgData name="Zhang, X (bw)" userId="8c11a9ad-4ec2-408f-b77f-edf277d143b8" providerId="ADAL" clId="{917AA4CC-9489-41C4-AF82-0BBF3A8480D9}" dt="2025-02-17T09:19:12.043" v="3" actId="2711"/>
          <ac:spMkLst>
            <pc:docMk/>
            <pc:sldMk cId="3549655527" sldId="406"/>
            <ac:spMk id="125" creationId="{CC995ADB-BB2A-4513-BFB7-0E5B5523B69F}"/>
          </ac:spMkLst>
        </pc:spChg>
        <pc:spChg chg="mod">
          <ac:chgData name="Zhang, X (bw)" userId="8c11a9ad-4ec2-408f-b77f-edf277d143b8" providerId="ADAL" clId="{917AA4CC-9489-41C4-AF82-0BBF3A8480D9}" dt="2025-02-17T09:36:18.727" v="45" actId="1035"/>
          <ac:spMkLst>
            <pc:docMk/>
            <pc:sldMk cId="3549655527" sldId="406"/>
            <ac:spMk id="136" creationId="{FCF428CE-A272-4927-A877-B5A51119ACCE}"/>
          </ac:spMkLst>
        </pc:spChg>
        <pc:spChg chg="mod">
          <ac:chgData name="Zhang, X (bw)" userId="8c11a9ad-4ec2-408f-b77f-edf277d143b8" providerId="ADAL" clId="{917AA4CC-9489-41C4-AF82-0BBF3A8480D9}" dt="2025-02-17T09:36:18.727" v="45" actId="1035"/>
          <ac:spMkLst>
            <pc:docMk/>
            <pc:sldMk cId="3549655527" sldId="406"/>
            <ac:spMk id="137" creationId="{B564E2D6-146D-460C-B8A0-763DAB12FA54}"/>
          </ac:spMkLst>
        </pc:spChg>
        <pc:spChg chg="mod topLvl">
          <ac:chgData name="Zhang, X (bw)" userId="8c11a9ad-4ec2-408f-b77f-edf277d143b8" providerId="ADAL" clId="{917AA4CC-9489-41C4-AF82-0BBF3A8480D9}" dt="2025-02-17T09:35:56.044" v="24" actId="165"/>
          <ac:spMkLst>
            <pc:docMk/>
            <pc:sldMk cId="3549655527" sldId="406"/>
            <ac:spMk id="138" creationId="{D8EEC768-76A6-40A5-98E9-C7D2EC27C824}"/>
          </ac:spMkLst>
        </pc:spChg>
        <pc:spChg chg="mod">
          <ac:chgData name="Zhang, X (bw)" userId="8c11a9ad-4ec2-408f-b77f-edf277d143b8" providerId="ADAL" clId="{917AA4CC-9489-41C4-AF82-0BBF3A8480D9}" dt="2025-02-17T09:36:18.727" v="45" actId="1035"/>
          <ac:spMkLst>
            <pc:docMk/>
            <pc:sldMk cId="3549655527" sldId="406"/>
            <ac:spMk id="143" creationId="{61881E25-F1F7-46B6-ABD2-DE9ED6DF5077}"/>
          </ac:spMkLst>
        </pc:spChg>
        <pc:spChg chg="mod topLvl">
          <ac:chgData name="Zhang, X (bw)" userId="8c11a9ad-4ec2-408f-b77f-edf277d143b8" providerId="ADAL" clId="{917AA4CC-9489-41C4-AF82-0BBF3A8480D9}" dt="2025-02-17T09:36:18.727" v="45" actId="1035"/>
          <ac:spMkLst>
            <pc:docMk/>
            <pc:sldMk cId="3549655527" sldId="406"/>
            <ac:spMk id="144" creationId="{56EFE496-ECD4-4D7A-A868-5EE1437C4F76}"/>
          </ac:spMkLst>
        </pc:spChg>
        <pc:spChg chg="mod">
          <ac:chgData name="Zhang, X (bw)" userId="8c11a9ad-4ec2-408f-b77f-edf277d143b8" providerId="ADAL" clId="{917AA4CC-9489-41C4-AF82-0BBF3A8480D9}" dt="2025-02-17T09:36:18.727" v="45" actId="1035"/>
          <ac:spMkLst>
            <pc:docMk/>
            <pc:sldMk cId="3549655527" sldId="406"/>
            <ac:spMk id="145" creationId="{94863FF3-9BF2-4CEC-9847-D92E55E209EF}"/>
          </ac:spMkLst>
        </pc:spChg>
        <pc:spChg chg="mod">
          <ac:chgData name="Zhang, X (bw)" userId="8c11a9ad-4ec2-408f-b77f-edf277d143b8" providerId="ADAL" clId="{917AA4CC-9489-41C4-AF82-0BBF3A8480D9}" dt="2025-02-17T09:36:18.727" v="45" actId="1035"/>
          <ac:spMkLst>
            <pc:docMk/>
            <pc:sldMk cId="3549655527" sldId="406"/>
            <ac:spMk id="146" creationId="{6302CF07-CB93-48EF-90C7-3322FB63C5F8}"/>
          </ac:spMkLst>
        </pc:spChg>
        <pc:spChg chg="mod">
          <ac:chgData name="Zhang, X (bw)" userId="8c11a9ad-4ec2-408f-b77f-edf277d143b8" providerId="ADAL" clId="{917AA4CC-9489-41C4-AF82-0BBF3A8480D9}" dt="2025-02-17T09:36:18.727" v="45" actId="1035"/>
          <ac:spMkLst>
            <pc:docMk/>
            <pc:sldMk cId="3549655527" sldId="406"/>
            <ac:spMk id="150" creationId="{68C94D0F-16E1-41A5-8166-FABB25DA6C4E}"/>
          </ac:spMkLst>
        </pc:spChg>
        <pc:spChg chg="mod topLvl">
          <ac:chgData name="Zhang, X (bw)" userId="8c11a9ad-4ec2-408f-b77f-edf277d143b8" providerId="ADAL" clId="{917AA4CC-9489-41C4-AF82-0BBF3A8480D9}" dt="2025-02-17T09:35:56.044" v="24" actId="165"/>
          <ac:spMkLst>
            <pc:docMk/>
            <pc:sldMk cId="3549655527" sldId="406"/>
            <ac:spMk id="151" creationId="{61B050CA-7511-4E58-AB7C-31E04057074C}"/>
          </ac:spMkLst>
        </pc:spChg>
        <pc:spChg chg="mod">
          <ac:chgData name="Zhang, X (bw)" userId="8c11a9ad-4ec2-408f-b77f-edf277d143b8" providerId="ADAL" clId="{917AA4CC-9489-41C4-AF82-0BBF3A8480D9}" dt="2025-02-17T09:36:18.727" v="45" actId="1035"/>
          <ac:spMkLst>
            <pc:docMk/>
            <pc:sldMk cId="3549655527" sldId="406"/>
            <ac:spMk id="154" creationId="{B9D0CE18-CDE8-4396-AE05-C55D1638980F}"/>
          </ac:spMkLst>
        </pc:spChg>
        <pc:spChg chg="mod topLvl">
          <ac:chgData name="Zhang, X (bw)" userId="8c11a9ad-4ec2-408f-b77f-edf277d143b8" providerId="ADAL" clId="{917AA4CC-9489-41C4-AF82-0BBF3A8480D9}" dt="2025-02-17T09:35:56.044" v="24" actId="165"/>
          <ac:spMkLst>
            <pc:docMk/>
            <pc:sldMk cId="3549655527" sldId="406"/>
            <ac:spMk id="179" creationId="{00000000-0000-0000-0000-000000000000}"/>
          </ac:spMkLst>
        </pc:spChg>
        <pc:spChg chg="mod topLvl">
          <ac:chgData name="Zhang, X (bw)" userId="8c11a9ad-4ec2-408f-b77f-edf277d143b8" providerId="ADAL" clId="{917AA4CC-9489-41C4-AF82-0BBF3A8480D9}" dt="2025-02-17T09:35:56.044" v="24" actId="165"/>
          <ac:spMkLst>
            <pc:docMk/>
            <pc:sldMk cId="3549655527" sldId="406"/>
            <ac:spMk id="189" creationId="{00000000-0000-0000-0000-000000000000}"/>
          </ac:spMkLst>
        </pc:spChg>
        <pc:graphicFrameChg chg="modGraphic">
          <ac:chgData name="Zhang, X (bw)" userId="8c11a9ad-4ec2-408f-b77f-edf277d143b8" providerId="ADAL" clId="{917AA4CC-9489-41C4-AF82-0BBF3A8480D9}" dt="2025-02-17T09:35:42.993" v="23" actId="2165"/>
          <ac:graphicFrameMkLst>
            <pc:docMk/>
            <pc:sldMk cId="3549655527" sldId="406"/>
            <ac:graphicFrameMk id="2" creationId="{00000000-0000-0000-0000-000000000000}"/>
          </ac:graphicFrameMkLst>
        </pc:graphicFrameChg>
      </pc:sldChg>
      <pc:sldChg chg="ord">
        <pc:chgData name="Zhang, X (bw)" userId="8c11a9ad-4ec2-408f-b77f-edf277d143b8" providerId="ADAL" clId="{917AA4CC-9489-41C4-AF82-0BBF3A8480D9}" dt="2025-02-17T09:53:21.501" v="216"/>
        <pc:sldMkLst>
          <pc:docMk/>
          <pc:sldMk cId="1795958423" sldId="407"/>
        </pc:sldMkLst>
      </pc:sldChg>
      <pc:sldChg chg="modSp del mod">
        <pc:chgData name="Zhang, X (bw)" userId="8c11a9ad-4ec2-408f-b77f-edf277d143b8" providerId="ADAL" clId="{917AA4CC-9489-41C4-AF82-0BBF3A8480D9}" dt="2025-02-17T09:52:12.471" v="210" actId="2696"/>
        <pc:sldMkLst>
          <pc:docMk/>
          <pc:sldMk cId="1961864004" sldId="407"/>
        </pc:sldMkLst>
        <pc:spChg chg="mod">
          <ac:chgData name="Zhang, X (bw)" userId="8c11a9ad-4ec2-408f-b77f-edf277d143b8" providerId="ADAL" clId="{917AA4CC-9489-41C4-AF82-0BBF3A8480D9}" dt="2025-02-17T09:20:50.339" v="12" actId="2711"/>
          <ac:spMkLst>
            <pc:docMk/>
            <pc:sldMk cId="1961864004" sldId="407"/>
            <ac:spMk id="36" creationId="{8E1942A8-869C-2A8E-B923-367AB6FE81FF}"/>
          </ac:spMkLst>
        </pc:spChg>
        <pc:spChg chg="mod">
          <ac:chgData name="Zhang, X (bw)" userId="8c11a9ad-4ec2-408f-b77f-edf277d143b8" providerId="ADAL" clId="{917AA4CC-9489-41C4-AF82-0BBF3A8480D9}" dt="2025-02-17T09:20:29.214" v="11" actId="255"/>
          <ac:spMkLst>
            <pc:docMk/>
            <pc:sldMk cId="1961864004" sldId="407"/>
            <ac:spMk id="39" creationId="{4BE993B3-4CED-9D06-46A9-A4D052A17060}"/>
          </ac:spMkLst>
        </pc:spChg>
        <pc:spChg chg="mod">
          <ac:chgData name="Zhang, X (bw)" userId="8c11a9ad-4ec2-408f-b77f-edf277d143b8" providerId="ADAL" clId="{917AA4CC-9489-41C4-AF82-0BBF3A8480D9}" dt="2025-02-17T09:20:29.214" v="11" actId="255"/>
          <ac:spMkLst>
            <pc:docMk/>
            <pc:sldMk cId="1961864004" sldId="407"/>
            <ac:spMk id="46" creationId="{4DDAF214-A72C-A864-44B3-EB5DCFA9C872}"/>
          </ac:spMkLst>
        </pc:spChg>
        <pc:spChg chg="mod">
          <ac:chgData name="Zhang, X (bw)" userId="8c11a9ad-4ec2-408f-b77f-edf277d143b8" providerId="ADAL" clId="{917AA4CC-9489-41C4-AF82-0BBF3A8480D9}" dt="2025-02-17T09:20:29.214" v="11" actId="255"/>
          <ac:spMkLst>
            <pc:docMk/>
            <pc:sldMk cId="1961864004" sldId="407"/>
            <ac:spMk id="68" creationId="{ED7BFD7D-93F0-5C9B-6B25-28334DA72363}"/>
          </ac:spMkLst>
        </pc:spChg>
        <pc:spChg chg="mod">
          <ac:chgData name="Zhang, X (bw)" userId="8c11a9ad-4ec2-408f-b77f-edf277d143b8" providerId="ADAL" clId="{917AA4CC-9489-41C4-AF82-0BBF3A8480D9}" dt="2025-02-17T09:20:50.339" v="12" actId="2711"/>
          <ac:spMkLst>
            <pc:docMk/>
            <pc:sldMk cId="1961864004" sldId="407"/>
            <ac:spMk id="71" creationId="{9D6A939B-F934-1EBB-6B9C-72DD5F978CD3}"/>
          </ac:spMkLst>
        </pc:spChg>
        <pc:spChg chg="mod">
          <ac:chgData name="Zhang, X (bw)" userId="8c11a9ad-4ec2-408f-b77f-edf277d143b8" providerId="ADAL" clId="{917AA4CC-9489-41C4-AF82-0BBF3A8480D9}" dt="2025-02-17T09:20:29.214" v="11" actId="255"/>
          <ac:spMkLst>
            <pc:docMk/>
            <pc:sldMk cId="1961864004" sldId="407"/>
            <ac:spMk id="74" creationId="{D90904FC-1D37-88AF-86F6-95010B725394}"/>
          </ac:spMkLst>
        </pc:spChg>
        <pc:spChg chg="mod">
          <ac:chgData name="Zhang, X (bw)" userId="8c11a9ad-4ec2-408f-b77f-edf277d143b8" providerId="ADAL" clId="{917AA4CC-9489-41C4-AF82-0BBF3A8480D9}" dt="2025-02-17T09:20:29.214" v="11" actId="255"/>
          <ac:spMkLst>
            <pc:docMk/>
            <pc:sldMk cId="1961864004" sldId="407"/>
            <ac:spMk id="97" creationId="{BE24E163-B87F-8C2E-1CF3-4B982B6A01A5}"/>
          </ac:spMkLst>
        </pc:spChg>
        <pc:spChg chg="mod">
          <ac:chgData name="Zhang, X (bw)" userId="8c11a9ad-4ec2-408f-b77f-edf277d143b8" providerId="ADAL" clId="{917AA4CC-9489-41C4-AF82-0BBF3A8480D9}" dt="2025-02-17T09:20:50.339" v="12" actId="2711"/>
          <ac:spMkLst>
            <pc:docMk/>
            <pc:sldMk cId="1961864004" sldId="407"/>
            <ac:spMk id="104" creationId="{08DE08D4-8111-64B7-643E-AD87443E22A1}"/>
          </ac:spMkLst>
        </pc:spChg>
        <pc:spChg chg="mod">
          <ac:chgData name="Zhang, X (bw)" userId="8c11a9ad-4ec2-408f-b77f-edf277d143b8" providerId="ADAL" clId="{917AA4CC-9489-41C4-AF82-0BBF3A8480D9}" dt="2025-02-17T09:20:50.339" v="12" actId="2711"/>
          <ac:spMkLst>
            <pc:docMk/>
            <pc:sldMk cId="1961864004" sldId="407"/>
            <ac:spMk id="118" creationId="{5CC95831-86AE-2A54-F5B0-609AE4172EE4}"/>
          </ac:spMkLst>
        </pc:spChg>
        <pc:spChg chg="mod">
          <ac:chgData name="Zhang, X (bw)" userId="8c11a9ad-4ec2-408f-b77f-edf277d143b8" providerId="ADAL" clId="{917AA4CC-9489-41C4-AF82-0BBF3A8480D9}" dt="2025-02-17T09:20:50.339" v="12" actId="2711"/>
          <ac:spMkLst>
            <pc:docMk/>
            <pc:sldMk cId="1961864004" sldId="407"/>
            <ac:spMk id="124" creationId="{5679CFFA-A58A-A670-98CD-4E2055396A76}"/>
          </ac:spMkLst>
        </pc:spChg>
        <pc:spChg chg="mod">
          <ac:chgData name="Zhang, X (bw)" userId="8c11a9ad-4ec2-408f-b77f-edf277d143b8" providerId="ADAL" clId="{917AA4CC-9489-41C4-AF82-0BBF3A8480D9}" dt="2025-02-17T09:20:29.214" v="11" actId="255"/>
          <ac:spMkLst>
            <pc:docMk/>
            <pc:sldMk cId="1961864004" sldId="407"/>
            <ac:spMk id="126" creationId="{B3563D19-C872-F4D6-C5C4-95F086FCA231}"/>
          </ac:spMkLst>
        </pc:spChg>
        <pc:spChg chg="mod">
          <ac:chgData name="Zhang, X (bw)" userId="8c11a9ad-4ec2-408f-b77f-edf277d143b8" providerId="ADAL" clId="{917AA4CC-9489-41C4-AF82-0BBF3A8480D9}" dt="2025-02-17T09:20:50.339" v="12" actId="2711"/>
          <ac:spMkLst>
            <pc:docMk/>
            <pc:sldMk cId="1961864004" sldId="407"/>
            <ac:spMk id="132" creationId="{A2738033-6EBF-428F-A185-855B141E61AF}"/>
          </ac:spMkLst>
        </pc:spChg>
        <pc:spChg chg="mod">
          <ac:chgData name="Zhang, X (bw)" userId="8c11a9ad-4ec2-408f-b77f-edf277d143b8" providerId="ADAL" clId="{917AA4CC-9489-41C4-AF82-0BBF3A8480D9}" dt="2025-02-17T09:20:50.339" v="12" actId="2711"/>
          <ac:spMkLst>
            <pc:docMk/>
            <pc:sldMk cId="1961864004" sldId="407"/>
            <ac:spMk id="133" creationId="{D66C90AF-A102-541F-E673-190A3AF861D9}"/>
          </ac:spMkLst>
        </pc:spChg>
        <pc:spChg chg="mod">
          <ac:chgData name="Zhang, X (bw)" userId="8c11a9ad-4ec2-408f-b77f-edf277d143b8" providerId="ADAL" clId="{917AA4CC-9489-41C4-AF82-0BBF3A8480D9}" dt="2025-02-17T09:20:50.339" v="12" actId="2711"/>
          <ac:spMkLst>
            <pc:docMk/>
            <pc:sldMk cId="1961864004" sldId="407"/>
            <ac:spMk id="138" creationId="{8AD61F8A-EBFA-698A-4FB0-8E926CE2B932}"/>
          </ac:spMkLst>
        </pc:spChg>
        <pc:spChg chg="mod">
          <ac:chgData name="Zhang, X (bw)" userId="8c11a9ad-4ec2-408f-b77f-edf277d143b8" providerId="ADAL" clId="{917AA4CC-9489-41C4-AF82-0BBF3A8480D9}" dt="2025-02-17T09:20:29.214" v="11" actId="255"/>
          <ac:spMkLst>
            <pc:docMk/>
            <pc:sldMk cId="1961864004" sldId="407"/>
            <ac:spMk id="139" creationId="{C7526072-EB5E-7BF1-B01A-4F3CEDE15B57}"/>
          </ac:spMkLst>
        </pc:spChg>
        <pc:spChg chg="mod">
          <ac:chgData name="Zhang, X (bw)" userId="8c11a9ad-4ec2-408f-b77f-edf277d143b8" providerId="ADAL" clId="{917AA4CC-9489-41C4-AF82-0BBF3A8480D9}" dt="2025-02-17T09:20:50.339" v="12" actId="2711"/>
          <ac:spMkLst>
            <pc:docMk/>
            <pc:sldMk cId="1961864004" sldId="407"/>
            <ac:spMk id="191" creationId="{ED98D6B0-4749-A8DA-CA3D-F8A6DBBCB0E7}"/>
          </ac:spMkLst>
        </pc:spChg>
        <pc:spChg chg="mod">
          <ac:chgData name="Zhang, X (bw)" userId="8c11a9ad-4ec2-408f-b77f-edf277d143b8" providerId="ADAL" clId="{917AA4CC-9489-41C4-AF82-0BBF3A8480D9}" dt="2025-02-17T09:20:50.339" v="12" actId="2711"/>
          <ac:spMkLst>
            <pc:docMk/>
            <pc:sldMk cId="1961864004" sldId="407"/>
            <ac:spMk id="198" creationId="{BE9035AC-F74E-2DEC-033D-26E6CDCFFB5C}"/>
          </ac:spMkLst>
        </pc:spChg>
      </pc:sldChg>
      <pc:sldChg chg="addSp delSp modSp mod">
        <pc:chgData name="Zhang, X (bw)" userId="8c11a9ad-4ec2-408f-b77f-edf277d143b8" providerId="ADAL" clId="{917AA4CC-9489-41C4-AF82-0BBF3A8480D9}" dt="2025-02-17T09:57:23.748" v="285" actId="1076"/>
        <pc:sldMkLst>
          <pc:docMk/>
          <pc:sldMk cId="3117842035" sldId="410"/>
        </pc:sldMkLst>
        <pc:spChg chg="mod">
          <ac:chgData name="Zhang, X (bw)" userId="8c11a9ad-4ec2-408f-b77f-edf277d143b8" providerId="ADAL" clId="{917AA4CC-9489-41C4-AF82-0BBF3A8480D9}" dt="2025-02-17T09:23:12.837" v="22" actId="2711"/>
          <ac:spMkLst>
            <pc:docMk/>
            <pc:sldMk cId="3117842035" sldId="410"/>
            <ac:spMk id="7" creationId="{DAD4F62F-73DD-BE13-8FD8-D876C7AD8A9F}"/>
          </ac:spMkLst>
        </pc:spChg>
        <pc:spChg chg="mod topLvl">
          <ac:chgData name="Zhang, X (bw)" userId="8c11a9ad-4ec2-408f-b77f-edf277d143b8" providerId="ADAL" clId="{917AA4CC-9489-41C4-AF82-0BBF3A8480D9}" dt="2025-02-17T09:23:02.391" v="20" actId="165"/>
          <ac:spMkLst>
            <pc:docMk/>
            <pc:sldMk cId="3117842035" sldId="410"/>
            <ac:spMk id="11" creationId="{1973F083-70A9-9C60-89D0-1627B2A98227}"/>
          </ac:spMkLst>
        </pc:spChg>
        <pc:spChg chg="mod">
          <ac:chgData name="Zhang, X (bw)" userId="8c11a9ad-4ec2-408f-b77f-edf277d143b8" providerId="ADAL" clId="{917AA4CC-9489-41C4-AF82-0BBF3A8480D9}" dt="2025-02-17T09:23:12.837" v="22" actId="2711"/>
          <ac:spMkLst>
            <pc:docMk/>
            <pc:sldMk cId="3117842035" sldId="410"/>
            <ac:spMk id="20" creationId="{DD3EAF64-9C03-498B-2918-701D642B956B}"/>
          </ac:spMkLst>
        </pc:spChg>
        <pc:spChg chg="mod">
          <ac:chgData name="Zhang, X (bw)" userId="8c11a9ad-4ec2-408f-b77f-edf277d143b8" providerId="ADAL" clId="{917AA4CC-9489-41C4-AF82-0BBF3A8480D9}" dt="2025-02-17T09:23:12.837" v="22" actId="2711"/>
          <ac:spMkLst>
            <pc:docMk/>
            <pc:sldMk cId="3117842035" sldId="410"/>
            <ac:spMk id="23" creationId="{BE597229-9F3A-E79E-45C5-6521E29C4C11}"/>
          </ac:spMkLst>
        </pc:spChg>
        <pc:spChg chg="mod topLvl">
          <ac:chgData name="Zhang, X (bw)" userId="8c11a9ad-4ec2-408f-b77f-edf277d143b8" providerId="ADAL" clId="{917AA4CC-9489-41C4-AF82-0BBF3A8480D9}" dt="2025-02-17T09:23:02.391" v="20" actId="165"/>
          <ac:spMkLst>
            <pc:docMk/>
            <pc:sldMk cId="3117842035" sldId="410"/>
            <ac:spMk id="24" creationId="{66537257-7D69-24E4-FCFD-C1696097F037}"/>
          </ac:spMkLst>
        </pc:spChg>
        <pc:spChg chg="mod topLvl">
          <ac:chgData name="Zhang, X (bw)" userId="8c11a9ad-4ec2-408f-b77f-edf277d143b8" providerId="ADAL" clId="{917AA4CC-9489-41C4-AF82-0BBF3A8480D9}" dt="2025-02-17T09:23:02.391" v="20" actId="165"/>
          <ac:spMkLst>
            <pc:docMk/>
            <pc:sldMk cId="3117842035" sldId="410"/>
            <ac:spMk id="36" creationId="{95A795A5-55A2-8D75-95D8-F80356A19E21}"/>
          </ac:spMkLst>
        </pc:spChg>
        <pc:spChg chg="mod">
          <ac:chgData name="Zhang, X (bw)" userId="8c11a9ad-4ec2-408f-b77f-edf277d143b8" providerId="ADAL" clId="{917AA4CC-9489-41C4-AF82-0BBF3A8480D9}" dt="2025-02-17T09:23:12.837" v="22" actId="2711"/>
          <ac:spMkLst>
            <pc:docMk/>
            <pc:sldMk cId="3117842035" sldId="410"/>
            <ac:spMk id="46" creationId="{201CAB0B-6D37-A4EF-44C3-C2A254A07447}"/>
          </ac:spMkLst>
        </pc:spChg>
        <pc:spChg chg="mod topLvl">
          <ac:chgData name="Zhang, X (bw)" userId="8c11a9ad-4ec2-408f-b77f-edf277d143b8" providerId="ADAL" clId="{917AA4CC-9489-41C4-AF82-0BBF3A8480D9}" dt="2025-02-17T09:23:12.837" v="22" actId="2711"/>
          <ac:spMkLst>
            <pc:docMk/>
            <pc:sldMk cId="3117842035" sldId="410"/>
            <ac:spMk id="51" creationId="{F2EE2B52-AE07-5E2B-8E9C-93521C73A7B6}"/>
          </ac:spMkLst>
        </pc:spChg>
        <pc:spChg chg="mod">
          <ac:chgData name="Zhang, X (bw)" userId="8c11a9ad-4ec2-408f-b77f-edf277d143b8" providerId="ADAL" clId="{917AA4CC-9489-41C4-AF82-0BBF3A8480D9}" dt="2025-02-17T09:23:12.837" v="22" actId="2711"/>
          <ac:spMkLst>
            <pc:docMk/>
            <pc:sldMk cId="3117842035" sldId="410"/>
            <ac:spMk id="52" creationId="{1FFF4155-F707-23B6-BFDA-41C53D96B95C}"/>
          </ac:spMkLst>
        </pc:spChg>
        <pc:spChg chg="mod topLvl">
          <ac:chgData name="Zhang, X (bw)" userId="8c11a9ad-4ec2-408f-b77f-edf277d143b8" providerId="ADAL" clId="{917AA4CC-9489-41C4-AF82-0BBF3A8480D9}" dt="2025-02-17T09:23:02.391" v="20" actId="165"/>
          <ac:spMkLst>
            <pc:docMk/>
            <pc:sldMk cId="3117842035" sldId="410"/>
            <ac:spMk id="54" creationId="{648F80B9-E613-E487-9449-9FBA8BE66505}"/>
          </ac:spMkLst>
        </pc:spChg>
        <pc:spChg chg="mod">
          <ac:chgData name="Zhang, X (bw)" userId="8c11a9ad-4ec2-408f-b77f-edf277d143b8" providerId="ADAL" clId="{917AA4CC-9489-41C4-AF82-0BBF3A8480D9}" dt="2025-02-17T09:23:12.837" v="22" actId="2711"/>
          <ac:spMkLst>
            <pc:docMk/>
            <pc:sldMk cId="3117842035" sldId="410"/>
            <ac:spMk id="55" creationId="{EDBFF825-24AB-D95D-3AE8-87ACA7A09D41}"/>
          </ac:spMkLst>
        </pc:spChg>
        <pc:spChg chg="mod topLvl">
          <ac:chgData name="Zhang, X (bw)" userId="8c11a9ad-4ec2-408f-b77f-edf277d143b8" providerId="ADAL" clId="{917AA4CC-9489-41C4-AF82-0BBF3A8480D9}" dt="2025-02-17T09:23:12.837" v="22" actId="2711"/>
          <ac:spMkLst>
            <pc:docMk/>
            <pc:sldMk cId="3117842035" sldId="410"/>
            <ac:spMk id="57" creationId="{8A0A4089-EEA8-3BB7-1DCA-504CAD6C1900}"/>
          </ac:spMkLst>
        </pc:spChg>
        <pc:spChg chg="mod topLvl">
          <ac:chgData name="Zhang, X (bw)" userId="8c11a9ad-4ec2-408f-b77f-edf277d143b8" providerId="ADAL" clId="{917AA4CC-9489-41C4-AF82-0BBF3A8480D9}" dt="2025-02-17T09:23:02.391" v="20" actId="165"/>
          <ac:spMkLst>
            <pc:docMk/>
            <pc:sldMk cId="3117842035" sldId="410"/>
            <ac:spMk id="59" creationId="{B83C339C-23AA-7884-6111-354C012EE0CD}"/>
          </ac:spMkLst>
        </pc:spChg>
        <pc:spChg chg="mod">
          <ac:chgData name="Zhang, X (bw)" userId="8c11a9ad-4ec2-408f-b77f-edf277d143b8" providerId="ADAL" clId="{917AA4CC-9489-41C4-AF82-0BBF3A8480D9}" dt="2025-02-17T09:23:12.837" v="22" actId="2711"/>
          <ac:spMkLst>
            <pc:docMk/>
            <pc:sldMk cId="3117842035" sldId="410"/>
            <ac:spMk id="60" creationId="{A1E0DA26-C1EF-F153-7E65-21E555F212EE}"/>
          </ac:spMkLst>
        </pc:spChg>
        <pc:spChg chg="mod topLvl">
          <ac:chgData name="Zhang, X (bw)" userId="8c11a9ad-4ec2-408f-b77f-edf277d143b8" providerId="ADAL" clId="{917AA4CC-9489-41C4-AF82-0BBF3A8480D9}" dt="2025-02-17T09:23:02.391" v="20" actId="165"/>
          <ac:spMkLst>
            <pc:docMk/>
            <pc:sldMk cId="3117842035" sldId="410"/>
            <ac:spMk id="61" creationId="{C9726D82-D367-94E9-DA4E-0A8BC6BB7B25}"/>
          </ac:spMkLst>
        </pc:spChg>
        <pc:spChg chg="mod topLvl">
          <ac:chgData name="Zhang, X (bw)" userId="8c11a9ad-4ec2-408f-b77f-edf277d143b8" providerId="ADAL" clId="{917AA4CC-9489-41C4-AF82-0BBF3A8480D9}" dt="2025-02-17T09:23:12.837" v="22" actId="2711"/>
          <ac:spMkLst>
            <pc:docMk/>
            <pc:sldMk cId="3117842035" sldId="410"/>
            <ac:spMk id="193" creationId="{8E235350-06E7-54E0-BC70-5DFB8BE3EACB}"/>
          </ac:spMkLst>
        </pc:spChg>
        <pc:spChg chg="mod topLvl">
          <ac:chgData name="Zhang, X (bw)" userId="8c11a9ad-4ec2-408f-b77f-edf277d143b8" providerId="ADAL" clId="{917AA4CC-9489-41C4-AF82-0BBF3A8480D9}" dt="2025-02-17T09:23:02.391" v="20" actId="165"/>
          <ac:spMkLst>
            <pc:docMk/>
            <pc:sldMk cId="3117842035" sldId="410"/>
            <ac:spMk id="196" creationId="{7733A979-5965-C935-6FBE-538C3EBE4AC9}"/>
          </ac:spMkLst>
        </pc:spChg>
        <pc:spChg chg="mod">
          <ac:chgData name="Zhang, X (bw)" userId="8c11a9ad-4ec2-408f-b77f-edf277d143b8" providerId="ADAL" clId="{917AA4CC-9489-41C4-AF82-0BBF3A8480D9}" dt="2025-02-17T09:20:17.622" v="9" actId="2711"/>
          <ac:spMkLst>
            <pc:docMk/>
            <pc:sldMk cId="3117842035" sldId="410"/>
            <ac:spMk id="213" creationId="{387DC085-1CEF-309E-764A-553025F3EA57}"/>
          </ac:spMkLst>
        </pc:spChg>
        <pc:spChg chg="mod">
          <ac:chgData name="Zhang, X (bw)" userId="8c11a9ad-4ec2-408f-b77f-edf277d143b8" providerId="ADAL" clId="{917AA4CC-9489-41C4-AF82-0BBF3A8480D9}" dt="2025-02-17T09:57:23.748" v="285" actId="1076"/>
          <ac:spMkLst>
            <pc:docMk/>
            <pc:sldMk cId="3117842035" sldId="410"/>
            <ac:spMk id="215" creationId="{0964AAE2-AB26-9535-857F-7FB568CD3365}"/>
          </ac:spMkLst>
        </pc:spChg>
      </pc:sldChg>
      <pc:sldChg chg="delSp modSp mod">
        <pc:chgData name="Zhang, X (bw)" userId="8c11a9ad-4ec2-408f-b77f-edf277d143b8" providerId="ADAL" clId="{917AA4CC-9489-41C4-AF82-0BBF3A8480D9}" dt="2025-02-17T09:21:27.128" v="15" actId="2711"/>
        <pc:sldMkLst>
          <pc:docMk/>
          <pc:sldMk cId="2414535057" sldId="411"/>
        </pc:sldMkLst>
        <pc:spChg chg="mod">
          <ac:chgData name="Zhang, X (bw)" userId="8c11a9ad-4ec2-408f-b77f-edf277d143b8" providerId="ADAL" clId="{917AA4CC-9489-41C4-AF82-0BBF3A8480D9}" dt="2025-02-17T09:21:20.607" v="14" actId="165"/>
          <ac:spMkLst>
            <pc:docMk/>
            <pc:sldMk cId="2414535057" sldId="411"/>
            <ac:spMk id="6" creationId="{1EDE2915-F4FF-9E51-ADE6-2504A9F016CB}"/>
          </ac:spMkLst>
        </pc:spChg>
        <pc:spChg chg="mod">
          <ac:chgData name="Zhang, X (bw)" userId="8c11a9ad-4ec2-408f-b77f-edf277d143b8" providerId="ADAL" clId="{917AA4CC-9489-41C4-AF82-0BBF3A8480D9}" dt="2025-02-17T09:21:27.128" v="15" actId="2711"/>
          <ac:spMkLst>
            <pc:docMk/>
            <pc:sldMk cId="2414535057" sldId="411"/>
            <ac:spMk id="11" creationId="{AF63F76D-1838-C41D-472D-E69F1E4EA26A}"/>
          </ac:spMkLst>
        </pc:spChg>
        <pc:spChg chg="mod">
          <ac:chgData name="Zhang, X (bw)" userId="8c11a9ad-4ec2-408f-b77f-edf277d143b8" providerId="ADAL" clId="{917AA4CC-9489-41C4-AF82-0BBF3A8480D9}" dt="2025-02-17T09:21:00.431" v="13" actId="2711"/>
          <ac:spMkLst>
            <pc:docMk/>
            <pc:sldMk cId="2414535057" sldId="411"/>
            <ac:spMk id="12" creationId="{617086AA-98B1-AFE7-1BCA-EFA121F5FC2E}"/>
          </ac:spMkLst>
        </pc:spChg>
        <pc:spChg chg="mod">
          <ac:chgData name="Zhang, X (bw)" userId="8c11a9ad-4ec2-408f-b77f-edf277d143b8" providerId="ADAL" clId="{917AA4CC-9489-41C4-AF82-0BBF3A8480D9}" dt="2025-02-17T09:21:20.607" v="14" actId="165"/>
          <ac:spMkLst>
            <pc:docMk/>
            <pc:sldMk cId="2414535057" sldId="411"/>
            <ac:spMk id="14" creationId="{FBCCC31C-F790-F928-8AEB-F9C2B25E619C}"/>
          </ac:spMkLst>
        </pc:spChg>
        <pc:spChg chg="mod">
          <ac:chgData name="Zhang, X (bw)" userId="8c11a9ad-4ec2-408f-b77f-edf277d143b8" providerId="ADAL" clId="{917AA4CC-9489-41C4-AF82-0BBF3A8480D9}" dt="2025-02-17T09:21:27.128" v="15" actId="2711"/>
          <ac:spMkLst>
            <pc:docMk/>
            <pc:sldMk cId="2414535057" sldId="411"/>
            <ac:spMk id="16" creationId="{C1CA2909-BC05-5F81-1B62-D1C8E801BE7A}"/>
          </ac:spMkLst>
        </pc:spChg>
        <pc:spChg chg="mod">
          <ac:chgData name="Zhang, X (bw)" userId="8c11a9ad-4ec2-408f-b77f-edf277d143b8" providerId="ADAL" clId="{917AA4CC-9489-41C4-AF82-0BBF3A8480D9}" dt="2025-02-17T09:21:20.607" v="14" actId="165"/>
          <ac:spMkLst>
            <pc:docMk/>
            <pc:sldMk cId="2414535057" sldId="411"/>
            <ac:spMk id="17" creationId="{DD3DBFDB-6EF2-29F0-06F6-11E458079250}"/>
          </ac:spMkLst>
        </pc:spChg>
        <pc:spChg chg="mod">
          <ac:chgData name="Zhang, X (bw)" userId="8c11a9ad-4ec2-408f-b77f-edf277d143b8" providerId="ADAL" clId="{917AA4CC-9489-41C4-AF82-0BBF3A8480D9}" dt="2025-02-17T09:21:20.607" v="14" actId="165"/>
          <ac:spMkLst>
            <pc:docMk/>
            <pc:sldMk cId="2414535057" sldId="411"/>
            <ac:spMk id="18" creationId="{6A0BFBB7-39BF-22F0-2221-E01D05729B5E}"/>
          </ac:spMkLst>
        </pc:spChg>
        <pc:spChg chg="mod">
          <ac:chgData name="Zhang, X (bw)" userId="8c11a9ad-4ec2-408f-b77f-edf277d143b8" providerId="ADAL" clId="{917AA4CC-9489-41C4-AF82-0BBF3A8480D9}" dt="2025-02-17T09:21:27.128" v="15" actId="2711"/>
          <ac:spMkLst>
            <pc:docMk/>
            <pc:sldMk cId="2414535057" sldId="411"/>
            <ac:spMk id="19" creationId="{7E545C8B-B2B2-A7A2-2716-10DCD1601932}"/>
          </ac:spMkLst>
        </pc:spChg>
        <pc:spChg chg="mod">
          <ac:chgData name="Zhang, X (bw)" userId="8c11a9ad-4ec2-408f-b77f-edf277d143b8" providerId="ADAL" clId="{917AA4CC-9489-41C4-AF82-0BBF3A8480D9}" dt="2025-02-17T09:21:27.128" v="15" actId="2711"/>
          <ac:spMkLst>
            <pc:docMk/>
            <pc:sldMk cId="2414535057" sldId="411"/>
            <ac:spMk id="20" creationId="{AE130FC7-AEC2-929F-C4FA-51B75E674A79}"/>
          </ac:spMkLst>
        </pc:spChg>
        <pc:spChg chg="mod">
          <ac:chgData name="Zhang, X (bw)" userId="8c11a9ad-4ec2-408f-b77f-edf277d143b8" providerId="ADAL" clId="{917AA4CC-9489-41C4-AF82-0BBF3A8480D9}" dt="2025-02-17T09:21:20.607" v="14" actId="165"/>
          <ac:spMkLst>
            <pc:docMk/>
            <pc:sldMk cId="2414535057" sldId="411"/>
            <ac:spMk id="21" creationId="{D0593A75-F6BF-D040-FC76-5D8E74419935}"/>
          </ac:spMkLst>
        </pc:spChg>
        <pc:spChg chg="mod">
          <ac:chgData name="Zhang, X (bw)" userId="8c11a9ad-4ec2-408f-b77f-edf277d143b8" providerId="ADAL" clId="{917AA4CC-9489-41C4-AF82-0BBF3A8480D9}" dt="2025-02-17T09:21:20.607" v="14" actId="165"/>
          <ac:spMkLst>
            <pc:docMk/>
            <pc:sldMk cId="2414535057" sldId="411"/>
            <ac:spMk id="23" creationId="{21B13A24-0645-5807-8168-03D0181557B2}"/>
          </ac:spMkLst>
        </pc:spChg>
        <pc:spChg chg="mod">
          <ac:chgData name="Zhang, X (bw)" userId="8c11a9ad-4ec2-408f-b77f-edf277d143b8" providerId="ADAL" clId="{917AA4CC-9489-41C4-AF82-0BBF3A8480D9}" dt="2025-02-17T09:21:27.128" v="15" actId="2711"/>
          <ac:spMkLst>
            <pc:docMk/>
            <pc:sldMk cId="2414535057" sldId="411"/>
            <ac:spMk id="24" creationId="{7015A225-DF11-B071-2F2E-FA0D0A77845A}"/>
          </ac:spMkLst>
        </pc:spChg>
        <pc:spChg chg="mod">
          <ac:chgData name="Zhang, X (bw)" userId="8c11a9ad-4ec2-408f-b77f-edf277d143b8" providerId="ADAL" clId="{917AA4CC-9489-41C4-AF82-0BBF3A8480D9}" dt="2025-02-17T09:21:27.128" v="15" actId="2711"/>
          <ac:spMkLst>
            <pc:docMk/>
            <pc:sldMk cId="2414535057" sldId="411"/>
            <ac:spMk id="25" creationId="{1D997935-53EC-1412-EB47-19D8E85A7501}"/>
          </ac:spMkLst>
        </pc:spChg>
        <pc:spChg chg="mod">
          <ac:chgData name="Zhang, X (bw)" userId="8c11a9ad-4ec2-408f-b77f-edf277d143b8" providerId="ADAL" clId="{917AA4CC-9489-41C4-AF82-0BBF3A8480D9}" dt="2025-02-17T09:21:27.128" v="15" actId="2711"/>
          <ac:spMkLst>
            <pc:docMk/>
            <pc:sldMk cId="2414535057" sldId="411"/>
            <ac:spMk id="26" creationId="{8341D27C-B356-FC2D-168B-2E7DC503E619}"/>
          </ac:spMkLst>
        </pc:spChg>
        <pc:spChg chg="mod">
          <ac:chgData name="Zhang, X (bw)" userId="8c11a9ad-4ec2-408f-b77f-edf277d143b8" providerId="ADAL" clId="{917AA4CC-9489-41C4-AF82-0BBF3A8480D9}" dt="2025-02-17T09:21:27.128" v="15" actId="2711"/>
          <ac:spMkLst>
            <pc:docMk/>
            <pc:sldMk cId="2414535057" sldId="411"/>
            <ac:spMk id="36" creationId="{A660E9A9-3A9C-E928-9C51-2AEED73740DD}"/>
          </ac:spMkLst>
        </pc:spChg>
        <pc:spChg chg="mod">
          <ac:chgData name="Zhang, X (bw)" userId="8c11a9ad-4ec2-408f-b77f-edf277d143b8" providerId="ADAL" clId="{917AA4CC-9489-41C4-AF82-0BBF3A8480D9}" dt="2025-02-17T09:21:27.128" v="15" actId="2711"/>
          <ac:spMkLst>
            <pc:docMk/>
            <pc:sldMk cId="2414535057" sldId="411"/>
            <ac:spMk id="39" creationId="{C8F77D2D-A5B1-F0A5-71B9-EB95B8CB12AA}"/>
          </ac:spMkLst>
        </pc:spChg>
        <pc:spChg chg="mod">
          <ac:chgData name="Zhang, X (bw)" userId="8c11a9ad-4ec2-408f-b77f-edf277d143b8" providerId="ADAL" clId="{917AA4CC-9489-41C4-AF82-0BBF3A8480D9}" dt="2025-02-17T09:21:27.128" v="15" actId="2711"/>
          <ac:spMkLst>
            <pc:docMk/>
            <pc:sldMk cId="2414535057" sldId="411"/>
            <ac:spMk id="60" creationId="{E6917569-740F-14D9-720E-ADEE16E49716}"/>
          </ac:spMkLst>
        </pc:spChg>
        <pc:spChg chg="mod">
          <ac:chgData name="Zhang, X (bw)" userId="8c11a9ad-4ec2-408f-b77f-edf277d143b8" providerId="ADAL" clId="{917AA4CC-9489-41C4-AF82-0BBF3A8480D9}" dt="2025-02-17T09:21:20.607" v="14" actId="165"/>
          <ac:spMkLst>
            <pc:docMk/>
            <pc:sldMk cId="2414535057" sldId="411"/>
            <ac:spMk id="196" creationId="{D73FF179-6AA5-5E80-41EA-B4CAC9D87FDD}"/>
          </ac:spMkLst>
        </pc:spChg>
        <pc:spChg chg="mod">
          <ac:chgData name="Zhang, X (bw)" userId="8c11a9ad-4ec2-408f-b77f-edf277d143b8" providerId="ADAL" clId="{917AA4CC-9489-41C4-AF82-0BBF3A8480D9}" dt="2025-02-17T09:21:20.607" v="14" actId="165"/>
          <ac:spMkLst>
            <pc:docMk/>
            <pc:sldMk cId="2414535057" sldId="411"/>
            <ac:spMk id="201" creationId="{373FB87D-DBE1-0D00-4732-C5134ED52569}"/>
          </ac:spMkLst>
        </pc:spChg>
        <pc:spChg chg="mod">
          <ac:chgData name="Zhang, X (bw)" userId="8c11a9ad-4ec2-408f-b77f-edf277d143b8" providerId="ADAL" clId="{917AA4CC-9489-41C4-AF82-0BBF3A8480D9}" dt="2025-02-17T09:21:20.607" v="14" actId="165"/>
          <ac:spMkLst>
            <pc:docMk/>
            <pc:sldMk cId="2414535057" sldId="411"/>
            <ac:spMk id="212" creationId="{FC241540-D429-B6FE-001C-BBDFC9B3AE23}"/>
          </ac:spMkLst>
        </pc:spChg>
      </pc:sldChg>
      <pc:sldChg chg="ord">
        <pc:chgData name="Zhang, X (bw)" userId="8c11a9ad-4ec2-408f-b77f-edf277d143b8" providerId="ADAL" clId="{917AA4CC-9489-41C4-AF82-0BBF3A8480D9}" dt="2025-02-17T09:53:32.261" v="222"/>
        <pc:sldMkLst>
          <pc:docMk/>
          <pc:sldMk cId="1301839555" sldId="412"/>
        </pc:sldMkLst>
      </pc:sldChg>
      <pc:sldChg chg="ord">
        <pc:chgData name="Zhang, X (bw)" userId="8c11a9ad-4ec2-408f-b77f-edf277d143b8" providerId="ADAL" clId="{917AA4CC-9489-41C4-AF82-0BBF3A8480D9}" dt="2025-02-17T09:49:34.358" v="201"/>
        <pc:sldMkLst>
          <pc:docMk/>
          <pc:sldMk cId="3418119145" sldId="413"/>
        </pc:sldMkLst>
      </pc:sldChg>
      <pc:sldChg chg="addSp delSp modSp mod ord">
        <pc:chgData name="Zhang, X (bw)" userId="8c11a9ad-4ec2-408f-b77f-edf277d143b8" providerId="ADAL" clId="{917AA4CC-9489-41C4-AF82-0BBF3A8480D9}" dt="2025-02-17T09:56:31.867" v="266" actId="1076"/>
        <pc:sldMkLst>
          <pc:docMk/>
          <pc:sldMk cId="1424199435" sldId="414"/>
        </pc:sldMkLst>
        <pc:spChg chg="mod topLvl">
          <ac:chgData name="Zhang, X (bw)" userId="8c11a9ad-4ec2-408f-b77f-edf277d143b8" providerId="ADAL" clId="{917AA4CC-9489-41C4-AF82-0BBF3A8480D9}" dt="2025-02-17T09:46:24.921" v="173" actId="1038"/>
          <ac:spMkLst>
            <pc:docMk/>
            <pc:sldMk cId="1424199435" sldId="414"/>
            <ac:spMk id="3" creationId="{D85644CB-423F-908B-6689-C9355569A952}"/>
          </ac:spMkLst>
        </pc:spChg>
        <pc:spChg chg="add mod">
          <ac:chgData name="Zhang, X (bw)" userId="8c11a9ad-4ec2-408f-b77f-edf277d143b8" providerId="ADAL" clId="{917AA4CC-9489-41C4-AF82-0BBF3A8480D9}" dt="2025-02-17T09:56:24.620" v="265" actId="1037"/>
          <ac:spMkLst>
            <pc:docMk/>
            <pc:sldMk cId="1424199435" sldId="414"/>
            <ac:spMk id="4" creationId="{3BAB3469-1A34-E095-8EED-EEE262F01728}"/>
          </ac:spMkLst>
        </pc:spChg>
        <pc:spChg chg="add mod">
          <ac:chgData name="Zhang, X (bw)" userId="8c11a9ad-4ec2-408f-b77f-edf277d143b8" providerId="ADAL" clId="{917AA4CC-9489-41C4-AF82-0BBF3A8480D9}" dt="2025-02-17T09:56:24.620" v="265" actId="1037"/>
          <ac:spMkLst>
            <pc:docMk/>
            <pc:sldMk cId="1424199435" sldId="414"/>
            <ac:spMk id="5" creationId="{6806E9EC-5A84-5775-F433-D853FC22D0BC}"/>
          </ac:spMkLst>
        </pc:spChg>
        <pc:spChg chg="add mod">
          <ac:chgData name="Zhang, X (bw)" userId="8c11a9ad-4ec2-408f-b77f-edf277d143b8" providerId="ADAL" clId="{917AA4CC-9489-41C4-AF82-0BBF3A8480D9}" dt="2025-02-17T09:56:24.620" v="265" actId="1037"/>
          <ac:spMkLst>
            <pc:docMk/>
            <pc:sldMk cId="1424199435" sldId="414"/>
            <ac:spMk id="9" creationId="{719B33B5-E4F2-7072-0A45-9E500292589A}"/>
          </ac:spMkLst>
        </pc:spChg>
        <pc:spChg chg="add mod">
          <ac:chgData name="Zhang, X (bw)" userId="8c11a9ad-4ec2-408f-b77f-edf277d143b8" providerId="ADAL" clId="{917AA4CC-9489-41C4-AF82-0BBF3A8480D9}" dt="2025-02-17T09:56:24.620" v="265" actId="1037"/>
          <ac:spMkLst>
            <pc:docMk/>
            <pc:sldMk cId="1424199435" sldId="414"/>
            <ac:spMk id="10" creationId="{3A1B3385-2CBC-D218-413B-C0CF81B99CF0}"/>
          </ac:spMkLst>
        </pc:spChg>
        <pc:spChg chg="mod">
          <ac:chgData name="Zhang, X (bw)" userId="8c11a9ad-4ec2-408f-b77f-edf277d143b8" providerId="ADAL" clId="{917AA4CC-9489-41C4-AF82-0BBF3A8480D9}" dt="2025-02-17T09:56:31.867" v="266" actId="1076"/>
          <ac:spMkLst>
            <pc:docMk/>
            <pc:sldMk cId="1424199435" sldId="414"/>
            <ac:spMk id="11" creationId="{1455EFA2-5A86-1AF1-F47B-1E23FDC3C913}"/>
          </ac:spMkLst>
        </pc:spChg>
        <pc:spChg chg="add mod">
          <ac:chgData name="Zhang, X (bw)" userId="8c11a9ad-4ec2-408f-b77f-edf277d143b8" providerId="ADAL" clId="{917AA4CC-9489-41C4-AF82-0BBF3A8480D9}" dt="2025-02-17T09:56:24.620" v="265" actId="1037"/>
          <ac:spMkLst>
            <pc:docMk/>
            <pc:sldMk cId="1424199435" sldId="414"/>
            <ac:spMk id="12" creationId="{4201C051-45BA-5148-858A-034CB8C9587A}"/>
          </ac:spMkLst>
        </pc:spChg>
        <pc:spChg chg="add mod">
          <ac:chgData name="Zhang, X (bw)" userId="8c11a9ad-4ec2-408f-b77f-edf277d143b8" providerId="ADAL" clId="{917AA4CC-9489-41C4-AF82-0BBF3A8480D9}" dt="2025-02-17T09:56:24.620" v="265" actId="1037"/>
          <ac:spMkLst>
            <pc:docMk/>
            <pc:sldMk cId="1424199435" sldId="414"/>
            <ac:spMk id="13" creationId="{DCDF9C34-451E-538B-8E32-564BE2D4FFF6}"/>
          </ac:spMkLst>
        </pc:spChg>
        <pc:spChg chg="add mod">
          <ac:chgData name="Zhang, X (bw)" userId="8c11a9ad-4ec2-408f-b77f-edf277d143b8" providerId="ADAL" clId="{917AA4CC-9489-41C4-AF82-0BBF3A8480D9}" dt="2025-02-17T09:56:24.620" v="265" actId="1037"/>
          <ac:spMkLst>
            <pc:docMk/>
            <pc:sldMk cId="1424199435" sldId="414"/>
            <ac:spMk id="14" creationId="{6B101A50-BFCF-7558-C8E9-E7C8EE7D3047}"/>
          </ac:spMkLst>
        </pc:spChg>
        <pc:spChg chg="add mod">
          <ac:chgData name="Zhang, X (bw)" userId="8c11a9ad-4ec2-408f-b77f-edf277d143b8" providerId="ADAL" clId="{917AA4CC-9489-41C4-AF82-0BBF3A8480D9}" dt="2025-02-17T09:56:24.620" v="265" actId="1037"/>
          <ac:spMkLst>
            <pc:docMk/>
            <pc:sldMk cId="1424199435" sldId="414"/>
            <ac:spMk id="15" creationId="{0E13C0BA-08B0-C05A-1722-8F9AA4250332}"/>
          </ac:spMkLst>
        </pc:spChg>
        <pc:spChg chg="mod">
          <ac:chgData name="Zhang, X (bw)" userId="8c11a9ad-4ec2-408f-b77f-edf277d143b8" providerId="ADAL" clId="{917AA4CC-9489-41C4-AF82-0BBF3A8480D9}" dt="2025-02-17T09:56:01.375" v="249" actId="338"/>
          <ac:spMkLst>
            <pc:docMk/>
            <pc:sldMk cId="1424199435" sldId="414"/>
            <ac:spMk id="36" creationId="{3D862438-54EF-D76C-D9EE-F3BAFDD5AE8C}"/>
          </ac:spMkLst>
        </pc:spChg>
        <pc:spChg chg="mod topLvl">
          <ac:chgData name="Zhang, X (bw)" userId="8c11a9ad-4ec2-408f-b77f-edf277d143b8" providerId="ADAL" clId="{917AA4CC-9489-41C4-AF82-0BBF3A8480D9}" dt="2025-02-17T09:56:01.375" v="249" actId="338"/>
          <ac:spMkLst>
            <pc:docMk/>
            <pc:sldMk cId="1424199435" sldId="414"/>
            <ac:spMk id="46" creationId="{E710032A-203C-1679-AD45-A769E120AE1D}"/>
          </ac:spMkLst>
        </pc:spChg>
        <pc:spChg chg="mod topLvl">
          <ac:chgData name="Zhang, X (bw)" userId="8c11a9ad-4ec2-408f-b77f-edf277d143b8" providerId="ADAL" clId="{917AA4CC-9489-41C4-AF82-0BBF3A8480D9}" dt="2025-02-17T09:37:08.391" v="47" actId="165"/>
          <ac:spMkLst>
            <pc:docMk/>
            <pc:sldMk cId="1424199435" sldId="414"/>
            <ac:spMk id="70" creationId="{A3EF3432-0D5A-9CF9-9C7B-C78D69B6E479}"/>
          </ac:spMkLst>
        </pc:spChg>
        <pc:spChg chg="mod topLvl">
          <ac:chgData name="Zhang, X (bw)" userId="8c11a9ad-4ec2-408f-b77f-edf277d143b8" providerId="ADAL" clId="{917AA4CC-9489-41C4-AF82-0BBF3A8480D9}" dt="2025-02-17T09:50:31.726" v="206" actId="408"/>
          <ac:spMkLst>
            <pc:docMk/>
            <pc:sldMk cId="1424199435" sldId="414"/>
            <ac:spMk id="72" creationId="{59E26819-2853-7B5B-6E5D-FB7E45FC1A4C}"/>
          </ac:spMkLst>
        </pc:spChg>
        <pc:spChg chg="mod topLvl">
          <ac:chgData name="Zhang, X (bw)" userId="8c11a9ad-4ec2-408f-b77f-edf277d143b8" providerId="ADAL" clId="{917AA4CC-9489-41C4-AF82-0BBF3A8480D9}" dt="2025-02-17T09:50:31.726" v="206" actId="408"/>
          <ac:spMkLst>
            <pc:docMk/>
            <pc:sldMk cId="1424199435" sldId="414"/>
            <ac:spMk id="73" creationId="{CFA6C7AB-A2E4-1B3C-5C2E-B3E1411BC0F0}"/>
          </ac:spMkLst>
        </pc:spChg>
        <pc:spChg chg="mod topLvl">
          <ac:chgData name="Zhang, X (bw)" userId="8c11a9ad-4ec2-408f-b77f-edf277d143b8" providerId="ADAL" clId="{917AA4CC-9489-41C4-AF82-0BBF3A8480D9}" dt="2025-02-17T09:50:31.726" v="206" actId="408"/>
          <ac:spMkLst>
            <pc:docMk/>
            <pc:sldMk cId="1424199435" sldId="414"/>
            <ac:spMk id="75" creationId="{237BFEC7-C610-FEA0-4ACA-3B5EB46368BB}"/>
          </ac:spMkLst>
        </pc:spChg>
        <pc:spChg chg="mod topLvl">
          <ac:chgData name="Zhang, X (bw)" userId="8c11a9ad-4ec2-408f-b77f-edf277d143b8" providerId="ADAL" clId="{917AA4CC-9489-41C4-AF82-0BBF3A8480D9}" dt="2025-02-17T09:50:31.726" v="206" actId="408"/>
          <ac:spMkLst>
            <pc:docMk/>
            <pc:sldMk cId="1424199435" sldId="414"/>
            <ac:spMk id="76" creationId="{96181F75-0A0B-BD64-7134-12ED3677E65E}"/>
          </ac:spMkLst>
        </pc:spChg>
        <pc:spChg chg="mod topLvl">
          <ac:chgData name="Zhang, X (bw)" userId="8c11a9ad-4ec2-408f-b77f-edf277d143b8" providerId="ADAL" clId="{917AA4CC-9489-41C4-AF82-0BBF3A8480D9}" dt="2025-02-17T09:50:09.129" v="205" actId="255"/>
          <ac:spMkLst>
            <pc:docMk/>
            <pc:sldMk cId="1424199435" sldId="414"/>
            <ac:spMk id="77" creationId="{DE2058EC-873E-BC5C-18E4-895866F6651A}"/>
          </ac:spMkLst>
        </pc:spChg>
        <pc:spChg chg="mod topLvl">
          <ac:chgData name="Zhang, X (bw)" userId="8c11a9ad-4ec2-408f-b77f-edf277d143b8" providerId="ADAL" clId="{917AA4CC-9489-41C4-AF82-0BBF3A8480D9}" dt="2025-02-17T09:56:01.375" v="249" actId="338"/>
          <ac:spMkLst>
            <pc:docMk/>
            <pc:sldMk cId="1424199435" sldId="414"/>
            <ac:spMk id="78" creationId="{F91C0E2A-8C77-AEBF-76E0-422B4BD2C1BA}"/>
          </ac:spMkLst>
        </pc:spChg>
        <pc:spChg chg="mod topLvl">
          <ac:chgData name="Zhang, X (bw)" userId="8c11a9ad-4ec2-408f-b77f-edf277d143b8" providerId="ADAL" clId="{917AA4CC-9489-41C4-AF82-0BBF3A8480D9}" dt="2025-02-17T09:50:31.726" v="206" actId="408"/>
          <ac:spMkLst>
            <pc:docMk/>
            <pc:sldMk cId="1424199435" sldId="414"/>
            <ac:spMk id="80" creationId="{035856D0-7D5A-7C41-6E04-6D2280EBB8F6}"/>
          </ac:spMkLst>
        </pc:spChg>
        <pc:spChg chg="mod">
          <ac:chgData name="Zhang, X (bw)" userId="8c11a9ad-4ec2-408f-b77f-edf277d143b8" providerId="ADAL" clId="{917AA4CC-9489-41C4-AF82-0BBF3A8480D9}" dt="2025-02-17T09:37:40.760" v="77" actId="1037"/>
          <ac:spMkLst>
            <pc:docMk/>
            <pc:sldMk cId="1424199435" sldId="414"/>
            <ac:spMk id="81" creationId="{0E6DE2C9-C302-325E-C4A7-5DF99F34AD7A}"/>
          </ac:spMkLst>
        </pc:spChg>
        <pc:spChg chg="mod topLvl">
          <ac:chgData name="Zhang, X (bw)" userId="8c11a9ad-4ec2-408f-b77f-edf277d143b8" providerId="ADAL" clId="{917AA4CC-9489-41C4-AF82-0BBF3A8480D9}" dt="2025-02-17T09:50:31.726" v="206" actId="408"/>
          <ac:spMkLst>
            <pc:docMk/>
            <pc:sldMk cId="1424199435" sldId="414"/>
            <ac:spMk id="83" creationId="{C5C0D555-D14E-AE1D-A26E-E1BE8C88B650}"/>
          </ac:spMkLst>
        </pc:spChg>
        <pc:spChg chg="mod">
          <ac:chgData name="Zhang, X (bw)" userId="8c11a9ad-4ec2-408f-b77f-edf277d143b8" providerId="ADAL" clId="{917AA4CC-9489-41C4-AF82-0BBF3A8480D9}" dt="2025-02-17T09:50:31.726" v="206" actId="408"/>
          <ac:spMkLst>
            <pc:docMk/>
            <pc:sldMk cId="1424199435" sldId="414"/>
            <ac:spMk id="86" creationId="{50E8A9D3-0016-B6B6-EFBF-EB763F5050F2}"/>
          </ac:spMkLst>
        </pc:spChg>
        <pc:spChg chg="mod topLvl">
          <ac:chgData name="Zhang, X (bw)" userId="8c11a9ad-4ec2-408f-b77f-edf277d143b8" providerId="ADAL" clId="{917AA4CC-9489-41C4-AF82-0BBF3A8480D9}" dt="2025-02-17T09:56:01.375" v="249" actId="338"/>
          <ac:spMkLst>
            <pc:docMk/>
            <pc:sldMk cId="1424199435" sldId="414"/>
            <ac:spMk id="87" creationId="{BA4C9A31-8083-C971-5815-5005B2381DCC}"/>
          </ac:spMkLst>
        </pc:spChg>
        <pc:spChg chg="mod">
          <ac:chgData name="Zhang, X (bw)" userId="8c11a9ad-4ec2-408f-b77f-edf277d143b8" providerId="ADAL" clId="{917AA4CC-9489-41C4-AF82-0BBF3A8480D9}" dt="2025-02-17T09:37:40.760" v="77" actId="1037"/>
          <ac:spMkLst>
            <pc:docMk/>
            <pc:sldMk cId="1424199435" sldId="414"/>
            <ac:spMk id="89" creationId="{69C23059-75A1-10EE-2F65-2426054DAD9D}"/>
          </ac:spMkLst>
        </pc:spChg>
        <pc:spChg chg="mod">
          <ac:chgData name="Zhang, X (bw)" userId="8c11a9ad-4ec2-408f-b77f-edf277d143b8" providerId="ADAL" clId="{917AA4CC-9489-41C4-AF82-0BBF3A8480D9}" dt="2025-02-17T09:56:01.375" v="249" actId="338"/>
          <ac:spMkLst>
            <pc:docMk/>
            <pc:sldMk cId="1424199435" sldId="414"/>
            <ac:spMk id="90" creationId="{89155E13-78AB-6F44-039D-9D03D48905C0}"/>
          </ac:spMkLst>
        </pc:spChg>
        <pc:spChg chg="mod">
          <ac:chgData name="Zhang, X (bw)" userId="8c11a9ad-4ec2-408f-b77f-edf277d143b8" providerId="ADAL" clId="{917AA4CC-9489-41C4-AF82-0BBF3A8480D9}" dt="2025-02-17T09:46:24.921" v="173" actId="1038"/>
          <ac:spMkLst>
            <pc:docMk/>
            <pc:sldMk cId="1424199435" sldId="414"/>
            <ac:spMk id="92" creationId="{D9F4912B-BDA4-BD41-B826-FF8CCDD6DCDB}"/>
          </ac:spMkLst>
        </pc:spChg>
        <pc:spChg chg="mod">
          <ac:chgData name="Zhang, X (bw)" userId="8c11a9ad-4ec2-408f-b77f-edf277d143b8" providerId="ADAL" clId="{917AA4CC-9489-41C4-AF82-0BBF3A8480D9}" dt="2025-02-17T09:46:24.921" v="173" actId="1038"/>
          <ac:spMkLst>
            <pc:docMk/>
            <pc:sldMk cId="1424199435" sldId="414"/>
            <ac:spMk id="99" creationId="{7DDAAD89-360D-BC7B-5FFD-6A064DEF7598}"/>
          </ac:spMkLst>
        </pc:spChg>
        <pc:spChg chg="mod">
          <ac:chgData name="Zhang, X (bw)" userId="8c11a9ad-4ec2-408f-b77f-edf277d143b8" providerId="ADAL" clId="{917AA4CC-9489-41C4-AF82-0BBF3A8480D9}" dt="2025-02-17T09:46:24.921" v="173" actId="1038"/>
          <ac:spMkLst>
            <pc:docMk/>
            <pc:sldMk cId="1424199435" sldId="414"/>
            <ac:spMk id="100" creationId="{B899BC31-768C-352B-C65C-FD9B3BA17EC9}"/>
          </ac:spMkLst>
        </pc:spChg>
        <pc:spChg chg="mod">
          <ac:chgData name="Zhang, X (bw)" userId="8c11a9ad-4ec2-408f-b77f-edf277d143b8" providerId="ADAL" clId="{917AA4CC-9489-41C4-AF82-0BBF3A8480D9}" dt="2025-02-17T09:47:34.877" v="179" actId="1038"/>
          <ac:spMkLst>
            <pc:docMk/>
            <pc:sldMk cId="1424199435" sldId="414"/>
            <ac:spMk id="107" creationId="{87766663-B72E-16ED-1BA2-82930203FC00}"/>
          </ac:spMkLst>
        </pc:spChg>
        <pc:spChg chg="mod topLvl">
          <ac:chgData name="Zhang, X (bw)" userId="8c11a9ad-4ec2-408f-b77f-edf277d143b8" providerId="ADAL" clId="{917AA4CC-9489-41C4-AF82-0BBF3A8480D9}" dt="2025-02-17T09:46:24.921" v="173" actId="1038"/>
          <ac:spMkLst>
            <pc:docMk/>
            <pc:sldMk cId="1424199435" sldId="414"/>
            <ac:spMk id="110" creationId="{7F55BD1F-0F82-C5BA-48B3-6DF2E2E798E6}"/>
          </ac:spMkLst>
        </pc:spChg>
        <pc:spChg chg="mod topLvl">
          <ac:chgData name="Zhang, X (bw)" userId="8c11a9ad-4ec2-408f-b77f-edf277d143b8" providerId="ADAL" clId="{917AA4CC-9489-41C4-AF82-0BBF3A8480D9}" dt="2025-02-17T09:46:24.921" v="173" actId="1038"/>
          <ac:spMkLst>
            <pc:docMk/>
            <pc:sldMk cId="1424199435" sldId="414"/>
            <ac:spMk id="116" creationId="{6AFC5514-C807-7AE5-289A-C1B1BC3D3C6A}"/>
          </ac:spMkLst>
        </pc:spChg>
        <pc:spChg chg="mod topLvl">
          <ac:chgData name="Zhang, X (bw)" userId="8c11a9ad-4ec2-408f-b77f-edf277d143b8" providerId="ADAL" clId="{917AA4CC-9489-41C4-AF82-0BBF3A8480D9}" dt="2025-02-17T09:45:54.150" v="168" actId="1038"/>
          <ac:spMkLst>
            <pc:docMk/>
            <pc:sldMk cId="1424199435" sldId="414"/>
            <ac:spMk id="118" creationId="{7E1FA0A2-0062-FE85-BCA7-144BCC3B51CD}"/>
          </ac:spMkLst>
        </pc:spChg>
        <pc:spChg chg="mod">
          <ac:chgData name="Zhang, X (bw)" userId="8c11a9ad-4ec2-408f-b77f-edf277d143b8" providerId="ADAL" clId="{917AA4CC-9489-41C4-AF82-0BBF3A8480D9}" dt="2025-02-17T09:56:01.375" v="249" actId="338"/>
          <ac:spMkLst>
            <pc:docMk/>
            <pc:sldMk cId="1424199435" sldId="414"/>
            <ac:spMk id="119" creationId="{708A3442-748B-721B-5718-12C06CE43674}"/>
          </ac:spMkLst>
        </pc:spChg>
        <pc:spChg chg="mod">
          <ac:chgData name="Zhang, X (bw)" userId="8c11a9ad-4ec2-408f-b77f-edf277d143b8" providerId="ADAL" clId="{917AA4CC-9489-41C4-AF82-0BBF3A8480D9}" dt="2025-02-17T09:47:34.877" v="179" actId="1038"/>
          <ac:spMkLst>
            <pc:docMk/>
            <pc:sldMk cId="1424199435" sldId="414"/>
            <ac:spMk id="123" creationId="{0602185E-83BD-603F-9387-DE34A760C656}"/>
          </ac:spMkLst>
        </pc:spChg>
        <pc:spChg chg="mod">
          <ac:chgData name="Zhang, X (bw)" userId="8c11a9ad-4ec2-408f-b77f-edf277d143b8" providerId="ADAL" clId="{917AA4CC-9489-41C4-AF82-0BBF3A8480D9}" dt="2025-02-17T09:47:34.877" v="179" actId="1038"/>
          <ac:spMkLst>
            <pc:docMk/>
            <pc:sldMk cId="1424199435" sldId="414"/>
            <ac:spMk id="124" creationId="{ACA8A065-00B9-A9F9-B32D-3A1588A327DA}"/>
          </ac:spMkLst>
        </pc:spChg>
        <pc:spChg chg="mod topLvl">
          <ac:chgData name="Zhang, X (bw)" userId="8c11a9ad-4ec2-408f-b77f-edf277d143b8" providerId="ADAL" clId="{917AA4CC-9489-41C4-AF82-0BBF3A8480D9}" dt="2025-02-17T09:45:54.150" v="168" actId="1038"/>
          <ac:spMkLst>
            <pc:docMk/>
            <pc:sldMk cId="1424199435" sldId="414"/>
            <ac:spMk id="130" creationId="{A11FEE5A-FC32-58CC-A970-9312EEE820B7}"/>
          </ac:spMkLst>
        </pc:spChg>
        <pc:spChg chg="mod topLvl">
          <ac:chgData name="Zhang, X (bw)" userId="8c11a9ad-4ec2-408f-b77f-edf277d143b8" providerId="ADAL" clId="{917AA4CC-9489-41C4-AF82-0BBF3A8480D9}" dt="2025-02-17T09:45:54.150" v="168" actId="1038"/>
          <ac:spMkLst>
            <pc:docMk/>
            <pc:sldMk cId="1424199435" sldId="414"/>
            <ac:spMk id="134" creationId="{4D8F45C2-8A32-A103-21AF-57E9AE5EB22B}"/>
          </ac:spMkLst>
        </pc:spChg>
        <pc:spChg chg="mod topLvl">
          <ac:chgData name="Zhang, X (bw)" userId="8c11a9ad-4ec2-408f-b77f-edf277d143b8" providerId="ADAL" clId="{917AA4CC-9489-41C4-AF82-0BBF3A8480D9}" dt="2025-02-17T09:46:24.921" v="173" actId="1038"/>
          <ac:spMkLst>
            <pc:docMk/>
            <pc:sldMk cId="1424199435" sldId="414"/>
            <ac:spMk id="141" creationId="{75C4CBF2-7549-39B5-043B-D774C83431A4}"/>
          </ac:spMkLst>
        </pc:spChg>
        <pc:spChg chg="mod">
          <ac:chgData name="Zhang, X (bw)" userId="8c11a9ad-4ec2-408f-b77f-edf277d143b8" providerId="ADAL" clId="{917AA4CC-9489-41C4-AF82-0BBF3A8480D9}" dt="2025-02-17T09:47:34.877" v="179" actId="1038"/>
          <ac:spMkLst>
            <pc:docMk/>
            <pc:sldMk cId="1424199435" sldId="414"/>
            <ac:spMk id="142" creationId="{FC6B9EC9-C61A-9D1C-2EA1-7744C745698C}"/>
          </ac:spMkLst>
        </pc:spChg>
        <pc:spChg chg="mod">
          <ac:chgData name="Zhang, X (bw)" userId="8c11a9ad-4ec2-408f-b77f-edf277d143b8" providerId="ADAL" clId="{917AA4CC-9489-41C4-AF82-0BBF3A8480D9}" dt="2025-02-17T09:47:34.877" v="179" actId="1038"/>
          <ac:spMkLst>
            <pc:docMk/>
            <pc:sldMk cId="1424199435" sldId="414"/>
            <ac:spMk id="145" creationId="{13851A35-85A8-7A6A-5B56-332288A6F72F}"/>
          </ac:spMkLst>
        </pc:spChg>
        <pc:spChg chg="mod">
          <ac:chgData name="Zhang, X (bw)" userId="8c11a9ad-4ec2-408f-b77f-edf277d143b8" providerId="ADAL" clId="{917AA4CC-9489-41C4-AF82-0BBF3A8480D9}" dt="2025-02-17T09:56:01.375" v="249" actId="338"/>
          <ac:spMkLst>
            <pc:docMk/>
            <pc:sldMk cId="1424199435" sldId="414"/>
            <ac:spMk id="146" creationId="{22987FE1-5E51-7CDA-D15D-298780B01F50}"/>
          </ac:spMkLst>
        </pc:spChg>
        <pc:spChg chg="mod topLvl">
          <ac:chgData name="Zhang, X (bw)" userId="8c11a9ad-4ec2-408f-b77f-edf277d143b8" providerId="ADAL" clId="{917AA4CC-9489-41C4-AF82-0BBF3A8480D9}" dt="2025-02-17T09:46:24.921" v="173" actId="1038"/>
          <ac:spMkLst>
            <pc:docMk/>
            <pc:sldMk cId="1424199435" sldId="414"/>
            <ac:spMk id="148" creationId="{04C7D8D8-3C79-6A1D-DDB3-F8A48179A05D}"/>
          </ac:spMkLst>
        </pc:spChg>
        <pc:spChg chg="mod">
          <ac:chgData name="Zhang, X (bw)" userId="8c11a9ad-4ec2-408f-b77f-edf277d143b8" providerId="ADAL" clId="{917AA4CC-9489-41C4-AF82-0BBF3A8480D9}" dt="2025-02-17T09:56:01.375" v="249" actId="338"/>
          <ac:spMkLst>
            <pc:docMk/>
            <pc:sldMk cId="1424199435" sldId="414"/>
            <ac:spMk id="153" creationId="{44B7EB3E-77B4-E842-047F-6119134CA733}"/>
          </ac:spMkLst>
        </pc:spChg>
        <pc:spChg chg="mod">
          <ac:chgData name="Zhang, X (bw)" userId="8c11a9ad-4ec2-408f-b77f-edf277d143b8" providerId="ADAL" clId="{917AA4CC-9489-41C4-AF82-0BBF3A8480D9}" dt="2025-02-17T09:56:01.375" v="249" actId="338"/>
          <ac:spMkLst>
            <pc:docMk/>
            <pc:sldMk cId="1424199435" sldId="414"/>
            <ac:spMk id="154" creationId="{AE2E0FE1-5556-823D-63D9-65FB213E1B2D}"/>
          </ac:spMkLst>
        </pc:spChg>
        <pc:spChg chg="mod">
          <ac:chgData name="Zhang, X (bw)" userId="8c11a9ad-4ec2-408f-b77f-edf277d143b8" providerId="ADAL" clId="{917AA4CC-9489-41C4-AF82-0BBF3A8480D9}" dt="2025-02-17T09:47:34.877" v="179" actId="1038"/>
          <ac:spMkLst>
            <pc:docMk/>
            <pc:sldMk cId="1424199435" sldId="414"/>
            <ac:spMk id="181" creationId="{F5B8FA5C-CFAA-2065-17E8-B9B8BEF2E6D3}"/>
          </ac:spMkLst>
        </pc:spChg>
        <pc:spChg chg="mod">
          <ac:chgData name="Zhang, X (bw)" userId="8c11a9ad-4ec2-408f-b77f-edf277d143b8" providerId="ADAL" clId="{917AA4CC-9489-41C4-AF82-0BBF3A8480D9}" dt="2025-02-17T09:47:34.877" v="179" actId="1038"/>
          <ac:spMkLst>
            <pc:docMk/>
            <pc:sldMk cId="1424199435" sldId="414"/>
            <ac:spMk id="182" creationId="{1550F561-D2F2-0A5E-FAB9-EA93E0C599D8}"/>
          </ac:spMkLst>
        </pc:spChg>
        <pc:spChg chg="mod">
          <ac:chgData name="Zhang, X (bw)" userId="8c11a9ad-4ec2-408f-b77f-edf277d143b8" providerId="ADAL" clId="{917AA4CC-9489-41C4-AF82-0BBF3A8480D9}" dt="2025-02-17T09:56:01.375" v="249" actId="338"/>
          <ac:spMkLst>
            <pc:docMk/>
            <pc:sldMk cId="1424199435" sldId="414"/>
            <ac:spMk id="189" creationId="{4611FAAD-EC9C-4BB1-6AC1-1F19EAB63AED}"/>
          </ac:spMkLst>
        </pc:spChg>
        <pc:spChg chg="mod topLvl">
          <ac:chgData name="Zhang, X (bw)" userId="8c11a9ad-4ec2-408f-b77f-edf277d143b8" providerId="ADAL" clId="{917AA4CC-9489-41C4-AF82-0BBF3A8480D9}" dt="2025-02-17T09:45:54.150" v="168" actId="1038"/>
          <ac:spMkLst>
            <pc:docMk/>
            <pc:sldMk cId="1424199435" sldId="414"/>
            <ac:spMk id="197" creationId="{B4CE852E-6546-95CA-747A-F5B5EEF258FB}"/>
          </ac:spMkLst>
        </pc:spChg>
        <pc:grpChg chg="mod">
          <ac:chgData name="Zhang, X (bw)" userId="8c11a9ad-4ec2-408f-b77f-edf277d143b8" providerId="ADAL" clId="{917AA4CC-9489-41C4-AF82-0BBF3A8480D9}" dt="2025-02-17T09:56:24.620" v="265" actId="1037"/>
          <ac:grpSpMkLst>
            <pc:docMk/>
            <pc:sldMk cId="1424199435" sldId="414"/>
            <ac:grpSpMk id="16" creationId="{01CA0E49-3BCF-64F5-1F4C-68C38BB1FC41}"/>
          </ac:grpSpMkLst>
        </pc:grpChg>
        <pc:grpChg chg="mod">
          <ac:chgData name="Zhang, X (bw)" userId="8c11a9ad-4ec2-408f-b77f-edf277d143b8" providerId="ADAL" clId="{917AA4CC-9489-41C4-AF82-0BBF3A8480D9}" dt="2025-02-17T09:56:06.042" v="252" actId="1037"/>
          <ac:grpSpMkLst>
            <pc:docMk/>
            <pc:sldMk cId="1424199435" sldId="414"/>
            <ac:grpSpMk id="17" creationId="{A2815F52-7579-C5A4-5D7C-1A79E787BE13}"/>
          </ac:grpSpMkLst>
        </pc:grpChg>
        <pc:graphicFrameChg chg="mod modGraphic">
          <ac:chgData name="Zhang, X (bw)" userId="8c11a9ad-4ec2-408f-b77f-edf277d143b8" providerId="ADAL" clId="{917AA4CC-9489-41C4-AF82-0BBF3A8480D9}" dt="2025-02-17T09:56:24.620" v="265" actId="1037"/>
          <ac:graphicFrameMkLst>
            <pc:docMk/>
            <pc:sldMk cId="1424199435" sldId="414"/>
            <ac:graphicFrameMk id="2" creationId="{6C1031E6-0AB7-D31D-30C6-E86003857BDA}"/>
          </ac:graphicFrameMkLst>
        </pc:graphicFrameChg>
      </pc:sldChg>
      <pc:sldChg chg="del">
        <pc:chgData name="Zhang, X (bw)" userId="8c11a9ad-4ec2-408f-b77f-edf277d143b8" providerId="ADAL" clId="{917AA4CC-9489-41C4-AF82-0BBF3A8480D9}" dt="2025-02-17T09:52:03.676" v="209" actId="2696"/>
        <pc:sldMkLst>
          <pc:docMk/>
          <pc:sldMk cId="4292062087" sldId="415"/>
        </pc:sldMkLst>
      </pc:sldChg>
    </pc:docChg>
  </pc:docChgLst>
  <pc:docChgLst>
    <pc:chgData name="Lamoth, CJC" userId="9fd10590-716c-41f9-b907-ea3606eab60c" providerId="ADAL" clId="{F52BD872-3120-0B40-B62B-CA12AC80F4A8}"/>
    <pc:docChg chg="undo custSel modSld">
      <pc:chgData name="Lamoth, CJC" userId="9fd10590-716c-41f9-b907-ea3606eab60c" providerId="ADAL" clId="{F52BD872-3120-0B40-B62B-CA12AC80F4A8}" dt="2025-02-17T10:44:32.312" v="836" actId="478"/>
      <pc:docMkLst>
        <pc:docMk/>
      </pc:docMkLst>
      <pc:sldChg chg="modSp mod">
        <pc:chgData name="Lamoth, CJC" userId="9fd10590-716c-41f9-b907-ea3606eab60c" providerId="ADAL" clId="{F52BD872-3120-0B40-B62B-CA12AC80F4A8}" dt="2025-02-17T08:49:53.352" v="48" actId="113"/>
        <pc:sldMkLst>
          <pc:docMk/>
          <pc:sldMk cId="0" sldId="314"/>
        </pc:sldMkLst>
        <pc:spChg chg="mod">
          <ac:chgData name="Lamoth, CJC" userId="9fd10590-716c-41f9-b907-ea3606eab60c" providerId="ADAL" clId="{F52BD872-3120-0B40-B62B-CA12AC80F4A8}" dt="2025-02-17T08:41:10.640" v="21" actId="404"/>
          <ac:spMkLst>
            <pc:docMk/>
            <pc:sldMk cId="0" sldId="314"/>
            <ac:spMk id="2" creationId="{00000000-0000-0000-0000-000000000000}"/>
          </ac:spMkLst>
        </pc:spChg>
        <pc:spChg chg="mod">
          <ac:chgData name="Lamoth, CJC" userId="9fd10590-716c-41f9-b907-ea3606eab60c" providerId="ADAL" clId="{F52BD872-3120-0B40-B62B-CA12AC80F4A8}" dt="2025-02-17T08:49:48.634" v="46" actId="113"/>
          <ac:spMkLst>
            <pc:docMk/>
            <pc:sldMk cId="0" sldId="314"/>
            <ac:spMk id="3" creationId="{00000000-0000-0000-0000-000000000000}"/>
          </ac:spMkLst>
        </pc:spChg>
        <pc:spChg chg="mod">
          <ac:chgData name="Lamoth, CJC" userId="9fd10590-716c-41f9-b907-ea3606eab60c" providerId="ADAL" clId="{F52BD872-3120-0B40-B62B-CA12AC80F4A8}" dt="2025-02-17T08:41:23.908" v="24" actId="403"/>
          <ac:spMkLst>
            <pc:docMk/>
            <pc:sldMk cId="0" sldId="314"/>
            <ac:spMk id="4" creationId="{00000000-0000-0000-0000-000000000000}"/>
          </ac:spMkLst>
        </pc:spChg>
        <pc:spChg chg="mod">
          <ac:chgData name="Lamoth, CJC" userId="9fd10590-716c-41f9-b907-ea3606eab60c" providerId="ADAL" clId="{F52BD872-3120-0B40-B62B-CA12AC80F4A8}" dt="2025-02-17T08:49:51.197" v="47" actId="113"/>
          <ac:spMkLst>
            <pc:docMk/>
            <pc:sldMk cId="0" sldId="314"/>
            <ac:spMk id="6" creationId="{00000000-0000-0000-0000-000000000000}"/>
          </ac:spMkLst>
        </pc:spChg>
        <pc:spChg chg="mod">
          <ac:chgData name="Lamoth, CJC" userId="9fd10590-716c-41f9-b907-ea3606eab60c" providerId="ADAL" clId="{F52BD872-3120-0B40-B62B-CA12AC80F4A8}" dt="2025-02-17T08:42:31.721" v="37" actId="2711"/>
          <ac:spMkLst>
            <pc:docMk/>
            <pc:sldMk cId="0" sldId="314"/>
            <ac:spMk id="7" creationId="{00000000-0000-0000-0000-000000000000}"/>
          </ac:spMkLst>
        </pc:spChg>
        <pc:spChg chg="mod">
          <ac:chgData name="Lamoth, CJC" userId="9fd10590-716c-41f9-b907-ea3606eab60c" providerId="ADAL" clId="{F52BD872-3120-0B40-B62B-CA12AC80F4A8}" dt="2025-02-17T08:49:53.352" v="48" actId="113"/>
          <ac:spMkLst>
            <pc:docMk/>
            <pc:sldMk cId="0" sldId="314"/>
            <ac:spMk id="8" creationId="{00000000-0000-0000-0000-000000000000}"/>
          </ac:spMkLst>
        </pc:spChg>
        <pc:spChg chg="mod">
          <ac:chgData name="Lamoth, CJC" userId="9fd10590-716c-41f9-b907-ea3606eab60c" providerId="ADAL" clId="{F52BD872-3120-0B40-B62B-CA12AC80F4A8}" dt="2025-02-17T08:42:43.558" v="40" actId="2711"/>
          <ac:spMkLst>
            <pc:docMk/>
            <pc:sldMk cId="0" sldId="314"/>
            <ac:spMk id="9" creationId="{00000000-0000-0000-0000-000000000000}"/>
          </ac:spMkLst>
        </pc:spChg>
        <pc:spChg chg="mod">
          <ac:chgData name="Lamoth, CJC" userId="9fd10590-716c-41f9-b907-ea3606eab60c" providerId="ADAL" clId="{F52BD872-3120-0B40-B62B-CA12AC80F4A8}" dt="2025-02-17T08:42:22.560" v="36" actId="403"/>
          <ac:spMkLst>
            <pc:docMk/>
            <pc:sldMk cId="0" sldId="314"/>
            <ac:spMk id="14" creationId="{00000000-0000-0000-0000-000000000000}"/>
          </ac:spMkLst>
        </pc:spChg>
        <pc:spChg chg="mod">
          <ac:chgData name="Lamoth, CJC" userId="9fd10590-716c-41f9-b907-ea3606eab60c" providerId="ADAL" clId="{F52BD872-3120-0B40-B62B-CA12AC80F4A8}" dt="2025-02-17T08:42:13.273" v="34" actId="403"/>
          <ac:spMkLst>
            <pc:docMk/>
            <pc:sldMk cId="0" sldId="314"/>
            <ac:spMk id="15" creationId="{00000000-0000-0000-0000-000000000000}"/>
          </ac:spMkLst>
        </pc:spChg>
        <pc:spChg chg="mod">
          <ac:chgData name="Lamoth, CJC" userId="9fd10590-716c-41f9-b907-ea3606eab60c" providerId="ADAL" clId="{F52BD872-3120-0B40-B62B-CA12AC80F4A8}" dt="2025-02-17T08:42:03.571" v="31" actId="403"/>
          <ac:spMkLst>
            <pc:docMk/>
            <pc:sldMk cId="0" sldId="314"/>
            <ac:spMk id="16" creationId="{00000000-0000-0000-0000-000000000000}"/>
          </ac:spMkLst>
        </pc:spChg>
        <pc:spChg chg="mod">
          <ac:chgData name="Lamoth, CJC" userId="9fd10590-716c-41f9-b907-ea3606eab60c" providerId="ADAL" clId="{F52BD872-3120-0B40-B62B-CA12AC80F4A8}" dt="2025-02-17T08:42:50.999" v="43" actId="20577"/>
          <ac:spMkLst>
            <pc:docMk/>
            <pc:sldMk cId="0" sldId="314"/>
            <ac:spMk id="20" creationId="{67B508D1-A4C1-4020-B0F0-168365E4DC04}"/>
          </ac:spMkLst>
        </pc:spChg>
      </pc:sldChg>
      <pc:sldChg chg="modSp mod">
        <pc:chgData name="Lamoth, CJC" userId="9fd10590-716c-41f9-b907-ea3606eab60c" providerId="ADAL" clId="{F52BD872-3120-0B40-B62B-CA12AC80F4A8}" dt="2025-02-17T08:50:46.998" v="54" actId="14100"/>
        <pc:sldMkLst>
          <pc:docMk/>
          <pc:sldMk cId="3549655527" sldId="406"/>
        </pc:sldMkLst>
        <pc:spChg chg="mod">
          <ac:chgData name="Lamoth, CJC" userId="9fd10590-716c-41f9-b907-ea3606eab60c" providerId="ADAL" clId="{F52BD872-3120-0B40-B62B-CA12AC80F4A8}" dt="2025-02-17T08:50:46.998" v="54" actId="14100"/>
          <ac:spMkLst>
            <pc:docMk/>
            <pc:sldMk cId="3549655527" sldId="406"/>
            <ac:spMk id="11" creationId="{00000000-0000-0000-0000-000000000000}"/>
          </ac:spMkLst>
        </pc:spChg>
      </pc:sldChg>
      <pc:sldChg chg="addSp delSp modSp mod">
        <pc:chgData name="Lamoth, CJC" userId="9fd10590-716c-41f9-b907-ea3606eab60c" providerId="ADAL" clId="{F52BD872-3120-0B40-B62B-CA12AC80F4A8}" dt="2025-02-17T10:44:01.421" v="835" actId="121"/>
        <pc:sldMkLst>
          <pc:docMk/>
          <pc:sldMk cId="3117842035" sldId="410"/>
        </pc:sldMkLst>
        <pc:spChg chg="add del mod">
          <ac:chgData name="Lamoth, CJC" userId="9fd10590-716c-41f9-b907-ea3606eab60c" providerId="ADAL" clId="{F52BD872-3120-0B40-B62B-CA12AC80F4A8}" dt="2025-02-17T09:03:03.636" v="269" actId="21"/>
          <ac:spMkLst>
            <pc:docMk/>
            <pc:sldMk cId="3117842035" sldId="410"/>
            <ac:spMk id="4" creationId="{D4C546DD-E6C3-946A-6503-A50842697963}"/>
          </ac:spMkLst>
        </pc:spChg>
        <pc:spChg chg="add mod">
          <ac:chgData name="Lamoth, CJC" userId="9fd10590-716c-41f9-b907-ea3606eab60c" providerId="ADAL" clId="{F52BD872-3120-0B40-B62B-CA12AC80F4A8}" dt="2025-02-17T10:19:08.278" v="655" actId="164"/>
          <ac:spMkLst>
            <pc:docMk/>
            <pc:sldMk cId="3117842035" sldId="410"/>
            <ac:spMk id="5" creationId="{B42ECCA4-8505-F697-2C06-F94423ED3D12}"/>
          </ac:spMkLst>
        </pc:spChg>
        <pc:spChg chg="add del mod">
          <ac:chgData name="Lamoth, CJC" userId="9fd10590-716c-41f9-b907-ea3606eab60c" providerId="ADAL" clId="{F52BD872-3120-0B40-B62B-CA12AC80F4A8}" dt="2025-02-17T09:08:52.586" v="516" actId="478"/>
          <ac:spMkLst>
            <pc:docMk/>
            <pc:sldMk cId="3117842035" sldId="410"/>
            <ac:spMk id="9" creationId="{FAF0F06C-8F92-3841-5450-BDF97BCBA09E}"/>
          </ac:spMkLst>
        </pc:spChg>
        <pc:spChg chg="del">
          <ac:chgData name="Lamoth, CJC" userId="9fd10590-716c-41f9-b907-ea3606eab60c" providerId="ADAL" clId="{F52BD872-3120-0B40-B62B-CA12AC80F4A8}" dt="2025-02-17T10:42:38.307" v="816" actId="478"/>
          <ac:spMkLst>
            <pc:docMk/>
            <pc:sldMk cId="3117842035" sldId="410"/>
            <ac:spMk id="192" creationId="{36518EA1-AD56-660E-31EE-400F896AF40D}"/>
          </ac:spMkLst>
        </pc:spChg>
        <pc:spChg chg="del mod">
          <ac:chgData name="Lamoth, CJC" userId="9fd10590-716c-41f9-b907-ea3606eab60c" providerId="ADAL" clId="{F52BD872-3120-0B40-B62B-CA12AC80F4A8}" dt="2025-02-17T10:36:46.814" v="795"/>
          <ac:spMkLst>
            <pc:docMk/>
            <pc:sldMk cId="3117842035" sldId="410"/>
            <ac:spMk id="215" creationId="{0964AAE2-AB26-9535-857F-7FB568CD3365}"/>
          </ac:spMkLst>
        </pc:spChg>
        <pc:spChg chg="add del mod topLvl">
          <ac:chgData name="Lamoth, CJC" userId="9fd10590-716c-41f9-b907-ea3606eab60c" providerId="ADAL" clId="{F52BD872-3120-0B40-B62B-CA12AC80F4A8}" dt="2025-02-17T10:34:27.795" v="788" actId="20577"/>
          <ac:spMkLst>
            <pc:docMk/>
            <pc:sldMk cId="3117842035" sldId="410"/>
            <ac:spMk id="217" creationId="{700C5413-2AC7-57A7-B9B8-3E86A811E356}"/>
          </ac:spMkLst>
        </pc:spChg>
        <pc:spChg chg="mod topLvl">
          <ac:chgData name="Lamoth, CJC" userId="9fd10590-716c-41f9-b907-ea3606eab60c" providerId="ADAL" clId="{F52BD872-3120-0B40-B62B-CA12AC80F4A8}" dt="2025-02-17T10:19:08.278" v="655" actId="164"/>
          <ac:spMkLst>
            <pc:docMk/>
            <pc:sldMk cId="3117842035" sldId="410"/>
            <ac:spMk id="218" creationId="{B9A1D9A3-82AD-C1BB-79F8-D2D937300968}"/>
          </ac:spMkLst>
        </pc:spChg>
        <pc:spChg chg="del">
          <ac:chgData name="Lamoth, CJC" userId="9fd10590-716c-41f9-b907-ea3606eab60c" providerId="ADAL" clId="{F52BD872-3120-0B40-B62B-CA12AC80F4A8}" dt="2025-02-17T09:02:58.088" v="267" actId="21"/>
          <ac:spMkLst>
            <pc:docMk/>
            <pc:sldMk cId="3117842035" sldId="410"/>
            <ac:spMk id="219" creationId="{C449DE7E-A862-62DB-15D8-282EB0701369}"/>
          </ac:spMkLst>
        </pc:spChg>
        <pc:spChg chg="mod topLvl">
          <ac:chgData name="Lamoth, CJC" userId="9fd10590-716c-41f9-b907-ea3606eab60c" providerId="ADAL" clId="{F52BD872-3120-0B40-B62B-CA12AC80F4A8}" dt="2025-02-17T10:19:08.278" v="655" actId="164"/>
          <ac:spMkLst>
            <pc:docMk/>
            <pc:sldMk cId="3117842035" sldId="410"/>
            <ac:spMk id="220" creationId="{315FB750-F579-6E8A-C3E3-3E4CF8A1F206}"/>
          </ac:spMkLst>
        </pc:spChg>
        <pc:spChg chg="add mod">
          <ac:chgData name="Lamoth, CJC" userId="9fd10590-716c-41f9-b907-ea3606eab60c" providerId="ADAL" clId="{F52BD872-3120-0B40-B62B-CA12AC80F4A8}" dt="2025-02-17T10:19:08.278" v="655" actId="164"/>
          <ac:spMkLst>
            <pc:docMk/>
            <pc:sldMk cId="3117842035" sldId="410"/>
            <ac:spMk id="224" creationId="{731F72EE-2864-988F-A70A-0BAE903813C8}"/>
          </ac:spMkLst>
        </pc:spChg>
        <pc:spChg chg="add mod">
          <ac:chgData name="Lamoth, CJC" userId="9fd10590-716c-41f9-b907-ea3606eab60c" providerId="ADAL" clId="{F52BD872-3120-0B40-B62B-CA12AC80F4A8}" dt="2025-02-17T10:06:22.411" v="553" actId="1076"/>
          <ac:spMkLst>
            <pc:docMk/>
            <pc:sldMk cId="3117842035" sldId="410"/>
            <ac:spMk id="225" creationId="{E3CBE83D-813C-AC1B-2716-5DDB46D8310B}"/>
          </ac:spMkLst>
        </pc:spChg>
        <pc:spChg chg="add del">
          <ac:chgData name="Lamoth, CJC" userId="9fd10590-716c-41f9-b907-ea3606eab60c" providerId="ADAL" clId="{F52BD872-3120-0B40-B62B-CA12AC80F4A8}" dt="2025-02-17T10:17:04.691" v="639" actId="22"/>
          <ac:spMkLst>
            <pc:docMk/>
            <pc:sldMk cId="3117842035" sldId="410"/>
            <ac:spMk id="231" creationId="{357B8C93-FEC7-D73C-F353-ECAC0C2785E2}"/>
          </ac:spMkLst>
        </pc:spChg>
        <pc:spChg chg="add del">
          <ac:chgData name="Lamoth, CJC" userId="9fd10590-716c-41f9-b907-ea3606eab60c" providerId="ADAL" clId="{F52BD872-3120-0B40-B62B-CA12AC80F4A8}" dt="2025-02-17T10:17:16.752" v="641" actId="22"/>
          <ac:spMkLst>
            <pc:docMk/>
            <pc:sldMk cId="3117842035" sldId="410"/>
            <ac:spMk id="233" creationId="{9EA382E2-1858-D790-C370-AAA2C055AEC5}"/>
          </ac:spMkLst>
        </pc:spChg>
        <pc:grpChg chg="add del">
          <ac:chgData name="Lamoth, CJC" userId="9fd10590-716c-41f9-b907-ea3606eab60c" providerId="ADAL" clId="{F52BD872-3120-0B40-B62B-CA12AC80F4A8}" dt="2025-02-17T10:15:38.355" v="628" actId="165"/>
          <ac:grpSpMkLst>
            <pc:docMk/>
            <pc:sldMk cId="3117842035" sldId="410"/>
            <ac:grpSpMk id="216" creationId="{48554CBF-C136-16F0-E5C9-0133317A4A7D}"/>
          </ac:grpSpMkLst>
        </pc:grpChg>
        <pc:grpChg chg="add del mod">
          <ac:chgData name="Lamoth, CJC" userId="9fd10590-716c-41f9-b907-ea3606eab60c" providerId="ADAL" clId="{F52BD872-3120-0B40-B62B-CA12AC80F4A8}" dt="2025-02-17T10:16:34.649" v="634" actId="165"/>
          <ac:grpSpMkLst>
            <pc:docMk/>
            <pc:sldMk cId="3117842035" sldId="410"/>
            <ac:grpSpMk id="228" creationId="{66B16A1B-AD5B-B6A5-9468-38A50019F227}"/>
          </ac:grpSpMkLst>
        </pc:grpChg>
        <pc:grpChg chg="add mod">
          <ac:chgData name="Lamoth, CJC" userId="9fd10590-716c-41f9-b907-ea3606eab60c" providerId="ADAL" clId="{F52BD872-3120-0B40-B62B-CA12AC80F4A8}" dt="2025-02-17T10:19:22.509" v="657" actId="164"/>
          <ac:grpSpMkLst>
            <pc:docMk/>
            <pc:sldMk cId="3117842035" sldId="410"/>
            <ac:grpSpMk id="229" creationId="{6304E468-B2A4-FB65-39F4-D0FC52ACA092}"/>
          </ac:grpSpMkLst>
        </pc:grpChg>
        <pc:grpChg chg="add mod">
          <ac:chgData name="Lamoth, CJC" userId="9fd10590-716c-41f9-b907-ea3606eab60c" providerId="ADAL" clId="{F52BD872-3120-0B40-B62B-CA12AC80F4A8}" dt="2025-02-17T10:19:08.278" v="655" actId="164"/>
          <ac:grpSpMkLst>
            <pc:docMk/>
            <pc:sldMk cId="3117842035" sldId="410"/>
            <ac:grpSpMk id="234" creationId="{FCAFD94D-AE3D-0703-7AEE-555AE8575B59}"/>
          </ac:grpSpMkLst>
        </pc:grpChg>
        <pc:grpChg chg="add mod">
          <ac:chgData name="Lamoth, CJC" userId="9fd10590-716c-41f9-b907-ea3606eab60c" providerId="ADAL" clId="{F52BD872-3120-0B40-B62B-CA12AC80F4A8}" dt="2025-02-17T10:36:24.994" v="792" actId="1076"/>
          <ac:grpSpMkLst>
            <pc:docMk/>
            <pc:sldMk cId="3117842035" sldId="410"/>
            <ac:grpSpMk id="235" creationId="{7840FEB4-8930-EDF2-7252-DE3364053F21}"/>
          </ac:grpSpMkLst>
        </pc:grpChg>
        <pc:graphicFrameChg chg="mod modGraphic">
          <ac:chgData name="Lamoth, CJC" userId="9fd10590-716c-41f9-b907-ea3606eab60c" providerId="ADAL" clId="{F52BD872-3120-0B40-B62B-CA12AC80F4A8}" dt="2025-02-17T10:44:01.421" v="835" actId="121"/>
          <ac:graphicFrameMkLst>
            <pc:docMk/>
            <pc:sldMk cId="3117842035" sldId="410"/>
            <ac:graphicFrameMk id="10" creationId="{FDC38EC0-5D6B-B183-AE2E-E3D09F8FB677}"/>
          </ac:graphicFrameMkLst>
        </pc:graphicFrameChg>
        <pc:picChg chg="add del mod">
          <ac:chgData name="Lamoth, CJC" userId="9fd10590-716c-41f9-b907-ea3606eab60c" providerId="ADAL" clId="{F52BD872-3120-0B40-B62B-CA12AC80F4A8}" dt="2025-02-17T10:34:29.683" v="789" actId="478"/>
          <ac:picMkLst>
            <pc:docMk/>
            <pc:sldMk cId="3117842035" sldId="410"/>
            <ac:picMk id="227" creationId="{54191C1C-165B-6817-4AF2-11958625B512}"/>
          </ac:picMkLst>
        </pc:picChg>
      </pc:sldChg>
      <pc:sldChg chg="addSp delSp modSp mod">
        <pc:chgData name="Lamoth, CJC" userId="9fd10590-716c-41f9-b907-ea3606eab60c" providerId="ADAL" clId="{F52BD872-3120-0B40-B62B-CA12AC80F4A8}" dt="2025-02-17T10:44:32.312" v="836" actId="478"/>
        <pc:sldMkLst>
          <pc:docMk/>
          <pc:sldMk cId="3418119145" sldId="413"/>
        </pc:sldMkLst>
        <pc:spChg chg="add del mod">
          <ac:chgData name="Lamoth, CJC" userId="9fd10590-716c-41f9-b907-ea3606eab60c" providerId="ADAL" clId="{F52BD872-3120-0B40-B62B-CA12AC80F4A8}" dt="2025-02-17T10:44:32.312" v="836" actId="478"/>
          <ac:spMkLst>
            <pc:docMk/>
            <pc:sldMk cId="3418119145" sldId="413"/>
            <ac:spMk id="5" creationId="{9C0E545C-BA1E-D92D-9B80-05EB51852971}"/>
          </ac:spMkLst>
        </pc:spChg>
      </pc:sldChg>
      <pc:sldChg chg="addSp delSp modSp mod">
        <pc:chgData name="Lamoth, CJC" userId="9fd10590-716c-41f9-b907-ea3606eab60c" providerId="ADAL" clId="{F52BD872-3120-0B40-B62B-CA12AC80F4A8}" dt="2025-02-17T10:39:53.299" v="806" actId="20577"/>
        <pc:sldMkLst>
          <pc:docMk/>
          <pc:sldMk cId="1424199435" sldId="414"/>
        </pc:sldMkLst>
        <pc:spChg chg="del mod">
          <ac:chgData name="Lamoth, CJC" userId="9fd10590-716c-41f9-b907-ea3606eab60c" providerId="ADAL" clId="{F52BD872-3120-0B40-B62B-CA12AC80F4A8}" dt="2025-02-17T10:04:15.738" v="525"/>
          <ac:spMkLst>
            <pc:docMk/>
            <pc:sldMk cId="1424199435" sldId="414"/>
            <ac:spMk id="11" creationId="{1455EFA2-5A86-1AF1-F47B-1E23FDC3C913}"/>
          </ac:spMkLst>
        </pc:spChg>
        <pc:spChg chg="add del mod">
          <ac:chgData name="Lamoth, CJC" userId="9fd10590-716c-41f9-b907-ea3606eab60c" providerId="ADAL" clId="{F52BD872-3120-0B40-B62B-CA12AC80F4A8}" dt="2025-02-17T10:04:13.971" v="523" actId="21"/>
          <ac:spMkLst>
            <pc:docMk/>
            <pc:sldMk cId="1424199435" sldId="414"/>
            <ac:spMk id="163" creationId="{C1FC9E1B-56DE-EBEA-8205-C8C7D36C71E0}"/>
          </ac:spMkLst>
        </pc:spChg>
        <pc:spChg chg="add mod">
          <ac:chgData name="Lamoth, CJC" userId="9fd10590-716c-41f9-b907-ea3606eab60c" providerId="ADAL" clId="{F52BD872-3120-0B40-B62B-CA12AC80F4A8}" dt="2025-02-17T10:17:39.303" v="643"/>
          <ac:spMkLst>
            <pc:docMk/>
            <pc:sldMk cId="1424199435" sldId="414"/>
            <ac:spMk id="176" creationId="{2B5123EC-6154-1054-79B2-B7A1C4716485}"/>
          </ac:spMkLst>
        </pc:spChg>
        <pc:spChg chg="mod">
          <ac:chgData name="Lamoth, CJC" userId="9fd10590-716c-41f9-b907-ea3606eab60c" providerId="ADAL" clId="{F52BD872-3120-0B40-B62B-CA12AC80F4A8}" dt="2025-02-17T10:19:33.559" v="658"/>
          <ac:spMkLst>
            <pc:docMk/>
            <pc:sldMk cId="1424199435" sldId="414"/>
            <ac:spMk id="178" creationId="{2D874AB8-9A77-F3D6-B14C-D179CCC3FF53}"/>
          </ac:spMkLst>
        </pc:spChg>
        <pc:spChg chg="mod">
          <ac:chgData name="Lamoth, CJC" userId="9fd10590-716c-41f9-b907-ea3606eab60c" providerId="ADAL" clId="{F52BD872-3120-0B40-B62B-CA12AC80F4A8}" dt="2025-02-17T10:19:33.559" v="658"/>
          <ac:spMkLst>
            <pc:docMk/>
            <pc:sldMk cId="1424199435" sldId="414"/>
            <ac:spMk id="183" creationId="{16993466-A07E-BBEE-61F4-0DCF31EDDC63}"/>
          </ac:spMkLst>
        </pc:spChg>
        <pc:spChg chg="mod">
          <ac:chgData name="Lamoth, CJC" userId="9fd10590-716c-41f9-b907-ea3606eab60c" providerId="ADAL" clId="{F52BD872-3120-0B40-B62B-CA12AC80F4A8}" dt="2025-02-17T10:19:33.559" v="658"/>
          <ac:spMkLst>
            <pc:docMk/>
            <pc:sldMk cId="1424199435" sldId="414"/>
            <ac:spMk id="184" creationId="{F2B76A43-199C-C1A2-B686-3BF0C69FD863}"/>
          </ac:spMkLst>
        </pc:spChg>
        <pc:spChg chg="mod">
          <ac:chgData name="Lamoth, CJC" userId="9fd10590-716c-41f9-b907-ea3606eab60c" providerId="ADAL" clId="{F52BD872-3120-0B40-B62B-CA12AC80F4A8}" dt="2025-02-17T10:19:33.559" v="658"/>
          <ac:spMkLst>
            <pc:docMk/>
            <pc:sldMk cId="1424199435" sldId="414"/>
            <ac:spMk id="185" creationId="{391F2DFE-52C3-44AF-752D-122FF80E1411}"/>
          </ac:spMkLst>
        </pc:spChg>
        <pc:spChg chg="mod">
          <ac:chgData name="Lamoth, CJC" userId="9fd10590-716c-41f9-b907-ea3606eab60c" providerId="ADAL" clId="{F52BD872-3120-0B40-B62B-CA12AC80F4A8}" dt="2025-02-17T10:19:33.559" v="658"/>
          <ac:spMkLst>
            <pc:docMk/>
            <pc:sldMk cId="1424199435" sldId="414"/>
            <ac:spMk id="186" creationId="{9ACFA201-745F-3C00-40FC-4BF1BBF51C74}"/>
          </ac:spMkLst>
        </pc:spChg>
        <pc:spChg chg="mod">
          <ac:chgData name="Lamoth, CJC" userId="9fd10590-716c-41f9-b907-ea3606eab60c" providerId="ADAL" clId="{F52BD872-3120-0B40-B62B-CA12AC80F4A8}" dt="2025-02-17T10:21:03.856" v="661"/>
          <ac:spMkLst>
            <pc:docMk/>
            <pc:sldMk cId="1424199435" sldId="414"/>
            <ac:spMk id="191" creationId="{AEDB8749-491B-5DBC-B9F0-94E883FB93B4}"/>
          </ac:spMkLst>
        </pc:spChg>
        <pc:spChg chg="mod">
          <ac:chgData name="Lamoth, CJC" userId="9fd10590-716c-41f9-b907-ea3606eab60c" providerId="ADAL" clId="{F52BD872-3120-0B40-B62B-CA12AC80F4A8}" dt="2025-02-17T10:21:03.856" v="661"/>
          <ac:spMkLst>
            <pc:docMk/>
            <pc:sldMk cId="1424199435" sldId="414"/>
            <ac:spMk id="193" creationId="{958EE8EA-9EE3-9180-C328-CCAF0905E92F}"/>
          </ac:spMkLst>
        </pc:spChg>
        <pc:spChg chg="mod">
          <ac:chgData name="Lamoth, CJC" userId="9fd10590-716c-41f9-b907-ea3606eab60c" providerId="ADAL" clId="{F52BD872-3120-0B40-B62B-CA12AC80F4A8}" dt="2025-02-17T10:21:03.856" v="661"/>
          <ac:spMkLst>
            <pc:docMk/>
            <pc:sldMk cId="1424199435" sldId="414"/>
            <ac:spMk id="194" creationId="{7F262621-5A94-C126-B0D8-87616D6FEB75}"/>
          </ac:spMkLst>
        </pc:spChg>
        <pc:spChg chg="mod">
          <ac:chgData name="Lamoth, CJC" userId="9fd10590-716c-41f9-b907-ea3606eab60c" providerId="ADAL" clId="{F52BD872-3120-0B40-B62B-CA12AC80F4A8}" dt="2025-02-17T10:21:03.856" v="661"/>
          <ac:spMkLst>
            <pc:docMk/>
            <pc:sldMk cId="1424199435" sldId="414"/>
            <ac:spMk id="195" creationId="{7CCA74B7-BB64-8A92-FF41-6D3CD40C7D89}"/>
          </ac:spMkLst>
        </pc:spChg>
        <pc:spChg chg="mod">
          <ac:chgData name="Lamoth, CJC" userId="9fd10590-716c-41f9-b907-ea3606eab60c" providerId="ADAL" clId="{F52BD872-3120-0B40-B62B-CA12AC80F4A8}" dt="2025-02-17T10:21:03.856" v="661"/>
          <ac:spMkLst>
            <pc:docMk/>
            <pc:sldMk cId="1424199435" sldId="414"/>
            <ac:spMk id="196" creationId="{E1E271C0-ED39-6275-109B-85D2EB60152D}"/>
          </ac:spMkLst>
        </pc:spChg>
        <pc:spChg chg="mod topLvl">
          <ac:chgData name="Lamoth, CJC" userId="9fd10590-716c-41f9-b907-ea3606eab60c" providerId="ADAL" clId="{F52BD872-3120-0B40-B62B-CA12AC80F4A8}" dt="2025-02-17T10:32:46.330" v="782" actId="14100"/>
          <ac:spMkLst>
            <pc:docMk/>
            <pc:sldMk cId="1424199435" sldId="414"/>
            <ac:spMk id="201" creationId="{2976DEFF-0FC6-E98B-DFE1-8D49ED580F79}"/>
          </ac:spMkLst>
        </pc:spChg>
        <pc:spChg chg="mod topLvl">
          <ac:chgData name="Lamoth, CJC" userId="9fd10590-716c-41f9-b907-ea3606eab60c" providerId="ADAL" clId="{F52BD872-3120-0B40-B62B-CA12AC80F4A8}" dt="2025-02-17T10:29:32.700" v="736" actId="1076"/>
          <ac:spMkLst>
            <pc:docMk/>
            <pc:sldMk cId="1424199435" sldId="414"/>
            <ac:spMk id="203" creationId="{D1FF99F1-4574-88C2-7FE7-155318B975CE}"/>
          </ac:spMkLst>
        </pc:spChg>
        <pc:spChg chg="mod topLvl">
          <ac:chgData name="Lamoth, CJC" userId="9fd10590-716c-41f9-b907-ea3606eab60c" providerId="ADAL" clId="{F52BD872-3120-0B40-B62B-CA12AC80F4A8}" dt="2025-02-17T10:29:35.331" v="737" actId="1076"/>
          <ac:spMkLst>
            <pc:docMk/>
            <pc:sldMk cId="1424199435" sldId="414"/>
            <ac:spMk id="204" creationId="{F9DD7584-F37E-A649-EDB4-BB14FC5E7F6E}"/>
          </ac:spMkLst>
        </pc:spChg>
        <pc:spChg chg="del mod topLvl">
          <ac:chgData name="Lamoth, CJC" userId="9fd10590-716c-41f9-b907-ea3606eab60c" providerId="ADAL" clId="{F52BD872-3120-0B40-B62B-CA12AC80F4A8}" dt="2025-02-17T10:27:10.118" v="727" actId="478"/>
          <ac:spMkLst>
            <pc:docMk/>
            <pc:sldMk cId="1424199435" sldId="414"/>
            <ac:spMk id="205" creationId="{90B56F47-2C56-4FA8-F833-24A3493334B6}"/>
          </ac:spMkLst>
        </pc:spChg>
        <pc:spChg chg="mod topLvl">
          <ac:chgData name="Lamoth, CJC" userId="9fd10590-716c-41f9-b907-ea3606eab60c" providerId="ADAL" clId="{F52BD872-3120-0B40-B62B-CA12AC80F4A8}" dt="2025-02-17T10:29:30.807" v="735" actId="1076"/>
          <ac:spMkLst>
            <pc:docMk/>
            <pc:sldMk cId="1424199435" sldId="414"/>
            <ac:spMk id="206" creationId="{3745F75C-E6A0-9A77-2C39-F571DA58A723}"/>
          </ac:spMkLst>
        </pc:spChg>
        <pc:spChg chg="add mod">
          <ac:chgData name="Lamoth, CJC" userId="9fd10590-716c-41f9-b907-ea3606eab60c" providerId="ADAL" clId="{F52BD872-3120-0B40-B62B-CA12AC80F4A8}" dt="2025-02-17T10:30:03.047" v="742" actId="1076"/>
          <ac:spMkLst>
            <pc:docMk/>
            <pc:sldMk cId="1424199435" sldId="414"/>
            <ac:spMk id="208" creationId="{C8CFA85A-CD62-346E-B522-3643E9406633}"/>
          </ac:spMkLst>
        </pc:spChg>
        <pc:spChg chg="add mod">
          <ac:chgData name="Lamoth, CJC" userId="9fd10590-716c-41f9-b907-ea3606eab60c" providerId="ADAL" clId="{F52BD872-3120-0B40-B62B-CA12AC80F4A8}" dt="2025-02-17T10:30:08.813" v="743" actId="1076"/>
          <ac:spMkLst>
            <pc:docMk/>
            <pc:sldMk cId="1424199435" sldId="414"/>
            <ac:spMk id="209" creationId="{429AFD94-1148-EE82-CD67-6D6FB92D3572}"/>
          </ac:spMkLst>
        </pc:spChg>
        <pc:spChg chg="add del mod">
          <ac:chgData name="Lamoth, CJC" userId="9fd10590-716c-41f9-b907-ea3606eab60c" providerId="ADAL" clId="{F52BD872-3120-0B40-B62B-CA12AC80F4A8}" dt="2025-02-17T10:34:20.408" v="787"/>
          <ac:spMkLst>
            <pc:docMk/>
            <pc:sldMk cId="1424199435" sldId="414"/>
            <ac:spMk id="211" creationId="{6381EA1B-32B6-8107-6475-46F201622378}"/>
          </ac:spMkLst>
        </pc:spChg>
        <pc:grpChg chg="add mod">
          <ac:chgData name="Lamoth, CJC" userId="9fd10590-716c-41f9-b907-ea3606eab60c" providerId="ADAL" clId="{F52BD872-3120-0B40-B62B-CA12AC80F4A8}" dt="2025-02-17T10:19:33.559" v="658"/>
          <ac:grpSpMkLst>
            <pc:docMk/>
            <pc:sldMk cId="1424199435" sldId="414"/>
            <ac:grpSpMk id="177" creationId="{F5341385-9A63-D9B2-C23A-D6C2BC730E2C}"/>
          </ac:grpSpMkLst>
        </pc:grpChg>
        <pc:grpChg chg="mod">
          <ac:chgData name="Lamoth, CJC" userId="9fd10590-716c-41f9-b907-ea3606eab60c" providerId="ADAL" clId="{F52BD872-3120-0B40-B62B-CA12AC80F4A8}" dt="2025-02-17T10:19:33.559" v="658"/>
          <ac:grpSpMkLst>
            <pc:docMk/>
            <pc:sldMk cId="1424199435" sldId="414"/>
            <ac:grpSpMk id="180" creationId="{28E8CA31-BDDD-DC9F-3081-8B01E0DA0E7C}"/>
          </ac:grpSpMkLst>
        </pc:grpChg>
        <pc:grpChg chg="add mod">
          <ac:chgData name="Lamoth, CJC" userId="9fd10590-716c-41f9-b907-ea3606eab60c" providerId="ADAL" clId="{F52BD872-3120-0B40-B62B-CA12AC80F4A8}" dt="2025-02-17T10:21:20.734" v="666" actId="1076"/>
          <ac:grpSpMkLst>
            <pc:docMk/>
            <pc:sldMk cId="1424199435" sldId="414"/>
            <ac:grpSpMk id="188" creationId="{66E4DFDC-BCC4-348D-33F3-0E34115AEA74}"/>
          </ac:grpSpMkLst>
        </pc:grpChg>
        <pc:grpChg chg="mod">
          <ac:chgData name="Lamoth, CJC" userId="9fd10590-716c-41f9-b907-ea3606eab60c" providerId="ADAL" clId="{F52BD872-3120-0B40-B62B-CA12AC80F4A8}" dt="2025-02-17T10:21:03.856" v="661"/>
          <ac:grpSpMkLst>
            <pc:docMk/>
            <pc:sldMk cId="1424199435" sldId="414"/>
            <ac:grpSpMk id="192" creationId="{16794945-6423-CFA9-8D92-203548DC848C}"/>
          </ac:grpSpMkLst>
        </pc:grpChg>
        <pc:grpChg chg="add del mod">
          <ac:chgData name="Lamoth, CJC" userId="9fd10590-716c-41f9-b907-ea3606eab60c" providerId="ADAL" clId="{F52BD872-3120-0B40-B62B-CA12AC80F4A8}" dt="2025-02-17T10:24:27.087" v="697" actId="165"/>
          <ac:grpSpMkLst>
            <pc:docMk/>
            <pc:sldMk cId="1424199435" sldId="414"/>
            <ac:grpSpMk id="200" creationId="{BFA8853C-F3CC-CE02-AA23-7BA5837B8FBC}"/>
          </ac:grpSpMkLst>
        </pc:grpChg>
        <pc:grpChg chg="del mod topLvl">
          <ac:chgData name="Lamoth, CJC" userId="9fd10590-716c-41f9-b907-ea3606eab60c" providerId="ADAL" clId="{F52BD872-3120-0B40-B62B-CA12AC80F4A8}" dt="2025-02-17T10:24:36.307" v="698" actId="165"/>
          <ac:grpSpMkLst>
            <pc:docMk/>
            <pc:sldMk cId="1424199435" sldId="414"/>
            <ac:grpSpMk id="202" creationId="{EA1EF2E7-F2B9-5D4F-B891-5A3943F43EFD}"/>
          </ac:grpSpMkLst>
        </pc:grpChg>
        <pc:graphicFrameChg chg="mod modGraphic">
          <ac:chgData name="Lamoth, CJC" userId="9fd10590-716c-41f9-b907-ea3606eab60c" providerId="ADAL" clId="{F52BD872-3120-0B40-B62B-CA12AC80F4A8}" dt="2025-02-17T10:39:53.299" v="806" actId="20577"/>
          <ac:graphicFrameMkLst>
            <pc:docMk/>
            <pc:sldMk cId="1424199435" sldId="414"/>
            <ac:graphicFrameMk id="2" creationId="{6C1031E6-0AB7-D31D-30C6-E86003857BDA}"/>
          </ac:graphicFrameMkLst>
        </pc:graphicFrameChg>
        <pc:picChg chg="add mod">
          <ac:chgData name="Lamoth, CJC" userId="9fd10590-716c-41f9-b907-ea3606eab60c" providerId="ADAL" clId="{F52BD872-3120-0B40-B62B-CA12AC80F4A8}" dt="2025-02-17T10:14:55.213" v="624" actId="1036"/>
          <ac:picMkLst>
            <pc:docMk/>
            <pc:sldMk cId="1424199435" sldId="414"/>
            <ac:picMk id="164" creationId="{0752D229-2D3E-6298-0E26-735F523D38E0}"/>
          </ac:picMkLst>
        </pc:picChg>
        <pc:picChg chg="add mod">
          <ac:chgData name="Lamoth, CJC" userId="9fd10590-716c-41f9-b907-ea3606eab60c" providerId="ADAL" clId="{F52BD872-3120-0B40-B62B-CA12AC80F4A8}" dt="2025-02-17T10:14:55.213" v="624" actId="1036"/>
          <ac:picMkLst>
            <pc:docMk/>
            <pc:sldMk cId="1424199435" sldId="414"/>
            <ac:picMk id="165" creationId="{9674811B-B49E-84C4-C461-F24BF8FB27E3}"/>
          </ac:picMkLst>
        </pc:picChg>
        <pc:picChg chg="add mod">
          <ac:chgData name="Lamoth, CJC" userId="9fd10590-716c-41f9-b907-ea3606eab60c" providerId="ADAL" clId="{F52BD872-3120-0B40-B62B-CA12AC80F4A8}" dt="2025-02-17T10:14:55.213" v="624" actId="1036"/>
          <ac:picMkLst>
            <pc:docMk/>
            <pc:sldMk cId="1424199435" sldId="414"/>
            <ac:picMk id="166" creationId="{9D04FC18-D972-1457-48F1-3AD4558E7D14}"/>
          </ac:picMkLst>
        </pc:picChg>
        <pc:picChg chg="add mod">
          <ac:chgData name="Lamoth, CJC" userId="9fd10590-716c-41f9-b907-ea3606eab60c" providerId="ADAL" clId="{F52BD872-3120-0B40-B62B-CA12AC80F4A8}" dt="2025-02-17T10:14:55.213" v="624" actId="1036"/>
          <ac:picMkLst>
            <pc:docMk/>
            <pc:sldMk cId="1424199435" sldId="414"/>
            <ac:picMk id="167" creationId="{DDF5E858-EA5B-E411-E4F5-E7FE835F21BD}"/>
          </ac:picMkLst>
        </pc:picChg>
        <pc:picChg chg="add mod">
          <ac:chgData name="Lamoth, CJC" userId="9fd10590-716c-41f9-b907-ea3606eab60c" providerId="ADAL" clId="{F52BD872-3120-0B40-B62B-CA12AC80F4A8}" dt="2025-02-17T10:14:29.751" v="620" actId="555"/>
          <ac:picMkLst>
            <pc:docMk/>
            <pc:sldMk cId="1424199435" sldId="414"/>
            <ac:picMk id="168" creationId="{47917532-19C0-8855-7B8B-0294724E9F6D}"/>
          </ac:picMkLst>
        </pc:picChg>
        <pc:picChg chg="add mod">
          <ac:chgData name="Lamoth, CJC" userId="9fd10590-716c-41f9-b907-ea3606eab60c" providerId="ADAL" clId="{F52BD872-3120-0B40-B62B-CA12AC80F4A8}" dt="2025-02-17T10:14:29.751" v="620" actId="555"/>
          <ac:picMkLst>
            <pc:docMk/>
            <pc:sldMk cId="1424199435" sldId="414"/>
            <ac:picMk id="169" creationId="{7DBE119D-607A-7EF1-7BDD-9EE5450CC9B5}"/>
          </ac:picMkLst>
        </pc:picChg>
        <pc:picChg chg="add mod">
          <ac:chgData name="Lamoth, CJC" userId="9fd10590-716c-41f9-b907-ea3606eab60c" providerId="ADAL" clId="{F52BD872-3120-0B40-B62B-CA12AC80F4A8}" dt="2025-02-17T10:14:29.751" v="620" actId="555"/>
          <ac:picMkLst>
            <pc:docMk/>
            <pc:sldMk cId="1424199435" sldId="414"/>
            <ac:picMk id="170" creationId="{50997382-A25D-A9C0-A6E4-9118AA3AF2EF}"/>
          </ac:picMkLst>
        </pc:picChg>
        <pc:picChg chg="add mod">
          <ac:chgData name="Lamoth, CJC" userId="9fd10590-716c-41f9-b907-ea3606eab60c" providerId="ADAL" clId="{F52BD872-3120-0B40-B62B-CA12AC80F4A8}" dt="2025-02-17T10:13:44.186" v="616" actId="555"/>
          <ac:picMkLst>
            <pc:docMk/>
            <pc:sldMk cId="1424199435" sldId="414"/>
            <ac:picMk id="171" creationId="{6F6BA17D-4F53-8C4F-6863-120AD469E03A}"/>
          </ac:picMkLst>
        </pc:picChg>
        <pc:picChg chg="add mod">
          <ac:chgData name="Lamoth, CJC" userId="9fd10590-716c-41f9-b907-ea3606eab60c" providerId="ADAL" clId="{F52BD872-3120-0B40-B62B-CA12AC80F4A8}" dt="2025-02-17T10:14:29.751" v="620" actId="555"/>
          <ac:picMkLst>
            <pc:docMk/>
            <pc:sldMk cId="1424199435" sldId="414"/>
            <ac:picMk id="172" creationId="{CF9E8AAD-3EF9-66F8-88E1-51C56A52A626}"/>
          </ac:picMkLst>
        </pc:picChg>
        <pc:picChg chg="add mod">
          <ac:chgData name="Lamoth, CJC" userId="9fd10590-716c-41f9-b907-ea3606eab60c" providerId="ADAL" clId="{F52BD872-3120-0B40-B62B-CA12AC80F4A8}" dt="2025-02-17T10:14:29.751" v="620" actId="555"/>
          <ac:picMkLst>
            <pc:docMk/>
            <pc:sldMk cId="1424199435" sldId="414"/>
            <ac:picMk id="173" creationId="{ED9D2E27-806A-A888-1104-207ED058DA16}"/>
          </ac:picMkLst>
        </pc:picChg>
        <pc:picChg chg="add mod">
          <ac:chgData name="Lamoth, CJC" userId="9fd10590-716c-41f9-b907-ea3606eab60c" providerId="ADAL" clId="{F52BD872-3120-0B40-B62B-CA12AC80F4A8}" dt="2025-02-17T10:14:29.751" v="620" actId="555"/>
          <ac:picMkLst>
            <pc:docMk/>
            <pc:sldMk cId="1424199435" sldId="414"/>
            <ac:picMk id="174" creationId="{C5F923C3-A8E2-609E-7D11-CDC1FB424BCC}"/>
          </ac:picMkLst>
        </pc:picChg>
        <pc:picChg chg="add mod">
          <ac:chgData name="Lamoth, CJC" userId="9fd10590-716c-41f9-b907-ea3606eab60c" providerId="ADAL" clId="{F52BD872-3120-0B40-B62B-CA12AC80F4A8}" dt="2025-02-17T10:14:29.751" v="620" actId="555"/>
          <ac:picMkLst>
            <pc:docMk/>
            <pc:sldMk cId="1424199435" sldId="414"/>
            <ac:picMk id="175" creationId="{48A82370-555B-8FCA-E903-B66AFF4E807F}"/>
          </ac:picMkLst>
        </pc:picChg>
        <pc:picChg chg="mod">
          <ac:chgData name="Lamoth, CJC" userId="9fd10590-716c-41f9-b907-ea3606eab60c" providerId="ADAL" clId="{F52BD872-3120-0B40-B62B-CA12AC80F4A8}" dt="2025-02-17T10:19:33.559" v="658"/>
          <ac:picMkLst>
            <pc:docMk/>
            <pc:sldMk cId="1424199435" sldId="414"/>
            <ac:picMk id="187" creationId="{4F9C40FD-6F7A-53AD-5BB7-10832CAE3001}"/>
          </ac:picMkLst>
        </pc:picChg>
        <pc:picChg chg="mod">
          <ac:chgData name="Lamoth, CJC" userId="9fd10590-716c-41f9-b907-ea3606eab60c" providerId="ADAL" clId="{F52BD872-3120-0B40-B62B-CA12AC80F4A8}" dt="2025-02-17T10:21:03.856" v="661"/>
          <ac:picMkLst>
            <pc:docMk/>
            <pc:sldMk cId="1424199435" sldId="414"/>
            <ac:picMk id="199" creationId="{89D71D22-FEFC-DDD6-9761-8F65EFB6B3CE}"/>
          </ac:picMkLst>
        </pc:picChg>
        <pc:picChg chg="mod topLvl">
          <ac:chgData name="Lamoth, CJC" userId="9fd10590-716c-41f9-b907-ea3606eab60c" providerId="ADAL" clId="{F52BD872-3120-0B40-B62B-CA12AC80F4A8}" dt="2025-02-17T10:29:28.831" v="734" actId="1076"/>
          <ac:picMkLst>
            <pc:docMk/>
            <pc:sldMk cId="1424199435" sldId="414"/>
            <ac:picMk id="207" creationId="{FB67E6B1-CAD1-271B-FB00-1415A10D2E35}"/>
          </ac:picMkLst>
        </pc:picChg>
      </pc:sldChg>
    </pc:docChg>
  </pc:docChgLst>
  <pc:docChgLst>
    <pc:chgData name="Zhang, X (bw)" userId="8c11a9ad-4ec2-408f-b77f-edf277d143b8" providerId="ADAL" clId="{F9D158F7-A57F-45C3-B9D5-554D24C9C5AC}"/>
    <pc:docChg chg="modSld">
      <pc:chgData name="Zhang, X (bw)" userId="8c11a9ad-4ec2-408f-b77f-edf277d143b8" providerId="ADAL" clId="{F9D158F7-A57F-45C3-B9D5-554D24C9C5AC}" dt="2025-02-18T11:32:26.132" v="4" actId="20577"/>
      <pc:docMkLst>
        <pc:docMk/>
      </pc:docMkLst>
      <pc:sldChg chg="modSp mod">
        <pc:chgData name="Zhang, X (bw)" userId="8c11a9ad-4ec2-408f-b77f-edf277d143b8" providerId="ADAL" clId="{F9D158F7-A57F-45C3-B9D5-554D24C9C5AC}" dt="2025-02-18T11:32:26.132" v="4" actId="20577"/>
        <pc:sldMkLst>
          <pc:docMk/>
          <pc:sldMk cId="3117842035" sldId="410"/>
        </pc:sldMkLst>
        <pc:spChg chg="mod">
          <ac:chgData name="Zhang, X (bw)" userId="8c11a9ad-4ec2-408f-b77f-edf277d143b8" providerId="ADAL" clId="{F9D158F7-A57F-45C3-B9D5-554D24C9C5AC}" dt="2025-02-18T11:32:26.132" v="4" actId="20577"/>
          <ac:spMkLst>
            <pc:docMk/>
            <pc:sldMk cId="3117842035" sldId="410"/>
            <ac:spMk id="217" creationId="{700C5413-2AC7-57A7-B9B8-3E86A811E356}"/>
          </ac:spMkLst>
        </pc:spChg>
      </pc:sldChg>
    </pc:docChg>
  </pc:docChgLst>
</pc:chgInfo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B84EA-7D68-4D60-9CB1-D50884785D1C}" type="datetimeFigureOut">
              <a:rPr lang="zh-CN" altLang="en-US" smtClean="0"/>
              <a:t>2025/2/1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4E0FC9-F1F8-4FAE-9988-3BA365CFD4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  <a:t>2025/2/1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6837353-30EB-4A48-80EB-173D804AEFBD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338637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2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2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2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2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2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2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2/1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2/1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2/1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2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2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5/2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460D423-DD55-0DD2-D901-BD6493893C7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>
            <a:extLst>
              <a:ext uri="{FF2B5EF4-FFF2-40B4-BE49-F238E27FC236}">
                <a16:creationId xmlns:a16="http://schemas.microsoft.com/office/drawing/2014/main" id="{BD33405B-5AB3-B867-2430-8EAA88371589}"/>
              </a:ext>
            </a:extLst>
          </p:cNvPr>
          <p:cNvGrpSpPr/>
          <p:nvPr/>
        </p:nvGrpSpPr>
        <p:grpSpPr>
          <a:xfrm>
            <a:off x="473338" y="471885"/>
            <a:ext cx="5770726" cy="7481914"/>
            <a:chOff x="473338" y="471885"/>
            <a:chExt cx="5770726" cy="7481914"/>
          </a:xfrm>
        </p:grpSpPr>
        <p:graphicFrame>
          <p:nvGraphicFramePr>
            <p:cNvPr id="10" name="表格 9">
              <a:extLst>
                <a:ext uri="{FF2B5EF4-FFF2-40B4-BE49-F238E27FC236}">
                  <a16:creationId xmlns:a16="http://schemas.microsoft.com/office/drawing/2014/main" id="{FDC38EC0-5D6B-B183-AE2E-E3D09F8FB677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2903383942"/>
                </p:ext>
              </p:extLst>
            </p:nvPr>
          </p:nvGraphicFramePr>
          <p:xfrm>
            <a:off x="671052" y="2396188"/>
            <a:ext cx="4928012" cy="3927122"/>
          </p:xfrm>
          <a:graphic>
            <a:graphicData uri="http://schemas.openxmlformats.org/drawingml/2006/table">
              <a:tbl>
                <a:tblPr>
                  <a:tableStyleId>{9D7B26C5-4107-4FEC-AEDC-1716B250A1EF}</a:tableStyleId>
                </a:tblPr>
                <a:tblGrid>
                  <a:gridCol w="420329">
                    <a:extLst>
                      <a:ext uri="{9D8B030D-6E8A-4147-A177-3AD203B41FA5}">
                        <a16:colId xmlns:a16="http://schemas.microsoft.com/office/drawing/2014/main" val="1053796065"/>
                      </a:ext>
                    </a:extLst>
                  </a:gridCol>
                  <a:gridCol w="2304483">
                    <a:extLst>
                      <a:ext uri="{9D8B030D-6E8A-4147-A177-3AD203B41FA5}">
                        <a16:colId xmlns:a16="http://schemas.microsoft.com/office/drawing/2014/main" val="20000"/>
                      </a:ext>
                    </a:extLst>
                  </a:gridCol>
                  <a:gridCol w="244800">
                    <a:extLst>
                      <a:ext uri="{9D8B030D-6E8A-4147-A177-3AD203B41FA5}">
                        <a16:colId xmlns:a16="http://schemas.microsoft.com/office/drawing/2014/main" val="4238136766"/>
                      </a:ext>
                    </a:extLst>
                  </a:gridCol>
                  <a:gridCol w="244800">
                    <a:extLst>
                      <a:ext uri="{9D8B030D-6E8A-4147-A177-3AD203B41FA5}">
                        <a16:colId xmlns:a16="http://schemas.microsoft.com/office/drawing/2014/main" val="1301611186"/>
                      </a:ext>
                    </a:extLst>
                  </a:gridCol>
                  <a:gridCol w="244800">
                    <a:extLst>
                      <a:ext uri="{9D8B030D-6E8A-4147-A177-3AD203B41FA5}">
                        <a16:colId xmlns:a16="http://schemas.microsoft.com/office/drawing/2014/main" val="1950059856"/>
                      </a:ext>
                    </a:extLst>
                  </a:gridCol>
                  <a:gridCol w="244800">
                    <a:extLst>
                      <a:ext uri="{9D8B030D-6E8A-4147-A177-3AD203B41FA5}">
                        <a16:colId xmlns:a16="http://schemas.microsoft.com/office/drawing/2014/main" val="20004"/>
                      </a:ext>
                    </a:extLst>
                  </a:gridCol>
                  <a:gridCol w="244800">
                    <a:extLst>
                      <a:ext uri="{9D8B030D-6E8A-4147-A177-3AD203B41FA5}">
                        <a16:colId xmlns:a16="http://schemas.microsoft.com/office/drawing/2014/main" val="20005"/>
                      </a:ext>
                    </a:extLst>
                  </a:gridCol>
                  <a:gridCol w="244800">
                    <a:extLst>
                      <a:ext uri="{9D8B030D-6E8A-4147-A177-3AD203B41FA5}">
                        <a16:colId xmlns:a16="http://schemas.microsoft.com/office/drawing/2014/main" val="20006"/>
                      </a:ext>
                    </a:extLst>
                  </a:gridCol>
                  <a:gridCol w="244800">
                    <a:extLst>
                      <a:ext uri="{9D8B030D-6E8A-4147-A177-3AD203B41FA5}">
                        <a16:colId xmlns:a16="http://schemas.microsoft.com/office/drawing/2014/main" val="20007"/>
                      </a:ext>
                    </a:extLst>
                  </a:gridCol>
                  <a:gridCol w="244800">
                    <a:extLst>
                      <a:ext uri="{9D8B030D-6E8A-4147-A177-3AD203B41FA5}">
                        <a16:colId xmlns:a16="http://schemas.microsoft.com/office/drawing/2014/main" val="20008"/>
                      </a:ext>
                    </a:extLst>
                  </a:gridCol>
                  <a:gridCol w="244800">
                    <a:extLst>
                      <a:ext uri="{9D8B030D-6E8A-4147-A177-3AD203B41FA5}">
                        <a16:colId xmlns:a16="http://schemas.microsoft.com/office/drawing/2014/main" val="20009"/>
                      </a:ext>
                    </a:extLst>
                  </a:gridCol>
                </a:tblGrid>
                <a:tr h="244800">
                  <a:tc gridSpan="2">
                    <a:txBody>
                      <a:bodyPr/>
                      <a:lstStyle/>
                      <a:p>
                        <a:pPr algn="ctr">
                          <a:buNone/>
                        </a:pPr>
                        <a:r>
                          <a:rPr lang="en-US" altLang="zh-CN" sz="1000" b="1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Parameters</a:t>
                        </a:r>
                      </a:p>
                    </a:txBody>
                    <a:tcPr marL="63340" marR="63340" marT="31668" marB="31668" anchor="ctr">
                      <a:lnL>
                        <a:noFill/>
                      </a:lnL>
                      <a:lnR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190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  <a:lnTlToBr>
                        <a:noFill/>
                      </a:lnTlToBr>
                      <a:lnBlToTr>
                        <a:noFill/>
                      </a:lnBlToTr>
                    </a:tcPr>
                  </a:tc>
                  <a:tc hMerge="1">
                    <a:txBody>
                      <a:bodyPr/>
                      <a:lstStyle/>
                      <a:p>
                        <a:endParaRPr/>
                      </a:p>
                    </a:txBody>
                    <a:tcPr marL="63340" marR="63340" marT="31668" marB="31668" anchor="ctr">
                      <a:lnL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190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  <a:lnTlToBr>
                        <a:noFill/>
                      </a:lnTlToBr>
                      <a:lnBlToTr>
                        <a:noFill/>
                      </a:lnBlToTr>
                    </a:tcPr>
                  </a:tc>
                  <a:tc gridSpan="3">
                    <a:txBody>
                      <a:bodyPr/>
                      <a:lstStyle/>
                      <a:p>
                        <a:pPr algn="ctr">
                          <a:buNone/>
                        </a:pPr>
                        <a:r>
                          <a:rPr lang="en-US" altLang="zh-CN" sz="1000" b="1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NF vs F</a:t>
                        </a:r>
                      </a:p>
                    </a:txBody>
                    <a:tcPr marL="63340" marR="63340" marT="31668" marB="31668" anchor="ctr">
                      <a:lnL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190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  <a:lnTlToBr>
                        <a:noFill/>
                      </a:lnTlToBr>
                      <a:lnBlToTr>
                        <a:noFill/>
                      </a:lnBlToTr>
                    </a:tcPr>
                  </a:tc>
                  <a:tc hMerge="1"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en-US" altLang="zh-CN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12700">
                        <a:solidFill>
                          <a:schemeClr val="tx1"/>
                        </a:solidFill>
                        <a:prstDash val="solid"/>
                      </a:lnT>
                      <a:lnB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  <a:lnTlToBr>
                        <a:noFill/>
                      </a:lnTlToBr>
                      <a:lnBlToTr>
                        <a:noFill/>
                      </a:lnBlToTr>
                    </a:tcPr>
                  </a:tc>
                  <a:tc hMerge="1"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en-US" altLang="zh-CN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12700">
                        <a:solidFill>
                          <a:schemeClr val="tx1"/>
                        </a:solidFill>
                        <a:prstDash val="solid"/>
                      </a:lnT>
                      <a:lnB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  <a:lnTlToBr>
                        <a:noFill/>
                      </a:lnTlToBr>
                      <a:lnBlToTr>
                        <a:noFill/>
                      </a:lnBlToTr>
                    </a:tcPr>
                  </a:tc>
                  <a:tc gridSpan="3">
                    <a:txBody>
                      <a:bodyPr/>
                      <a:lstStyle/>
                      <a:p>
                        <a:pPr algn="ctr">
                          <a:buNone/>
                        </a:pPr>
                        <a:r>
                          <a:rPr lang="en-US" altLang="zh-CN" sz="1000" b="1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NF vs PF</a:t>
                        </a: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190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  <a:lnTlToBr>
                        <a:noFill/>
                      </a:lnTlToBr>
                      <a:lnBlToTr>
                        <a:noFill/>
                      </a:lnBlToTr>
                    </a:tcPr>
                  </a:tc>
                  <a:tc hMerge="1">
                    <a:txBody>
                      <a:bodyPr/>
                      <a:lstStyle/>
                      <a:p>
                        <a:endParaRPr lang="en-US"/>
                      </a:p>
                    </a:txBody>
                    <a:tcPr anchor="ctr">
                      <a:lnT w="12700">
                        <a:solidFill>
                          <a:schemeClr val="tx1"/>
                        </a:solidFill>
                        <a:prstDash val="solid"/>
                      </a:lnT>
                      <a:lnB w="12700">
                        <a:solidFill>
                          <a:schemeClr val="tx1"/>
                        </a:solidFill>
                        <a:prstDash val="solid"/>
                      </a:lnB>
                    </a:tcPr>
                  </a:tc>
                  <a:tc hMerge="1">
                    <a:txBody>
                      <a:bodyPr/>
                      <a:lstStyle/>
                      <a:p>
                        <a:endParaRPr lang="en-US"/>
                      </a:p>
                    </a:txBody>
                    <a:tcPr anchor="ctr">
                      <a:lnR w="12700">
                        <a:solidFill>
                          <a:schemeClr val="tx1"/>
                        </a:solidFill>
                        <a:prstDash val="solid"/>
                      </a:lnR>
                      <a:lnT w="12700">
                        <a:solidFill>
                          <a:schemeClr val="tx1"/>
                        </a:solidFill>
                        <a:prstDash val="solid"/>
                      </a:lnT>
                      <a:lnB w="12700">
                        <a:solidFill>
                          <a:schemeClr val="tx1"/>
                        </a:solidFill>
                        <a:prstDash val="solid"/>
                      </a:lnB>
                    </a:tcPr>
                  </a:tc>
                  <a:tc gridSpan="3">
                    <a:txBody>
                      <a:bodyPr/>
                      <a:lstStyle/>
                      <a:p>
                        <a:pPr algn="ctr">
                          <a:buNone/>
                        </a:pPr>
                        <a:r>
                          <a:rPr lang="en-US" altLang="zh-CN" sz="1000" b="1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PF vs F</a:t>
                        </a: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>
                        <a:noFill/>
                      </a:lnR>
                      <a:lnT w="190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  <a:lnTlToBr>
                        <a:noFill/>
                      </a:lnTlToBr>
                      <a:lnBlToTr>
                        <a:noFill/>
                      </a:lnBlToTr>
                    </a:tcPr>
                  </a:tc>
                  <a:tc hMerge="1">
                    <a:txBody>
                      <a:bodyPr/>
                      <a:lstStyle/>
                      <a:p>
                        <a:endParaRPr lang="en-US"/>
                      </a:p>
                    </a:txBody>
                    <a:tcPr anchor="ctr">
                      <a:lnT w="12700">
                        <a:solidFill>
                          <a:schemeClr val="tx1"/>
                        </a:solidFill>
                        <a:prstDash val="solid"/>
                      </a:lnT>
                      <a:lnB w="12700">
                        <a:solidFill>
                          <a:schemeClr val="tx1"/>
                        </a:solidFill>
                        <a:prstDash val="solid"/>
                      </a:lnB>
                    </a:tcPr>
                  </a:tc>
                  <a:tc hMerge="1">
                    <a:txBody>
                      <a:bodyPr/>
                      <a:lstStyle/>
                      <a:p>
                        <a:endParaRPr lang="en-US"/>
                      </a:p>
                    </a:txBody>
                    <a:tcPr anchor="ctr">
                      <a:lnR>
                        <a:noFill/>
                      </a:lnR>
                      <a:lnT w="12700">
                        <a:solidFill>
                          <a:schemeClr val="tx1"/>
                        </a:solidFill>
                        <a:prstDash val="solid"/>
                      </a:lnT>
                      <a:lnB w="12700">
                        <a:solidFill>
                          <a:schemeClr val="tx1"/>
                        </a:solidFill>
                        <a:prstDash val="solid"/>
                      </a:lnB>
                    </a:tcPr>
                  </a:tc>
                  <a:extLst>
                    <a:ext uri="{0D108BD9-81ED-4DB2-BD59-A6C34878D82A}">
                      <a16:rowId xmlns:a16="http://schemas.microsoft.com/office/drawing/2014/main" val="10000"/>
                    </a:ext>
                  </a:extLst>
                </a:tr>
                <a:tr h="244800">
                  <a:tc rowSpan="7">
                    <a:txBody>
                      <a:bodyPr/>
                      <a:lstStyle/>
                      <a:p>
                        <a:pPr algn="ctr">
                          <a:buNone/>
                        </a:pPr>
                        <a:r>
                          <a:rPr lang="en-US" altLang="zh-CN" sz="1000" b="1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Gait Parameters</a:t>
                        </a:r>
                      </a:p>
                    </a:txBody>
                    <a:tcPr marL="63340" marR="63340" marT="31668" marB="31668" vert="eaVert" anchor="ctr">
                      <a:lnL>
                        <a:noFill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r">
                          <a:buNone/>
                        </a:pPr>
                        <a:r>
                          <a:rPr lang="en-US" sz="1000" b="0" i="0" u="none" strike="noStrike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charset="0"/>
                            <a:ea typeface="宋体" panose="02010600030101010101" pitchFamily="2" charset="-122"/>
                          </a:rPr>
                          <a:t>Gait speed(m/s)</a:t>
                        </a:r>
                        <a:endParaRPr lang="en-US" altLang="zh-CN" sz="10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en-US" altLang="zh-CN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>
                        <a:noFill/>
                      </a:lnR>
                      <a:lnT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extLst>
                    <a:ext uri="{0D108BD9-81ED-4DB2-BD59-A6C34878D82A}">
                      <a16:rowId xmlns:a16="http://schemas.microsoft.com/office/drawing/2014/main" val="10002"/>
                    </a:ext>
                  </a:extLst>
                </a:tr>
                <a:tr h="244800">
                  <a:tc vMerge="1"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en-US" altLang="zh-CN" sz="10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>
                        <a:noFill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marL="0" marR="0" lvl="0" indent="0" algn="r" defTabSz="685800" rtl="0" eaLnBrk="1" fontAlgn="ctr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lang="en-US" altLang="zh-CN" sz="1000" b="0" i="0" u="none" strike="noStrike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charset="0"/>
                            <a:ea typeface="宋体" panose="02010600030101010101" pitchFamily="2" charset="-122"/>
                          </a:rPr>
                          <a:t>Gait cadence (steps/min)</a:t>
                        </a: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en-US" altLang="zh-CN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>
                        <a:noFill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extLst>
                    <a:ext uri="{0D108BD9-81ED-4DB2-BD59-A6C34878D82A}">
                      <a16:rowId xmlns:a16="http://schemas.microsoft.com/office/drawing/2014/main" val="10003"/>
                    </a:ext>
                  </a:extLst>
                </a:tr>
                <a:tr h="244800">
                  <a:tc vMerge="1"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en-US" altLang="zh-CN" sz="10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>
                        <a:noFill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r" fontAlgn="ctr">
                          <a:lnSpc>
                            <a:spcPct val="100000"/>
                          </a:lnSpc>
                        </a:pPr>
                        <a:r>
                          <a:rPr lang="en-US" sz="1000" b="0" i="0" u="none" strike="noStrike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charset="0"/>
                            <a:ea typeface="宋体" panose="02010600030101010101" pitchFamily="2" charset="-122"/>
                          </a:rPr>
                          <a:t>Stride/Step time (sec)</a:t>
                        </a: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en-US" altLang="zh-CN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en-US" altLang="zh-CN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>
                        <a:noFill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extLst>
                    <a:ext uri="{0D108BD9-81ED-4DB2-BD59-A6C34878D82A}">
                      <a16:rowId xmlns:a16="http://schemas.microsoft.com/office/drawing/2014/main" val="10004"/>
                    </a:ext>
                  </a:extLst>
                </a:tr>
                <a:tr h="250874">
                  <a:tc vMerge="1"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en-US" altLang="zh-CN" sz="10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>
                        <a:noFill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r">
                          <a:buNone/>
                        </a:pPr>
                        <a:r>
                          <a:rPr lang="en-US" altLang="zh-CN" sz="1000" b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Gait periodicity</a:t>
                        </a: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en-US" altLang="zh-CN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en-US" altLang="zh-CN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en-US" altLang="zh-CN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en-US" altLang="zh-CN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en-US" altLang="zh-CN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>
                        <a:noFill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extLst>
                    <a:ext uri="{0D108BD9-81ED-4DB2-BD59-A6C34878D82A}">
                      <a16:rowId xmlns:a16="http://schemas.microsoft.com/office/drawing/2014/main" val="10005"/>
                    </a:ext>
                  </a:extLst>
                </a:tr>
                <a:tr h="244800">
                  <a:tc vMerge="1"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en-US" altLang="zh-CN" sz="10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>
                        <a:noFill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indent="0" algn="r" fontAlgn="ctr">
                          <a:lnSpc>
                            <a:spcPct val="120000"/>
                          </a:lnSpc>
                        </a:pPr>
                        <a:r>
                          <a:rPr lang="en-US" sz="1000" b="0" i="0" u="none" strike="noStrike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charset="0"/>
                            <a:ea typeface="宋体" panose="02010600030101010101" pitchFamily="2" charset="-122"/>
                          </a:rPr>
                          <a:t>Range of magnitude </a:t>
                        </a:r>
                        <a:r>
                          <a:rPr lang="el-GR" sz="1000" b="0" i="0" u="none" strike="noStrike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charset="0"/>
                            <a:ea typeface="宋体" panose="02010600030101010101" pitchFamily="2" charset="-122"/>
                          </a:rPr>
                          <a:t>Δ</a:t>
                        </a:r>
                        <a:r>
                          <a:rPr lang="en-US" sz="1000" b="0" i="0" u="none" strike="noStrike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charset="0"/>
                            <a:ea typeface="宋体" panose="02010600030101010101" pitchFamily="2" charset="-122"/>
                          </a:rPr>
                          <a:t>a-AP/VT/ML</a:t>
                        </a: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en-US" altLang="zh-CN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en-US" altLang="zh-CN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en-US" altLang="zh-CN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en-US" altLang="zh-CN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en-US" altLang="zh-CN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>
                        <a:noFill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extLst>
                    <a:ext uri="{0D108BD9-81ED-4DB2-BD59-A6C34878D82A}">
                      <a16:rowId xmlns:a16="http://schemas.microsoft.com/office/drawing/2014/main" val="10006"/>
                    </a:ext>
                  </a:extLst>
                </a:tr>
                <a:tr h="244800">
                  <a:tc vMerge="1"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en-US" altLang="zh-CN" sz="10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>
                        <a:noFill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indent="0" algn="r" fontAlgn="ctr">
                          <a:lnSpc>
                            <a:spcPct val="120000"/>
                          </a:lnSpc>
                        </a:pPr>
                        <a:r>
                          <a:rPr lang="en-US" sz="1000" b="0" i="0" u="none" strike="noStrike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charset="0"/>
                            <a:ea typeface="宋体" panose="02010600030101010101" pitchFamily="2" charset="-122"/>
                          </a:rPr>
                          <a:t>Gait variability-step/stride time</a:t>
                        </a: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en-US" altLang="zh-CN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en-US" altLang="zh-CN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en-US" altLang="zh-CN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en-US" altLang="zh-CN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en-US" altLang="zh-CN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>
                        <a:noFill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extLst>
                    <a:ext uri="{0D108BD9-81ED-4DB2-BD59-A6C34878D82A}">
                      <a16:rowId xmlns:a16="http://schemas.microsoft.com/office/drawing/2014/main" val="10007"/>
                    </a:ext>
                  </a:extLst>
                </a:tr>
                <a:tr h="244800">
                  <a:tc vMerge="1"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en-US" altLang="zh-CN" sz="10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>
                        <a:noFill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indent="0" algn="r" fontAlgn="ctr">
                          <a:lnSpc>
                            <a:spcPct val="120000"/>
                          </a:lnSpc>
                          <a:buNone/>
                        </a:pPr>
                        <a:r>
                          <a:rPr lang="en-US" altLang="en-US" sz="1000" b="0" i="0" u="none" strike="noStrike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charset="0"/>
                            <a:ea typeface="宋体" panose="02010600030101010101" pitchFamily="2" charset="-122"/>
                          </a:rPr>
                          <a:t>PSD slope (W)</a:t>
                        </a: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en-US" altLang="zh-CN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>
                        <a:noFill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extLst>
                    <a:ext uri="{0D108BD9-81ED-4DB2-BD59-A6C34878D82A}">
                      <a16:rowId xmlns:a16="http://schemas.microsoft.com/office/drawing/2014/main" val="10008"/>
                    </a:ext>
                  </a:extLst>
                </a:tr>
                <a:tr h="244800">
                  <a:tc rowSpan="8">
                    <a:txBody>
                      <a:bodyPr/>
                      <a:lstStyle/>
                      <a:p>
                        <a:pPr algn="ctr">
                          <a:buNone/>
                        </a:pPr>
                        <a:r>
                          <a:rPr lang="en-US" altLang="zh-CN" sz="1000" b="1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DPA Parameters (24h)</a:t>
                        </a:r>
                      </a:p>
                    </a:txBody>
                    <a:tcPr marL="63340" marR="63340" marT="31668" marB="31668" vert="eaVert" anchor="ctr">
                      <a:lnL>
                        <a:noFill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12700">
                        <a:solidFill>
                          <a:schemeClr val="tx1"/>
                        </a:solidFill>
                        <a:prstDash val="solid"/>
                      </a:lnB>
                    </a:tcPr>
                  </a:tc>
                  <a:tc>
                    <a:txBody>
                      <a:bodyPr/>
                      <a:lstStyle/>
                      <a:p>
                        <a:pPr indent="0" algn="r" fontAlgn="ctr">
                          <a:lnSpc>
                            <a:spcPct val="100000"/>
                          </a:lnSpc>
                          <a:buNone/>
                        </a:pPr>
                        <a:r>
                          <a:rPr lang="en-US" altLang="zh-CN" sz="1000" b="0" i="0" u="none" strike="noStrike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charset="0"/>
                            <a:ea typeface="宋体" panose="02010600030101010101" pitchFamily="2" charset="-122"/>
                          </a:rPr>
                          <a:t>Duration/% of lying</a:t>
                        </a: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en-US" altLang="zh-CN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>
                        <a:noFill/>
                      </a:lnR>
                      <a:lnT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extLst>
                    <a:ext uri="{0D108BD9-81ED-4DB2-BD59-A6C34878D82A}">
                      <a16:rowId xmlns:a16="http://schemas.microsoft.com/office/drawing/2014/main" val="535553260"/>
                    </a:ext>
                  </a:extLst>
                </a:tr>
                <a:tr h="244800">
                  <a:tc vMerge="1"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en-US" altLang="zh-CN" sz="10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>
                        <a:noFill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indent="0" algn="r" fontAlgn="ctr">
                          <a:lnSpc>
                            <a:spcPct val="100000"/>
                          </a:lnSpc>
                          <a:buNone/>
                        </a:pPr>
                        <a:r>
                          <a:rPr lang="en-US" altLang="zh-CN" sz="1000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charset="0"/>
                            <a:ea typeface="宋体" panose="02010600030101010101" pitchFamily="2" charset="-122"/>
                            <a:sym typeface="+mn-ea"/>
                          </a:rPr>
                          <a:t>Duration of Postural Transition-</a:t>
                        </a:r>
                        <a:r>
                          <a:rPr lang="en-US" altLang="zh-CN" sz="1000" err="1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charset="0"/>
                            <a:ea typeface="宋体" panose="02010600030101010101" pitchFamily="2" charset="-122"/>
                            <a:sym typeface="+mn-ea"/>
                          </a:rPr>
                          <a:t>SiSt</a:t>
                        </a:r>
                        <a:r>
                          <a:rPr lang="en-US" altLang="zh-CN" sz="1000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charset="0"/>
                            <a:ea typeface="宋体" panose="02010600030101010101" pitchFamily="2" charset="-122"/>
                            <a:sym typeface="+mn-ea"/>
                          </a:rPr>
                          <a:t>/</a:t>
                        </a:r>
                        <a:r>
                          <a:rPr lang="en-US" altLang="zh-CN" sz="1000" err="1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charset="0"/>
                            <a:ea typeface="宋体" panose="02010600030101010101" pitchFamily="2" charset="-122"/>
                            <a:sym typeface="+mn-ea"/>
                          </a:rPr>
                          <a:t>StSi</a:t>
                        </a:r>
                        <a:r>
                          <a:rPr lang="en-US" altLang="zh-CN" sz="1000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charset="0"/>
                            <a:ea typeface="宋体" panose="02010600030101010101" pitchFamily="2" charset="-122"/>
                            <a:sym typeface="+mn-ea"/>
                          </a:rPr>
                          <a:t> </a:t>
                        </a:r>
                        <a:endPara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宋体" panose="02010600030101010101" pitchFamily="2" charset="-122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en-US" altLang="zh-CN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>
                        <a:noFill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extLst>
                    <a:ext uri="{0D108BD9-81ED-4DB2-BD59-A6C34878D82A}">
                      <a16:rowId xmlns:a16="http://schemas.microsoft.com/office/drawing/2014/main" val="3774635248"/>
                    </a:ext>
                  </a:extLst>
                </a:tr>
                <a:tr h="244800">
                  <a:tc vMerge="1"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en-US" altLang="zh-CN" sz="10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>
                        <a:noFill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indent="0" algn="r" fontAlgn="ctr">
                          <a:lnSpc>
                            <a:spcPct val="100000"/>
                          </a:lnSpc>
                          <a:buNone/>
                        </a:pPr>
                        <a:r>
                          <a:rPr lang="en-US" altLang="zh-CN" sz="1000" b="0" i="0" u="none" strike="noStrike" err="1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charset="0"/>
                            <a:ea typeface="宋体" panose="02010600030101010101" pitchFamily="2" charset="-122"/>
                          </a:rPr>
                          <a:t>CoV</a:t>
                        </a:r>
                        <a:r>
                          <a:rPr lang="en-US" altLang="zh-CN" sz="1000" b="0" i="0" u="none" strike="noStrike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charset="0"/>
                            <a:ea typeface="宋体" panose="02010600030101010101" pitchFamily="2" charset="-122"/>
                          </a:rPr>
                          <a:t> of lying (%)</a:t>
                        </a: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en-US" altLang="zh-CN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>
                        <a:noFill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extLst>
                    <a:ext uri="{0D108BD9-81ED-4DB2-BD59-A6C34878D82A}">
                      <a16:rowId xmlns:a16="http://schemas.microsoft.com/office/drawing/2014/main" val="1944064856"/>
                    </a:ext>
                  </a:extLst>
                </a:tr>
                <a:tr h="244800">
                  <a:tc vMerge="1"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en-US" altLang="zh-CN" sz="10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>
                        <a:noFill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indent="0" algn="r" fontAlgn="ctr">
                          <a:lnSpc>
                            <a:spcPct val="100000"/>
                          </a:lnSpc>
                          <a:buNone/>
                        </a:pPr>
                        <a:r>
                          <a:rPr lang="en-US" altLang="zh-CN" sz="1000" b="0" i="0" u="none" strike="noStrike" err="1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charset="0"/>
                            <a:ea typeface="宋体" panose="02010600030101010101" pitchFamily="2" charset="-122"/>
                          </a:rPr>
                          <a:t>CoV</a:t>
                        </a:r>
                        <a:r>
                          <a:rPr lang="en-US" altLang="zh-CN" sz="1000" b="0" i="0" u="none" strike="noStrike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charset="0"/>
                            <a:ea typeface="宋体" panose="02010600030101010101" pitchFamily="2" charset="-122"/>
                          </a:rPr>
                          <a:t> of walking bouts (%)</a:t>
                        </a: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en-US" altLang="zh-CN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>
                        <a:noFill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extLst>
                    <a:ext uri="{0D108BD9-81ED-4DB2-BD59-A6C34878D82A}">
                      <a16:rowId xmlns:a16="http://schemas.microsoft.com/office/drawing/2014/main" val="924574526"/>
                    </a:ext>
                  </a:extLst>
                </a:tr>
                <a:tr h="244800">
                  <a:tc vMerge="1"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en-US" altLang="zh-CN" sz="10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>
                        <a:noFill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indent="0" algn="r" fontAlgn="ctr">
                          <a:lnSpc>
                            <a:spcPct val="100000"/>
                          </a:lnSpc>
                          <a:buNone/>
                        </a:pPr>
                        <a:r>
                          <a:rPr lang="en-US" altLang="zh-CN" sz="1000" err="1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charset="0"/>
                            <a:ea typeface="宋体" panose="02010600030101010101" pitchFamily="2" charset="-122"/>
                            <a:sym typeface="+mn-ea"/>
                          </a:rPr>
                          <a:t>CoV</a:t>
                        </a:r>
                        <a:r>
                          <a:rPr lang="en-US" altLang="zh-CN" sz="1000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charset="0"/>
                            <a:ea typeface="宋体" panose="02010600030101010101" pitchFamily="2" charset="-122"/>
                            <a:sym typeface="+mn-ea"/>
                          </a:rPr>
                          <a:t> of </a:t>
                        </a:r>
                        <a:r>
                          <a:rPr lang="en-US" altLang="zh-CN" sz="1000" err="1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charset="0"/>
                            <a:ea typeface="宋体" panose="02010600030101010101" pitchFamily="2" charset="-122"/>
                            <a:sym typeface="+mn-ea"/>
                          </a:rPr>
                          <a:t>StSi</a:t>
                        </a:r>
                        <a:r>
                          <a:rPr lang="en-US" altLang="zh-CN" sz="1000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charset="0"/>
                            <a:ea typeface="宋体" panose="02010600030101010101" pitchFamily="2" charset="-122"/>
                            <a:sym typeface="+mn-ea"/>
                          </a:rPr>
                          <a:t> (%)</a:t>
                        </a:r>
                        <a:endPara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宋体" panose="02010600030101010101" pitchFamily="2" charset="-122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en-US" altLang="zh-CN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>
                        <a:noFill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extLst>
                    <a:ext uri="{0D108BD9-81ED-4DB2-BD59-A6C34878D82A}">
                      <a16:rowId xmlns:a16="http://schemas.microsoft.com/office/drawing/2014/main" val="2176871327"/>
                    </a:ext>
                  </a:extLst>
                </a:tr>
                <a:tr h="244800">
                  <a:tc vMerge="1"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en-US" altLang="zh-CN" sz="10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>
                        <a:noFill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r">
                          <a:buNone/>
                        </a:pPr>
                        <a:r>
                          <a:rPr lang="en-US" altLang="zh-CN" sz="1000" b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Sedentary physical activity (</a:t>
                        </a:r>
                        <a:r>
                          <a:rPr lang="en-US" altLang="zh-CN" sz="1000" b="0" err="1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hr</a:t>
                        </a:r>
                        <a:r>
                          <a:rPr lang="en-US" altLang="zh-CN" sz="1000" b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/24h)</a:t>
                        </a: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en-US" altLang="zh-CN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>
                        <a:noFill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extLst>
                    <a:ext uri="{0D108BD9-81ED-4DB2-BD59-A6C34878D82A}">
                      <a16:rowId xmlns:a16="http://schemas.microsoft.com/office/drawing/2014/main" val="1926338152"/>
                    </a:ext>
                  </a:extLst>
                </a:tr>
                <a:tr h="244800">
                  <a:tc vMerge="1"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en-US" altLang="zh-CN" sz="10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>
                        <a:noFill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r">
                          <a:buNone/>
                        </a:pPr>
                        <a:r>
                          <a:rPr lang="en-US" altLang="zh-CN" sz="1000" b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Moderate physical activity (</a:t>
                        </a:r>
                        <a:r>
                          <a:rPr lang="en-US" altLang="zh-CN" sz="1000" b="0" err="1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hr</a:t>
                        </a:r>
                        <a:r>
                          <a:rPr lang="en-US" altLang="zh-CN" sz="1000" b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/24h)</a:t>
                        </a: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en-US" altLang="zh-CN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>
                        <a:noFill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extLst>
                    <a:ext uri="{0D108BD9-81ED-4DB2-BD59-A6C34878D82A}">
                      <a16:rowId xmlns:a16="http://schemas.microsoft.com/office/drawing/2014/main" val="1516487225"/>
                    </a:ext>
                  </a:extLst>
                </a:tr>
                <a:tr h="244800">
                  <a:tc vMerge="1"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en-US" altLang="zh-CN" sz="10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>
                        <a:noFill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12700">
                        <a:solidFill>
                          <a:schemeClr val="tx1"/>
                        </a:solidFill>
                        <a:prstDash val="solid"/>
                      </a:lnB>
                    </a:tcPr>
                  </a:tc>
                  <a:tc>
                    <a:txBody>
                      <a:bodyPr/>
                      <a:lstStyle/>
                      <a:p>
                        <a:pPr marL="0" marR="0" lvl="0" indent="0" algn="r" defTabSz="6858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lang="en-US" altLang="zh-CN" sz="1000" b="0" i="0" u="none" strike="noStrike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charset="0"/>
                            <a:ea typeface="宋体" panose="02010600030101010101" pitchFamily="2" charset="-122"/>
                          </a:rPr>
                          <a:t>Signal Vector Magnitude (</a:t>
                        </a:r>
                        <a:r>
                          <a:rPr lang="en-US" altLang="zh-CN" sz="1000" b="0" i="0" u="none" strike="noStrike" err="1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charset="0"/>
                            <a:ea typeface="宋体" panose="02010600030101010101" pitchFamily="2" charset="-122"/>
                          </a:rPr>
                          <a:t>SVMg</a:t>
                        </a:r>
                        <a:r>
                          <a:rPr lang="en-US" altLang="zh-CN" sz="1000" b="0" i="0" u="none" strike="noStrike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charset="0"/>
                            <a:ea typeface="宋体" panose="02010600030101010101" pitchFamily="2" charset="-122"/>
                          </a:rPr>
                          <a:t>)</a:t>
                        </a:r>
                        <a:endParaRPr lang="zh-CN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charset="0"/>
                          <a:ea typeface="宋体" panose="02010600030101010101" pitchFamily="2" charset="-122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12700">
                        <a:solidFill>
                          <a:schemeClr val="tx1"/>
                        </a:solidFill>
                        <a:prstDash val="soli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9525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190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190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190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12700">
                        <a:solidFill>
                          <a:schemeClr val="tx1"/>
                        </a:solidFill>
                        <a:prstDash val="soli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en-US" altLang="zh-CN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12700">
                        <a:solidFill>
                          <a:schemeClr val="tx1"/>
                        </a:solidFill>
                        <a:prstDash val="soli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12700">
                        <a:solidFill>
                          <a:schemeClr val="tx1"/>
                        </a:solidFill>
                        <a:prstDash val="soli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12700">
                        <a:solidFill>
                          <a:schemeClr val="tx1"/>
                        </a:solidFill>
                        <a:prstDash val="soli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12700">
                        <a:solidFill>
                          <a:schemeClr val="tx1"/>
                        </a:solidFill>
                        <a:prstDash val="soli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>
                          <a:buNone/>
                        </a:pPr>
                        <a:endParaRPr lang="zh-CN" altLang="en-US" sz="1000" b="1">
                          <a:solidFill>
                            <a:srgbClr val="C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a:txBody>
                    <a:tcPr marL="63340" marR="63340" marT="31668" marB="31668" anchor="ctr">
                      <a:lnL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>
                        <a:noFill/>
                      </a:lnR>
                      <a:lnT w="6350" cap="flat" cmpd="sng" algn="ctr">
                        <a:solidFill>
                          <a:schemeClr val="bg1">
                            <a:lumMod val="8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12700">
                        <a:solidFill>
                          <a:schemeClr val="tx1"/>
                        </a:solidFill>
                        <a:prstDash val="solid"/>
                      </a:lnB>
                    </a:tcPr>
                  </a:tc>
                  <a:extLst>
                    <a:ext uri="{0D108BD9-81ED-4DB2-BD59-A6C34878D82A}">
                      <a16:rowId xmlns:a16="http://schemas.microsoft.com/office/drawing/2014/main" val="683860542"/>
                    </a:ext>
                  </a:extLst>
                </a:tr>
              </a:tbl>
            </a:graphicData>
          </a:graphic>
        </p:graphicFrame>
        <p:sp>
          <p:nvSpPr>
            <p:cNvPr id="2" name="文本框 9">
              <a:extLst>
                <a:ext uri="{FF2B5EF4-FFF2-40B4-BE49-F238E27FC236}">
                  <a16:creationId xmlns:a16="http://schemas.microsoft.com/office/drawing/2014/main" id="{D4999980-F7CC-D341-55E1-A3FD21CE19F6}"/>
                </a:ext>
              </a:extLst>
            </p:cNvPr>
            <p:cNvSpPr txBox="1"/>
            <p:nvPr/>
          </p:nvSpPr>
          <p:spPr>
            <a:xfrm rot="16200000">
              <a:off x="2766953" y="1338774"/>
              <a:ext cx="1980000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da-DK" sz="1000">
                  <a:latin typeface="Times New Roman" panose="02020603050405020304" pitchFamily="18" charset="0"/>
                  <a:cs typeface="Times New Roman" panose="02020603050405020304" pitchFamily="18" charset="0"/>
                </a:rPr>
                <a:t>[35] Kumar et al., 2023</a:t>
              </a:r>
            </a:p>
          </p:txBody>
        </p:sp>
        <p:sp>
          <p:nvSpPr>
            <p:cNvPr id="6" name="文本框 7">
              <a:extLst>
                <a:ext uri="{FF2B5EF4-FFF2-40B4-BE49-F238E27FC236}">
                  <a16:creationId xmlns:a16="http://schemas.microsoft.com/office/drawing/2014/main" id="{34003C5B-5B8E-11BC-D034-B16B33F2298F}"/>
                </a:ext>
              </a:extLst>
            </p:cNvPr>
            <p:cNvSpPr txBox="1"/>
            <p:nvPr/>
          </p:nvSpPr>
          <p:spPr>
            <a:xfrm rot="16200000">
              <a:off x="2520585" y="1338774"/>
              <a:ext cx="1980000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GB" sz="1000">
                  <a:latin typeface="Times New Roman" panose="02020603050405020304" pitchFamily="18" charset="0"/>
                  <a:cs typeface="Times New Roman" panose="02020603050405020304" pitchFamily="18" charset="0"/>
                </a:rPr>
                <a:t>[32] Abbas et al., 2022</a:t>
              </a:r>
            </a:p>
          </p:txBody>
        </p:sp>
        <p:sp>
          <p:nvSpPr>
            <p:cNvPr id="196" name="文本框 16">
              <a:extLst>
                <a:ext uri="{FF2B5EF4-FFF2-40B4-BE49-F238E27FC236}">
                  <a16:creationId xmlns:a16="http://schemas.microsoft.com/office/drawing/2014/main" id="{7733A979-5965-C935-6FBE-538C3EBE4AC9}"/>
                </a:ext>
              </a:extLst>
            </p:cNvPr>
            <p:cNvSpPr txBox="1"/>
            <p:nvPr/>
          </p:nvSpPr>
          <p:spPr>
            <a:xfrm rot="16200000">
              <a:off x="3013321" y="1338774"/>
              <a:ext cx="1980000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0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[</a:t>
              </a:r>
              <a:r>
                <a:rPr lang="it-IT" sz="100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  <a:r>
                <a:rPr kumimoji="0" lang="it-IT" sz="10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] Camerlingo et al., 2023</a:t>
              </a:r>
            </a:p>
          </p:txBody>
        </p:sp>
        <p:sp>
          <p:nvSpPr>
            <p:cNvPr id="201" name="文本框 9">
              <a:extLst>
                <a:ext uri="{FF2B5EF4-FFF2-40B4-BE49-F238E27FC236}">
                  <a16:creationId xmlns:a16="http://schemas.microsoft.com/office/drawing/2014/main" id="{B04EDC65-2239-CE51-D162-0BCDF926C247}"/>
                </a:ext>
              </a:extLst>
            </p:cNvPr>
            <p:cNvSpPr txBox="1"/>
            <p:nvPr/>
          </p:nvSpPr>
          <p:spPr>
            <a:xfrm rot="16200000">
              <a:off x="4232621" y="1338774"/>
              <a:ext cx="1980000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da-DK" sz="1000">
                  <a:latin typeface="Times New Roman" panose="02020603050405020304" pitchFamily="18" charset="0"/>
                  <a:cs typeface="Times New Roman" panose="02020603050405020304" pitchFamily="18" charset="0"/>
                </a:rPr>
                <a:t>[35] Kumar et al., 2023</a:t>
              </a:r>
            </a:p>
          </p:txBody>
        </p:sp>
        <p:sp>
          <p:nvSpPr>
            <p:cNvPr id="202" name="文本框 7">
              <a:extLst>
                <a:ext uri="{FF2B5EF4-FFF2-40B4-BE49-F238E27FC236}">
                  <a16:creationId xmlns:a16="http://schemas.microsoft.com/office/drawing/2014/main" id="{97177084-B146-D140-3933-D0FD9B3A396B}"/>
                </a:ext>
              </a:extLst>
            </p:cNvPr>
            <p:cNvSpPr txBox="1"/>
            <p:nvPr/>
          </p:nvSpPr>
          <p:spPr>
            <a:xfrm rot="16200000">
              <a:off x="3986253" y="1338774"/>
              <a:ext cx="1980000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GB" sz="1000">
                  <a:latin typeface="Times New Roman" panose="02020603050405020304" pitchFamily="18" charset="0"/>
                  <a:cs typeface="Times New Roman" panose="02020603050405020304" pitchFamily="18" charset="0"/>
                </a:rPr>
                <a:t>[32] Abbas et al., 2022</a:t>
              </a:r>
            </a:p>
          </p:txBody>
        </p:sp>
        <p:sp>
          <p:nvSpPr>
            <p:cNvPr id="203" name="文本框 16">
              <a:extLst>
                <a:ext uri="{FF2B5EF4-FFF2-40B4-BE49-F238E27FC236}">
                  <a16:creationId xmlns:a16="http://schemas.microsoft.com/office/drawing/2014/main" id="{80E4E8A4-CA16-8C26-D1CE-F722CF5C6918}"/>
                </a:ext>
              </a:extLst>
            </p:cNvPr>
            <p:cNvSpPr txBox="1"/>
            <p:nvPr/>
          </p:nvSpPr>
          <p:spPr>
            <a:xfrm rot="16200000">
              <a:off x="4478989" y="1338774"/>
              <a:ext cx="1980000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0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[</a:t>
              </a:r>
              <a:r>
                <a:rPr lang="it-IT" sz="100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  <a:r>
                <a:rPr kumimoji="0" lang="it-IT" sz="10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] Camerlingo et al., 2023</a:t>
              </a:r>
            </a:p>
          </p:txBody>
        </p:sp>
        <p:sp>
          <p:nvSpPr>
            <p:cNvPr id="211" name="文本框 9">
              <a:extLst>
                <a:ext uri="{FF2B5EF4-FFF2-40B4-BE49-F238E27FC236}">
                  <a16:creationId xmlns:a16="http://schemas.microsoft.com/office/drawing/2014/main" id="{CD3B2CB4-2915-BD58-ED64-B32092B49CDF}"/>
                </a:ext>
              </a:extLst>
            </p:cNvPr>
            <p:cNvSpPr txBox="1"/>
            <p:nvPr/>
          </p:nvSpPr>
          <p:spPr>
            <a:xfrm rot="16200000">
              <a:off x="3499787" y="1338774"/>
              <a:ext cx="1980000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da-DK" sz="1000">
                  <a:latin typeface="Times New Roman" panose="02020603050405020304" pitchFamily="18" charset="0"/>
                  <a:cs typeface="Times New Roman" panose="02020603050405020304" pitchFamily="18" charset="0"/>
                </a:rPr>
                <a:t>[35] Kumar et al., 2023</a:t>
              </a:r>
            </a:p>
          </p:txBody>
        </p:sp>
        <p:sp>
          <p:nvSpPr>
            <p:cNvPr id="212" name="文本框 7">
              <a:extLst>
                <a:ext uri="{FF2B5EF4-FFF2-40B4-BE49-F238E27FC236}">
                  <a16:creationId xmlns:a16="http://schemas.microsoft.com/office/drawing/2014/main" id="{8CFD29FB-97C1-ED4C-6058-F5073D7CC3A5}"/>
                </a:ext>
              </a:extLst>
            </p:cNvPr>
            <p:cNvSpPr txBox="1"/>
            <p:nvPr/>
          </p:nvSpPr>
          <p:spPr>
            <a:xfrm rot="16200000">
              <a:off x="3253419" y="1338774"/>
              <a:ext cx="1980000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GB" sz="1000">
                  <a:latin typeface="Times New Roman" panose="02020603050405020304" pitchFamily="18" charset="0"/>
                  <a:cs typeface="Times New Roman" panose="02020603050405020304" pitchFamily="18" charset="0"/>
                </a:rPr>
                <a:t>[32] Abbas et al., 2022</a:t>
              </a:r>
            </a:p>
          </p:txBody>
        </p:sp>
        <p:sp>
          <p:nvSpPr>
            <p:cNvPr id="213" name="文本框 16">
              <a:extLst>
                <a:ext uri="{FF2B5EF4-FFF2-40B4-BE49-F238E27FC236}">
                  <a16:creationId xmlns:a16="http://schemas.microsoft.com/office/drawing/2014/main" id="{387DC085-1CEF-309E-764A-553025F3EA57}"/>
                </a:ext>
              </a:extLst>
            </p:cNvPr>
            <p:cNvSpPr txBox="1"/>
            <p:nvPr/>
          </p:nvSpPr>
          <p:spPr>
            <a:xfrm rot="16200000">
              <a:off x="3746155" y="1338774"/>
              <a:ext cx="1980000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0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[</a:t>
              </a:r>
              <a:r>
                <a:rPr lang="it-IT" sz="100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  <a:r>
                <a:rPr kumimoji="0" lang="it-IT" sz="10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] Camerlingo et al., 2023</a:t>
              </a:r>
            </a:p>
          </p:txBody>
        </p:sp>
        <p:sp>
          <p:nvSpPr>
            <p:cNvPr id="7" name="椭圆 196">
              <a:extLst>
                <a:ext uri="{FF2B5EF4-FFF2-40B4-BE49-F238E27FC236}">
                  <a16:creationId xmlns:a16="http://schemas.microsoft.com/office/drawing/2014/main" id="{DAD4F62F-73DD-BE13-8FD8-D876C7AD8A9F}"/>
                </a:ext>
              </a:extLst>
            </p:cNvPr>
            <p:cNvSpPr/>
            <p:nvPr/>
          </p:nvSpPr>
          <p:spPr>
            <a:xfrm>
              <a:off x="3431805" y="2916320"/>
              <a:ext cx="180000" cy="180000"/>
            </a:xfrm>
            <a:prstGeom prst="ellipse">
              <a:avLst/>
            </a:prstGeom>
            <a:solidFill>
              <a:srgbClr val="00B050"/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zh-CN" sz="1000" b="1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黑体" panose="02010609060101010101" pitchFamily="49" charset="-122"/>
                <a:ea typeface="黑体" panose="02010609060101010101" pitchFamily="49" charset="-122"/>
                <a:cs typeface="Times New Roman" panose="02020603050405020304" pitchFamily="18" charset="0"/>
              </a:endParaRPr>
            </a:p>
          </p:txBody>
        </p:sp>
        <p:sp>
          <p:nvSpPr>
            <p:cNvPr id="11" name="椭圆 196">
              <a:extLst>
                <a:ext uri="{FF2B5EF4-FFF2-40B4-BE49-F238E27FC236}">
                  <a16:creationId xmlns:a16="http://schemas.microsoft.com/office/drawing/2014/main" id="{1973F083-70A9-9C60-89D0-1627B2A98227}"/>
                </a:ext>
              </a:extLst>
            </p:cNvPr>
            <p:cNvSpPr/>
            <p:nvPr/>
          </p:nvSpPr>
          <p:spPr>
            <a:xfrm>
              <a:off x="4917107" y="2913184"/>
              <a:ext cx="180000" cy="180000"/>
            </a:xfrm>
            <a:prstGeom prst="ellipse">
              <a:avLst/>
            </a:prstGeom>
            <a:solidFill>
              <a:srgbClr val="00B050"/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zh-CN" sz="1000" b="1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黑体" panose="02010609060101010101" pitchFamily="49" charset="-122"/>
                <a:ea typeface="黑体" panose="02010609060101010101" pitchFamily="49" charset="-122"/>
                <a:cs typeface="Times New Roman" panose="02020603050405020304" pitchFamily="18" charset="0"/>
              </a:endParaRPr>
            </a:p>
          </p:txBody>
        </p:sp>
        <p:sp>
          <p:nvSpPr>
            <p:cNvPr id="14" name="椭圆 196">
              <a:extLst>
                <a:ext uri="{FF2B5EF4-FFF2-40B4-BE49-F238E27FC236}">
                  <a16:creationId xmlns:a16="http://schemas.microsoft.com/office/drawing/2014/main" id="{15291501-929D-705F-D3CC-B0541B0F22D0}"/>
                </a:ext>
              </a:extLst>
            </p:cNvPr>
            <p:cNvSpPr/>
            <p:nvPr/>
          </p:nvSpPr>
          <p:spPr>
            <a:xfrm>
              <a:off x="4171917" y="3419622"/>
              <a:ext cx="180000" cy="180000"/>
            </a:xfrm>
            <a:prstGeom prst="ellipse">
              <a:avLst/>
            </a:prstGeom>
            <a:solidFill>
              <a:srgbClr val="00B050"/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zh-CN" sz="1000" b="1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黑体" panose="02010609060101010101" pitchFamily="49" charset="-122"/>
                <a:ea typeface="黑体" panose="02010609060101010101" pitchFamily="49" charset="-122"/>
                <a:cs typeface="Times New Roman" panose="02020603050405020304" pitchFamily="18" charset="0"/>
              </a:endParaRPr>
            </a:p>
          </p:txBody>
        </p:sp>
        <p:sp>
          <p:nvSpPr>
            <p:cNvPr id="16" name="椭圆 196">
              <a:extLst>
                <a:ext uri="{FF2B5EF4-FFF2-40B4-BE49-F238E27FC236}">
                  <a16:creationId xmlns:a16="http://schemas.microsoft.com/office/drawing/2014/main" id="{0186E92F-D8BA-3624-ADFE-C4238F5816A8}"/>
                </a:ext>
              </a:extLst>
            </p:cNvPr>
            <p:cNvSpPr/>
            <p:nvPr/>
          </p:nvSpPr>
          <p:spPr>
            <a:xfrm>
              <a:off x="3429000" y="3419622"/>
              <a:ext cx="180000" cy="180000"/>
            </a:xfrm>
            <a:prstGeom prst="ellipse">
              <a:avLst/>
            </a:prstGeom>
            <a:solidFill>
              <a:srgbClr val="00B050"/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zh-CN" sz="1000" b="1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黑体" panose="02010609060101010101" pitchFamily="49" charset="-122"/>
                <a:ea typeface="黑体" panose="02010609060101010101" pitchFamily="49" charset="-122"/>
                <a:cs typeface="Times New Roman" panose="02020603050405020304" pitchFamily="18" charset="0"/>
              </a:endParaRPr>
            </a:p>
          </p:txBody>
        </p:sp>
        <p:sp>
          <p:nvSpPr>
            <p:cNvPr id="17" name="椭圆 196">
              <a:extLst>
                <a:ext uri="{FF2B5EF4-FFF2-40B4-BE49-F238E27FC236}">
                  <a16:creationId xmlns:a16="http://schemas.microsoft.com/office/drawing/2014/main" id="{A602CB11-2475-7698-0AA9-AAADDFC3A487}"/>
                </a:ext>
              </a:extLst>
            </p:cNvPr>
            <p:cNvSpPr/>
            <p:nvPr/>
          </p:nvSpPr>
          <p:spPr>
            <a:xfrm>
              <a:off x="4914302" y="3416486"/>
              <a:ext cx="180000" cy="180000"/>
            </a:xfrm>
            <a:prstGeom prst="ellipse">
              <a:avLst/>
            </a:prstGeom>
            <a:solidFill>
              <a:srgbClr val="00B050"/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zh-CN" sz="1000" b="1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黑体" panose="02010609060101010101" pitchFamily="49" charset="-122"/>
                <a:ea typeface="黑体" panose="02010609060101010101" pitchFamily="49" charset="-122"/>
                <a:cs typeface="Times New Roman" panose="02020603050405020304" pitchFamily="18" charset="0"/>
              </a:endParaRPr>
            </a:p>
          </p:txBody>
        </p:sp>
        <p:sp>
          <p:nvSpPr>
            <p:cNvPr id="18" name="椭圆 196">
              <a:extLst>
                <a:ext uri="{FF2B5EF4-FFF2-40B4-BE49-F238E27FC236}">
                  <a16:creationId xmlns:a16="http://schemas.microsoft.com/office/drawing/2014/main" id="{DA42C7D7-39E4-FAB0-7279-012A3F428062}"/>
                </a:ext>
              </a:extLst>
            </p:cNvPr>
            <p:cNvSpPr/>
            <p:nvPr/>
          </p:nvSpPr>
          <p:spPr>
            <a:xfrm>
              <a:off x="4171917" y="3655625"/>
              <a:ext cx="180000" cy="180000"/>
            </a:xfrm>
            <a:prstGeom prst="ellipse">
              <a:avLst/>
            </a:prstGeom>
            <a:solidFill>
              <a:srgbClr val="00B050"/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zh-CN" sz="1000" b="1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黑体" panose="02010609060101010101" pitchFamily="49" charset="-122"/>
                <a:ea typeface="黑体" panose="02010609060101010101" pitchFamily="49" charset="-122"/>
                <a:cs typeface="Times New Roman" panose="02020603050405020304" pitchFamily="18" charset="0"/>
              </a:endParaRPr>
            </a:p>
          </p:txBody>
        </p:sp>
        <p:sp>
          <p:nvSpPr>
            <p:cNvPr id="19" name="椭圆 196">
              <a:extLst>
                <a:ext uri="{FF2B5EF4-FFF2-40B4-BE49-F238E27FC236}">
                  <a16:creationId xmlns:a16="http://schemas.microsoft.com/office/drawing/2014/main" id="{9BDB8BC9-89FC-AB8A-F62C-511E78BC9901}"/>
                </a:ext>
              </a:extLst>
            </p:cNvPr>
            <p:cNvSpPr/>
            <p:nvPr/>
          </p:nvSpPr>
          <p:spPr>
            <a:xfrm>
              <a:off x="3429000" y="3655625"/>
              <a:ext cx="180000" cy="180000"/>
            </a:xfrm>
            <a:prstGeom prst="ellipse">
              <a:avLst/>
            </a:prstGeom>
            <a:solidFill>
              <a:srgbClr val="00B050"/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zh-CN" sz="1000" b="1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黑体" panose="02010609060101010101" pitchFamily="49" charset="-122"/>
                <a:ea typeface="黑体" panose="02010609060101010101" pitchFamily="49" charset="-122"/>
                <a:cs typeface="Times New Roman" panose="02020603050405020304" pitchFamily="18" charset="0"/>
              </a:endParaRPr>
            </a:p>
          </p:txBody>
        </p:sp>
        <p:sp>
          <p:nvSpPr>
            <p:cNvPr id="20" name="椭圆 196">
              <a:extLst>
                <a:ext uri="{FF2B5EF4-FFF2-40B4-BE49-F238E27FC236}">
                  <a16:creationId xmlns:a16="http://schemas.microsoft.com/office/drawing/2014/main" id="{DD3EAF64-9C03-498B-2918-701D642B956B}"/>
                </a:ext>
              </a:extLst>
            </p:cNvPr>
            <p:cNvSpPr/>
            <p:nvPr/>
          </p:nvSpPr>
          <p:spPr>
            <a:xfrm>
              <a:off x="4914302" y="3652489"/>
              <a:ext cx="180000" cy="180000"/>
            </a:xfrm>
            <a:prstGeom prst="ellipse">
              <a:avLst/>
            </a:prstGeom>
            <a:solidFill>
              <a:srgbClr val="00B050"/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zh-CN" sz="1000" b="1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黑体" panose="02010609060101010101" pitchFamily="49" charset="-122"/>
                <a:ea typeface="黑体" panose="02010609060101010101" pitchFamily="49" charset="-122"/>
                <a:cs typeface="Times New Roman" panose="02020603050405020304" pitchFamily="18" charset="0"/>
              </a:endParaRPr>
            </a:p>
          </p:txBody>
        </p:sp>
        <p:sp>
          <p:nvSpPr>
            <p:cNvPr id="21" name="椭圆 196">
              <a:extLst>
                <a:ext uri="{FF2B5EF4-FFF2-40B4-BE49-F238E27FC236}">
                  <a16:creationId xmlns:a16="http://schemas.microsoft.com/office/drawing/2014/main" id="{A81A5379-4E26-4397-93AB-C535D6ABE14E}"/>
                </a:ext>
              </a:extLst>
            </p:cNvPr>
            <p:cNvSpPr/>
            <p:nvPr/>
          </p:nvSpPr>
          <p:spPr>
            <a:xfrm>
              <a:off x="4171917" y="3906594"/>
              <a:ext cx="180000" cy="180000"/>
            </a:xfrm>
            <a:prstGeom prst="ellipse">
              <a:avLst/>
            </a:prstGeom>
            <a:solidFill>
              <a:srgbClr val="00B050"/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zh-CN" sz="1000" b="1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黑体" panose="02010609060101010101" pitchFamily="49" charset="-122"/>
                <a:ea typeface="黑体" panose="02010609060101010101" pitchFamily="49" charset="-122"/>
                <a:cs typeface="Times New Roman" panose="02020603050405020304" pitchFamily="18" charset="0"/>
              </a:endParaRPr>
            </a:p>
          </p:txBody>
        </p:sp>
        <p:sp>
          <p:nvSpPr>
            <p:cNvPr id="23" name="椭圆 196">
              <a:extLst>
                <a:ext uri="{FF2B5EF4-FFF2-40B4-BE49-F238E27FC236}">
                  <a16:creationId xmlns:a16="http://schemas.microsoft.com/office/drawing/2014/main" id="{BE597229-9F3A-E79E-45C5-6521E29C4C11}"/>
                </a:ext>
              </a:extLst>
            </p:cNvPr>
            <p:cNvSpPr/>
            <p:nvPr/>
          </p:nvSpPr>
          <p:spPr>
            <a:xfrm>
              <a:off x="3429000" y="3906594"/>
              <a:ext cx="180000" cy="180000"/>
            </a:xfrm>
            <a:prstGeom prst="ellipse">
              <a:avLst/>
            </a:prstGeom>
            <a:solidFill>
              <a:srgbClr val="00B050"/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zh-CN" sz="1000" b="1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黑体" panose="02010609060101010101" pitchFamily="49" charset="-122"/>
                <a:ea typeface="黑体" panose="02010609060101010101" pitchFamily="49" charset="-122"/>
                <a:cs typeface="Times New Roman" panose="02020603050405020304" pitchFamily="18" charset="0"/>
              </a:endParaRPr>
            </a:p>
          </p:txBody>
        </p:sp>
        <p:sp>
          <p:nvSpPr>
            <p:cNvPr id="24" name="椭圆 196">
              <a:extLst>
                <a:ext uri="{FF2B5EF4-FFF2-40B4-BE49-F238E27FC236}">
                  <a16:creationId xmlns:a16="http://schemas.microsoft.com/office/drawing/2014/main" id="{66537257-7D69-24E4-FCFD-C1696097F037}"/>
                </a:ext>
              </a:extLst>
            </p:cNvPr>
            <p:cNvSpPr/>
            <p:nvPr/>
          </p:nvSpPr>
          <p:spPr>
            <a:xfrm>
              <a:off x="4914302" y="3903458"/>
              <a:ext cx="180000" cy="180000"/>
            </a:xfrm>
            <a:prstGeom prst="ellipse">
              <a:avLst/>
            </a:prstGeom>
            <a:solidFill>
              <a:srgbClr val="00B050"/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zh-CN" sz="1000" b="1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黑体" panose="02010609060101010101" pitchFamily="49" charset="-122"/>
                <a:ea typeface="黑体" panose="02010609060101010101" pitchFamily="49" charset="-122"/>
                <a:cs typeface="Times New Roman" panose="02020603050405020304" pitchFamily="18" charset="0"/>
              </a:endParaRPr>
            </a:p>
          </p:txBody>
        </p:sp>
        <p:sp>
          <p:nvSpPr>
            <p:cNvPr id="25" name="椭圆 24">
              <a:extLst>
                <a:ext uri="{FF2B5EF4-FFF2-40B4-BE49-F238E27FC236}">
                  <a16:creationId xmlns:a16="http://schemas.microsoft.com/office/drawing/2014/main" id="{CA193A85-1B85-75EC-E08F-93EDB1B8EA5C}"/>
                </a:ext>
              </a:extLst>
            </p:cNvPr>
            <p:cNvSpPr/>
            <p:nvPr/>
          </p:nvSpPr>
          <p:spPr>
            <a:xfrm>
              <a:off x="3689745" y="3169056"/>
              <a:ext cx="180000" cy="180000"/>
            </a:xfrm>
            <a:prstGeom prst="ellipse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000" b="1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黑体" panose="02010609060101010101" pitchFamily="49" charset="-122"/>
                  <a:ea typeface="黑体" panose="02010609060101010101" pitchFamily="49" charset="-122"/>
                  <a:cs typeface="Times New Roman" panose="02020603050405020304" pitchFamily="18" charset="0"/>
                  <a:sym typeface="+mn-ea"/>
                </a:rPr>
                <a:t>↑</a:t>
              </a:r>
            </a:p>
          </p:txBody>
        </p:sp>
        <p:sp>
          <p:nvSpPr>
            <p:cNvPr id="26" name="椭圆 25">
              <a:extLst>
                <a:ext uri="{FF2B5EF4-FFF2-40B4-BE49-F238E27FC236}">
                  <a16:creationId xmlns:a16="http://schemas.microsoft.com/office/drawing/2014/main" id="{61FF5BF8-7FBC-5527-FA3F-053B34090B34}"/>
                </a:ext>
              </a:extLst>
            </p:cNvPr>
            <p:cNvSpPr/>
            <p:nvPr/>
          </p:nvSpPr>
          <p:spPr>
            <a:xfrm>
              <a:off x="4416419" y="3169056"/>
              <a:ext cx="180000" cy="180000"/>
            </a:xfrm>
            <a:prstGeom prst="ellipse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000" b="1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黑体" panose="02010609060101010101" pitchFamily="49" charset="-122"/>
                  <a:ea typeface="黑体" panose="02010609060101010101" pitchFamily="49" charset="-122"/>
                  <a:cs typeface="Times New Roman" panose="02020603050405020304" pitchFamily="18" charset="0"/>
                  <a:sym typeface="+mn-ea"/>
                </a:rPr>
                <a:t>↑</a:t>
              </a:r>
            </a:p>
          </p:txBody>
        </p:sp>
        <p:sp>
          <p:nvSpPr>
            <p:cNvPr id="36" name="椭圆 178">
              <a:extLst>
                <a:ext uri="{FF2B5EF4-FFF2-40B4-BE49-F238E27FC236}">
                  <a16:creationId xmlns:a16="http://schemas.microsoft.com/office/drawing/2014/main" id="{95A795A5-55A2-8D75-95D8-F80356A19E21}"/>
                </a:ext>
              </a:extLst>
            </p:cNvPr>
            <p:cNvSpPr/>
            <p:nvPr/>
          </p:nvSpPr>
          <p:spPr>
            <a:xfrm>
              <a:off x="3689745" y="4140474"/>
              <a:ext cx="180000" cy="180000"/>
            </a:xfrm>
            <a:prstGeom prst="ellipse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000" b="1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黑体" panose="02010609060101010101" pitchFamily="49" charset="-122"/>
                  <a:ea typeface="黑体" panose="02010609060101010101" pitchFamily="49" charset="-122"/>
                  <a:cs typeface="Times New Roman" panose="02020603050405020304" pitchFamily="18" charset="0"/>
                  <a:sym typeface="+mn-ea"/>
                </a:rPr>
                <a:t>↓</a:t>
              </a:r>
            </a:p>
          </p:txBody>
        </p:sp>
        <p:sp>
          <p:nvSpPr>
            <p:cNvPr id="39" name="椭圆 178">
              <a:extLst>
                <a:ext uri="{FF2B5EF4-FFF2-40B4-BE49-F238E27FC236}">
                  <a16:creationId xmlns:a16="http://schemas.microsoft.com/office/drawing/2014/main" id="{43B085B1-8E3C-F822-6949-DA74CE6F31EC}"/>
                </a:ext>
              </a:extLst>
            </p:cNvPr>
            <p:cNvSpPr/>
            <p:nvPr/>
          </p:nvSpPr>
          <p:spPr>
            <a:xfrm>
              <a:off x="4416419" y="4140474"/>
              <a:ext cx="180000" cy="180000"/>
            </a:xfrm>
            <a:prstGeom prst="ellipse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000" b="1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黑体" panose="02010609060101010101" pitchFamily="49" charset="-122"/>
                  <a:ea typeface="黑体" panose="02010609060101010101" pitchFamily="49" charset="-122"/>
                  <a:cs typeface="Times New Roman" panose="02020603050405020304" pitchFamily="18" charset="0"/>
                  <a:sym typeface="+mn-ea"/>
                </a:rPr>
                <a:t>↓</a:t>
              </a:r>
            </a:p>
          </p:txBody>
        </p:sp>
        <p:sp>
          <p:nvSpPr>
            <p:cNvPr id="46" name="椭圆 45">
              <a:extLst>
                <a:ext uri="{FF2B5EF4-FFF2-40B4-BE49-F238E27FC236}">
                  <a16:creationId xmlns:a16="http://schemas.microsoft.com/office/drawing/2014/main" id="{201CAB0B-6D37-A4EF-44C3-C2A254A07447}"/>
                </a:ext>
              </a:extLst>
            </p:cNvPr>
            <p:cNvSpPr/>
            <p:nvPr/>
          </p:nvSpPr>
          <p:spPr>
            <a:xfrm>
              <a:off x="4416419" y="4398039"/>
              <a:ext cx="180000" cy="180000"/>
            </a:xfrm>
            <a:prstGeom prst="ellipse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000" b="1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黑体" panose="02010609060101010101" pitchFamily="49" charset="-122"/>
                  <a:ea typeface="黑体" panose="02010609060101010101" pitchFamily="49" charset="-122"/>
                  <a:cs typeface="Times New Roman" panose="02020603050405020304" pitchFamily="18" charset="0"/>
                  <a:sym typeface="+mn-ea"/>
                </a:rPr>
                <a:t>↑</a:t>
              </a:r>
            </a:p>
          </p:txBody>
        </p:sp>
        <p:sp>
          <p:nvSpPr>
            <p:cNvPr id="49" name="椭圆 48">
              <a:extLst>
                <a:ext uri="{FF2B5EF4-FFF2-40B4-BE49-F238E27FC236}">
                  <a16:creationId xmlns:a16="http://schemas.microsoft.com/office/drawing/2014/main" id="{66990736-6599-7788-9632-265B09E9B4D7}"/>
                </a:ext>
              </a:extLst>
            </p:cNvPr>
            <p:cNvSpPr/>
            <p:nvPr/>
          </p:nvSpPr>
          <p:spPr>
            <a:xfrm>
              <a:off x="4416419" y="4645689"/>
              <a:ext cx="180000" cy="180000"/>
            </a:xfrm>
            <a:prstGeom prst="ellipse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000" b="1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黑体" panose="02010609060101010101" pitchFamily="49" charset="-122"/>
                  <a:ea typeface="黑体" panose="02010609060101010101" pitchFamily="49" charset="-122"/>
                  <a:cs typeface="Times New Roman" panose="02020603050405020304" pitchFamily="18" charset="0"/>
                  <a:sym typeface="+mn-ea"/>
                </a:rPr>
                <a:t>↑</a:t>
              </a:r>
            </a:p>
          </p:txBody>
        </p:sp>
        <p:sp>
          <p:nvSpPr>
            <p:cNvPr id="50" name="椭圆 49">
              <a:extLst>
                <a:ext uri="{FF2B5EF4-FFF2-40B4-BE49-F238E27FC236}">
                  <a16:creationId xmlns:a16="http://schemas.microsoft.com/office/drawing/2014/main" id="{B2E0329C-FCD1-FB57-5816-E638A5F954A4}"/>
                </a:ext>
              </a:extLst>
            </p:cNvPr>
            <p:cNvSpPr/>
            <p:nvPr/>
          </p:nvSpPr>
          <p:spPr>
            <a:xfrm>
              <a:off x="3689745" y="4645689"/>
              <a:ext cx="180000" cy="180000"/>
            </a:xfrm>
            <a:prstGeom prst="ellipse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000" b="1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黑体" panose="02010609060101010101" pitchFamily="49" charset="-122"/>
                  <a:ea typeface="黑体" panose="02010609060101010101" pitchFamily="49" charset="-122"/>
                  <a:cs typeface="Times New Roman" panose="02020603050405020304" pitchFamily="18" charset="0"/>
                  <a:sym typeface="+mn-ea"/>
                </a:rPr>
                <a:t>↑</a:t>
              </a:r>
            </a:p>
          </p:txBody>
        </p:sp>
        <p:sp>
          <p:nvSpPr>
            <p:cNvPr id="51" name="椭圆 178">
              <a:extLst>
                <a:ext uri="{FF2B5EF4-FFF2-40B4-BE49-F238E27FC236}">
                  <a16:creationId xmlns:a16="http://schemas.microsoft.com/office/drawing/2014/main" id="{F2EE2B52-AE07-5E2B-8E9C-93521C73A7B6}"/>
                </a:ext>
              </a:extLst>
            </p:cNvPr>
            <p:cNvSpPr/>
            <p:nvPr/>
          </p:nvSpPr>
          <p:spPr>
            <a:xfrm>
              <a:off x="5150389" y="5131734"/>
              <a:ext cx="180000" cy="180000"/>
            </a:xfrm>
            <a:prstGeom prst="ellipse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000" b="1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黑体" panose="02010609060101010101" pitchFamily="49" charset="-122"/>
                  <a:ea typeface="黑体" panose="02010609060101010101" pitchFamily="49" charset="-122"/>
                  <a:cs typeface="Times New Roman" panose="02020603050405020304" pitchFamily="18" charset="0"/>
                  <a:sym typeface="+mn-ea"/>
                </a:rPr>
                <a:t>↓</a:t>
              </a:r>
            </a:p>
          </p:txBody>
        </p:sp>
        <p:sp>
          <p:nvSpPr>
            <p:cNvPr id="52" name="椭圆 178">
              <a:extLst>
                <a:ext uri="{FF2B5EF4-FFF2-40B4-BE49-F238E27FC236}">
                  <a16:creationId xmlns:a16="http://schemas.microsoft.com/office/drawing/2014/main" id="{1FFF4155-F707-23B6-BFDA-41C53D96B95C}"/>
                </a:ext>
              </a:extLst>
            </p:cNvPr>
            <p:cNvSpPr/>
            <p:nvPr/>
          </p:nvSpPr>
          <p:spPr>
            <a:xfrm>
              <a:off x="4416419" y="5131734"/>
              <a:ext cx="180000" cy="180000"/>
            </a:xfrm>
            <a:prstGeom prst="ellipse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000" b="1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黑体" panose="02010609060101010101" pitchFamily="49" charset="-122"/>
                  <a:ea typeface="黑体" panose="02010609060101010101" pitchFamily="49" charset="-122"/>
                  <a:cs typeface="Times New Roman" panose="02020603050405020304" pitchFamily="18" charset="0"/>
                  <a:sym typeface="+mn-ea"/>
                </a:rPr>
                <a:t>↓</a:t>
              </a:r>
            </a:p>
          </p:txBody>
        </p:sp>
        <p:sp>
          <p:nvSpPr>
            <p:cNvPr id="53" name="椭圆 178">
              <a:extLst>
                <a:ext uri="{FF2B5EF4-FFF2-40B4-BE49-F238E27FC236}">
                  <a16:creationId xmlns:a16="http://schemas.microsoft.com/office/drawing/2014/main" id="{15E754E7-BE10-F353-8D08-5D1FCDA51EC2}"/>
                </a:ext>
              </a:extLst>
            </p:cNvPr>
            <p:cNvSpPr/>
            <p:nvPr/>
          </p:nvSpPr>
          <p:spPr>
            <a:xfrm>
              <a:off x="3689745" y="5131734"/>
              <a:ext cx="180000" cy="180000"/>
            </a:xfrm>
            <a:prstGeom prst="ellipse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000" b="1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黑体" panose="02010609060101010101" pitchFamily="49" charset="-122"/>
                  <a:ea typeface="黑体" panose="02010609060101010101" pitchFamily="49" charset="-122"/>
                  <a:cs typeface="Times New Roman" panose="02020603050405020304" pitchFamily="18" charset="0"/>
                  <a:sym typeface="+mn-ea"/>
                </a:rPr>
                <a:t>↓</a:t>
              </a:r>
            </a:p>
          </p:txBody>
        </p:sp>
        <p:sp>
          <p:nvSpPr>
            <p:cNvPr id="54" name="椭圆 53">
              <a:extLst>
                <a:ext uri="{FF2B5EF4-FFF2-40B4-BE49-F238E27FC236}">
                  <a16:creationId xmlns:a16="http://schemas.microsoft.com/office/drawing/2014/main" id="{648F80B9-E613-E487-9449-9FBA8BE66505}"/>
                </a:ext>
              </a:extLst>
            </p:cNvPr>
            <p:cNvSpPr/>
            <p:nvPr/>
          </p:nvSpPr>
          <p:spPr>
            <a:xfrm>
              <a:off x="4416419" y="5365838"/>
              <a:ext cx="180000" cy="180000"/>
            </a:xfrm>
            <a:prstGeom prst="ellipse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000" b="1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黑体" panose="02010609060101010101" pitchFamily="49" charset="-122"/>
                  <a:ea typeface="黑体" panose="02010609060101010101" pitchFamily="49" charset="-122"/>
                  <a:cs typeface="Times New Roman" panose="02020603050405020304" pitchFamily="18" charset="0"/>
                  <a:sym typeface="+mn-ea"/>
                </a:rPr>
                <a:t>↑</a:t>
              </a:r>
            </a:p>
          </p:txBody>
        </p:sp>
        <p:sp>
          <p:nvSpPr>
            <p:cNvPr id="55" name="椭圆 54">
              <a:extLst>
                <a:ext uri="{FF2B5EF4-FFF2-40B4-BE49-F238E27FC236}">
                  <a16:creationId xmlns:a16="http://schemas.microsoft.com/office/drawing/2014/main" id="{EDBFF825-24AB-D95D-3AE8-87ACA7A09D41}"/>
                </a:ext>
              </a:extLst>
            </p:cNvPr>
            <p:cNvSpPr/>
            <p:nvPr/>
          </p:nvSpPr>
          <p:spPr>
            <a:xfrm>
              <a:off x="3689745" y="5365838"/>
              <a:ext cx="180000" cy="180000"/>
            </a:xfrm>
            <a:prstGeom prst="ellipse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000" b="1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黑体" panose="02010609060101010101" pitchFamily="49" charset="-122"/>
                  <a:ea typeface="黑体" panose="02010609060101010101" pitchFamily="49" charset="-122"/>
                  <a:cs typeface="Times New Roman" panose="02020603050405020304" pitchFamily="18" charset="0"/>
                  <a:sym typeface="+mn-ea"/>
                </a:rPr>
                <a:t>↑</a:t>
              </a:r>
            </a:p>
          </p:txBody>
        </p:sp>
        <p:sp>
          <p:nvSpPr>
            <p:cNvPr id="57" name="椭圆 178">
              <a:extLst>
                <a:ext uri="{FF2B5EF4-FFF2-40B4-BE49-F238E27FC236}">
                  <a16:creationId xmlns:a16="http://schemas.microsoft.com/office/drawing/2014/main" id="{8A0A4089-EEA8-3BB7-1DCA-504CAD6C1900}"/>
                </a:ext>
              </a:extLst>
            </p:cNvPr>
            <p:cNvSpPr/>
            <p:nvPr/>
          </p:nvSpPr>
          <p:spPr>
            <a:xfrm>
              <a:off x="3689745" y="4886122"/>
              <a:ext cx="180000" cy="180000"/>
            </a:xfrm>
            <a:prstGeom prst="ellipse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000" b="1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黑体" panose="02010609060101010101" pitchFamily="49" charset="-122"/>
                  <a:ea typeface="黑体" panose="02010609060101010101" pitchFamily="49" charset="-122"/>
                  <a:cs typeface="Times New Roman" panose="02020603050405020304" pitchFamily="18" charset="0"/>
                  <a:sym typeface="+mn-ea"/>
                </a:rPr>
                <a:t>↓</a:t>
              </a:r>
            </a:p>
          </p:txBody>
        </p:sp>
        <p:sp>
          <p:nvSpPr>
            <p:cNvPr id="59" name="椭圆 178">
              <a:extLst>
                <a:ext uri="{FF2B5EF4-FFF2-40B4-BE49-F238E27FC236}">
                  <a16:creationId xmlns:a16="http://schemas.microsoft.com/office/drawing/2014/main" id="{B83C339C-23AA-7884-6111-354C012EE0CD}"/>
                </a:ext>
              </a:extLst>
            </p:cNvPr>
            <p:cNvSpPr/>
            <p:nvPr/>
          </p:nvSpPr>
          <p:spPr>
            <a:xfrm>
              <a:off x="4646155" y="2671438"/>
              <a:ext cx="180000" cy="180000"/>
            </a:xfrm>
            <a:prstGeom prst="ellipse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000" b="1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黑体" panose="02010609060101010101" pitchFamily="49" charset="-122"/>
                  <a:ea typeface="黑体" panose="02010609060101010101" pitchFamily="49" charset="-122"/>
                  <a:cs typeface="Times New Roman" panose="02020603050405020304" pitchFamily="18" charset="0"/>
                  <a:sym typeface="+mn-ea"/>
                </a:rPr>
                <a:t>↓</a:t>
              </a:r>
            </a:p>
          </p:txBody>
        </p:sp>
        <p:sp>
          <p:nvSpPr>
            <p:cNvPr id="60" name="椭圆 178">
              <a:extLst>
                <a:ext uri="{FF2B5EF4-FFF2-40B4-BE49-F238E27FC236}">
                  <a16:creationId xmlns:a16="http://schemas.microsoft.com/office/drawing/2014/main" id="{A1E0DA26-C1EF-F153-7E65-21E555F212EE}"/>
                </a:ext>
              </a:extLst>
            </p:cNvPr>
            <p:cNvSpPr/>
            <p:nvPr/>
          </p:nvSpPr>
          <p:spPr>
            <a:xfrm>
              <a:off x="3925320" y="2671438"/>
              <a:ext cx="180000" cy="180000"/>
            </a:xfrm>
            <a:prstGeom prst="ellipse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000" b="1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黑体" panose="02010609060101010101" pitchFamily="49" charset="-122"/>
                  <a:ea typeface="黑体" panose="02010609060101010101" pitchFamily="49" charset="-122"/>
                  <a:cs typeface="Times New Roman" panose="02020603050405020304" pitchFamily="18" charset="0"/>
                  <a:sym typeface="+mn-ea"/>
                </a:rPr>
                <a:t>↓</a:t>
              </a:r>
            </a:p>
          </p:txBody>
        </p:sp>
        <p:sp>
          <p:nvSpPr>
            <p:cNvPr id="61" name="椭圆 60">
              <a:extLst>
                <a:ext uri="{FF2B5EF4-FFF2-40B4-BE49-F238E27FC236}">
                  <a16:creationId xmlns:a16="http://schemas.microsoft.com/office/drawing/2014/main" id="{C9726D82-D367-94E9-DA4E-0A8BC6BB7B25}"/>
                </a:ext>
              </a:extLst>
            </p:cNvPr>
            <p:cNvSpPr/>
            <p:nvPr/>
          </p:nvSpPr>
          <p:spPr>
            <a:xfrm>
              <a:off x="5376467" y="5613263"/>
              <a:ext cx="180000" cy="180000"/>
            </a:xfrm>
            <a:prstGeom prst="ellipse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000" b="1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黑体" panose="02010609060101010101" pitchFamily="49" charset="-122"/>
                  <a:ea typeface="黑体" panose="02010609060101010101" pitchFamily="49" charset="-122"/>
                  <a:cs typeface="Times New Roman" panose="02020603050405020304" pitchFamily="18" charset="0"/>
                  <a:sym typeface="+mn-ea"/>
                </a:rPr>
                <a:t>↑</a:t>
              </a:r>
            </a:p>
          </p:txBody>
        </p:sp>
        <p:sp>
          <p:nvSpPr>
            <p:cNvPr id="62" name="椭圆 61">
              <a:extLst>
                <a:ext uri="{FF2B5EF4-FFF2-40B4-BE49-F238E27FC236}">
                  <a16:creationId xmlns:a16="http://schemas.microsoft.com/office/drawing/2014/main" id="{591445A8-CAD5-A92D-0B18-DE7705713DEA}"/>
                </a:ext>
              </a:extLst>
            </p:cNvPr>
            <p:cNvSpPr/>
            <p:nvPr/>
          </p:nvSpPr>
          <p:spPr>
            <a:xfrm>
              <a:off x="3913321" y="5613263"/>
              <a:ext cx="180000" cy="180000"/>
            </a:xfrm>
            <a:prstGeom prst="ellipse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000" b="1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黑体" panose="02010609060101010101" pitchFamily="49" charset="-122"/>
                  <a:ea typeface="黑体" panose="02010609060101010101" pitchFamily="49" charset="-122"/>
                  <a:cs typeface="Times New Roman" panose="02020603050405020304" pitchFamily="18" charset="0"/>
                  <a:sym typeface="+mn-ea"/>
                </a:rPr>
                <a:t>↑</a:t>
              </a:r>
            </a:p>
          </p:txBody>
        </p:sp>
        <p:sp>
          <p:nvSpPr>
            <p:cNvPr id="193" name="椭圆 178">
              <a:extLst>
                <a:ext uri="{FF2B5EF4-FFF2-40B4-BE49-F238E27FC236}">
                  <a16:creationId xmlns:a16="http://schemas.microsoft.com/office/drawing/2014/main" id="{8E235350-06E7-54E0-BC70-5DFB8BE3EACB}"/>
                </a:ext>
              </a:extLst>
            </p:cNvPr>
            <p:cNvSpPr/>
            <p:nvPr/>
          </p:nvSpPr>
          <p:spPr>
            <a:xfrm>
              <a:off x="4649277" y="6101928"/>
              <a:ext cx="180000" cy="180000"/>
            </a:xfrm>
            <a:prstGeom prst="ellipse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000" b="1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黑体" panose="02010609060101010101" pitchFamily="49" charset="-122"/>
                  <a:ea typeface="黑体" panose="02010609060101010101" pitchFamily="49" charset="-122"/>
                  <a:cs typeface="Times New Roman" panose="02020603050405020304" pitchFamily="18" charset="0"/>
                  <a:sym typeface="+mn-ea"/>
                </a:rPr>
                <a:t>↓</a:t>
              </a:r>
            </a:p>
          </p:txBody>
        </p:sp>
        <p:sp>
          <p:nvSpPr>
            <p:cNvPr id="8" name="椭圆 20">
              <a:extLst>
                <a:ext uri="{FF2B5EF4-FFF2-40B4-BE49-F238E27FC236}">
                  <a16:creationId xmlns:a16="http://schemas.microsoft.com/office/drawing/2014/main" id="{B6BDF15E-C723-3F13-1F31-6E9C00D2B1BD}"/>
                </a:ext>
              </a:extLst>
            </p:cNvPr>
            <p:cNvSpPr/>
            <p:nvPr/>
          </p:nvSpPr>
          <p:spPr>
            <a:xfrm>
              <a:off x="5378989" y="2671438"/>
              <a:ext cx="180000" cy="180000"/>
            </a:xfrm>
            <a:prstGeom prst="ellipse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zh-CN" sz="1000" b="1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黑体" panose="02010609060101010101" pitchFamily="49" charset="-122"/>
                <a:ea typeface="黑体" panose="02010609060101010101" pitchFamily="49" charset="-122"/>
                <a:cs typeface="Times New Roman" panose="02020603050405020304" pitchFamily="18" charset="0"/>
              </a:endParaRPr>
            </a:p>
          </p:txBody>
        </p:sp>
        <p:sp>
          <p:nvSpPr>
            <p:cNvPr id="9" name="椭圆 20">
              <a:extLst>
                <a:ext uri="{FF2B5EF4-FFF2-40B4-BE49-F238E27FC236}">
                  <a16:creationId xmlns:a16="http://schemas.microsoft.com/office/drawing/2014/main" id="{C237EF27-9A54-A350-B517-97D69CF04FF3}"/>
                </a:ext>
              </a:extLst>
            </p:cNvPr>
            <p:cNvSpPr/>
            <p:nvPr/>
          </p:nvSpPr>
          <p:spPr>
            <a:xfrm>
              <a:off x="4171917" y="2913184"/>
              <a:ext cx="180000" cy="180000"/>
            </a:xfrm>
            <a:prstGeom prst="ellipse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zh-CN" sz="1000" b="1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黑体" panose="02010609060101010101" pitchFamily="49" charset="-122"/>
                <a:ea typeface="黑体" panose="02010609060101010101" pitchFamily="49" charset="-122"/>
                <a:cs typeface="Times New Roman" panose="02020603050405020304" pitchFamily="18" charset="0"/>
              </a:endParaRPr>
            </a:p>
          </p:txBody>
        </p:sp>
        <p:sp>
          <p:nvSpPr>
            <p:cNvPr id="12" name="椭圆 20">
              <a:extLst>
                <a:ext uri="{FF2B5EF4-FFF2-40B4-BE49-F238E27FC236}">
                  <a16:creationId xmlns:a16="http://schemas.microsoft.com/office/drawing/2014/main" id="{30982C4E-8344-8776-4945-6679EDB51731}"/>
                </a:ext>
              </a:extLst>
            </p:cNvPr>
            <p:cNvSpPr/>
            <p:nvPr/>
          </p:nvSpPr>
          <p:spPr>
            <a:xfrm>
              <a:off x="5132621" y="3169150"/>
              <a:ext cx="180000" cy="180000"/>
            </a:xfrm>
            <a:prstGeom prst="ellipse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zh-CN" sz="1000" b="1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黑体" panose="02010609060101010101" pitchFamily="49" charset="-122"/>
                <a:ea typeface="黑体" panose="02010609060101010101" pitchFamily="49" charset="-122"/>
                <a:cs typeface="Times New Roman" panose="02020603050405020304" pitchFamily="18" charset="0"/>
              </a:endParaRPr>
            </a:p>
          </p:txBody>
        </p:sp>
        <p:sp>
          <p:nvSpPr>
            <p:cNvPr id="13" name="椭圆 20">
              <a:extLst>
                <a:ext uri="{FF2B5EF4-FFF2-40B4-BE49-F238E27FC236}">
                  <a16:creationId xmlns:a16="http://schemas.microsoft.com/office/drawing/2014/main" id="{2598B3F9-EF92-BFC6-04BA-5BEEFE90B0DF}"/>
                </a:ext>
              </a:extLst>
            </p:cNvPr>
            <p:cNvSpPr/>
            <p:nvPr/>
          </p:nvSpPr>
          <p:spPr>
            <a:xfrm>
              <a:off x="5132621" y="4140474"/>
              <a:ext cx="180000" cy="180000"/>
            </a:xfrm>
            <a:prstGeom prst="ellipse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zh-CN" sz="1000" b="1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黑体" panose="02010609060101010101" pitchFamily="49" charset="-122"/>
                <a:ea typeface="黑体" panose="02010609060101010101" pitchFamily="49" charset="-122"/>
                <a:cs typeface="Times New Roman" panose="02020603050405020304" pitchFamily="18" charset="0"/>
              </a:endParaRPr>
            </a:p>
          </p:txBody>
        </p:sp>
        <p:sp>
          <p:nvSpPr>
            <p:cNvPr id="15" name="椭圆 20">
              <a:extLst>
                <a:ext uri="{FF2B5EF4-FFF2-40B4-BE49-F238E27FC236}">
                  <a16:creationId xmlns:a16="http://schemas.microsoft.com/office/drawing/2014/main" id="{B1A1985D-1EAD-5E4B-F433-207D0A5F214F}"/>
                </a:ext>
              </a:extLst>
            </p:cNvPr>
            <p:cNvSpPr/>
            <p:nvPr/>
          </p:nvSpPr>
          <p:spPr>
            <a:xfrm>
              <a:off x="5154345" y="4398039"/>
              <a:ext cx="180000" cy="180000"/>
            </a:xfrm>
            <a:prstGeom prst="ellipse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zh-CN" sz="1000" b="1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黑体" panose="02010609060101010101" pitchFamily="49" charset="-122"/>
                <a:ea typeface="黑体" panose="02010609060101010101" pitchFamily="49" charset="-122"/>
                <a:cs typeface="Times New Roman" panose="02020603050405020304" pitchFamily="18" charset="0"/>
              </a:endParaRPr>
            </a:p>
          </p:txBody>
        </p:sp>
        <p:sp>
          <p:nvSpPr>
            <p:cNvPr id="22" name="椭圆 20">
              <a:extLst>
                <a:ext uri="{FF2B5EF4-FFF2-40B4-BE49-F238E27FC236}">
                  <a16:creationId xmlns:a16="http://schemas.microsoft.com/office/drawing/2014/main" id="{84247774-F6B0-301D-0419-DA52716A9D28}"/>
                </a:ext>
              </a:extLst>
            </p:cNvPr>
            <p:cNvSpPr/>
            <p:nvPr/>
          </p:nvSpPr>
          <p:spPr>
            <a:xfrm>
              <a:off x="5150389" y="4645689"/>
              <a:ext cx="180000" cy="180000"/>
            </a:xfrm>
            <a:prstGeom prst="ellipse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zh-CN" sz="1000" b="1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黑体" panose="02010609060101010101" pitchFamily="49" charset="-122"/>
                <a:ea typeface="黑体" panose="02010609060101010101" pitchFamily="49" charset="-122"/>
                <a:cs typeface="Times New Roman" panose="02020603050405020304" pitchFamily="18" charset="0"/>
              </a:endParaRPr>
            </a:p>
          </p:txBody>
        </p:sp>
        <p:sp>
          <p:nvSpPr>
            <p:cNvPr id="27" name="椭圆 20">
              <a:extLst>
                <a:ext uri="{FF2B5EF4-FFF2-40B4-BE49-F238E27FC236}">
                  <a16:creationId xmlns:a16="http://schemas.microsoft.com/office/drawing/2014/main" id="{7A3BD3B7-EEF1-BC14-3104-814A4BAB0A04}"/>
                </a:ext>
              </a:extLst>
            </p:cNvPr>
            <p:cNvSpPr/>
            <p:nvPr/>
          </p:nvSpPr>
          <p:spPr>
            <a:xfrm>
              <a:off x="5150389" y="4886122"/>
              <a:ext cx="180000" cy="180000"/>
            </a:xfrm>
            <a:prstGeom prst="ellipse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zh-CN" sz="1000" b="1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黑体" panose="02010609060101010101" pitchFamily="49" charset="-122"/>
                <a:ea typeface="黑体" panose="02010609060101010101" pitchFamily="49" charset="-122"/>
                <a:cs typeface="Times New Roman" panose="02020603050405020304" pitchFamily="18" charset="0"/>
              </a:endParaRPr>
            </a:p>
          </p:txBody>
        </p:sp>
        <p:sp>
          <p:nvSpPr>
            <p:cNvPr id="28" name="椭圆 20">
              <a:extLst>
                <a:ext uri="{FF2B5EF4-FFF2-40B4-BE49-F238E27FC236}">
                  <a16:creationId xmlns:a16="http://schemas.microsoft.com/office/drawing/2014/main" id="{F8175631-2EDB-E9A5-7C9A-3BA8D6FA3BA3}"/>
                </a:ext>
              </a:extLst>
            </p:cNvPr>
            <p:cNvSpPr/>
            <p:nvPr/>
          </p:nvSpPr>
          <p:spPr>
            <a:xfrm>
              <a:off x="3689745" y="4398039"/>
              <a:ext cx="180000" cy="180000"/>
            </a:xfrm>
            <a:prstGeom prst="ellipse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zh-CN" sz="1000" b="1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黑体" panose="02010609060101010101" pitchFamily="49" charset="-122"/>
                <a:ea typeface="黑体" panose="02010609060101010101" pitchFamily="49" charset="-122"/>
                <a:cs typeface="Times New Roman" panose="02020603050405020304" pitchFamily="18" charset="0"/>
              </a:endParaRPr>
            </a:p>
          </p:txBody>
        </p:sp>
        <p:sp>
          <p:nvSpPr>
            <p:cNvPr id="29" name="椭圆 20">
              <a:extLst>
                <a:ext uri="{FF2B5EF4-FFF2-40B4-BE49-F238E27FC236}">
                  <a16:creationId xmlns:a16="http://schemas.microsoft.com/office/drawing/2014/main" id="{D9204D3F-5B7E-D459-C409-3A716C2619EA}"/>
                </a:ext>
              </a:extLst>
            </p:cNvPr>
            <p:cNvSpPr/>
            <p:nvPr/>
          </p:nvSpPr>
          <p:spPr>
            <a:xfrm>
              <a:off x="5150389" y="5369452"/>
              <a:ext cx="180000" cy="180000"/>
            </a:xfrm>
            <a:prstGeom prst="ellipse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zh-CN" sz="1000" b="1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黑体" panose="02010609060101010101" pitchFamily="49" charset="-122"/>
                <a:ea typeface="黑体" panose="02010609060101010101" pitchFamily="49" charset="-122"/>
                <a:cs typeface="Times New Roman" panose="02020603050405020304" pitchFamily="18" charset="0"/>
              </a:endParaRPr>
            </a:p>
          </p:txBody>
        </p:sp>
        <p:sp>
          <p:nvSpPr>
            <p:cNvPr id="31" name="椭圆 20">
              <a:extLst>
                <a:ext uri="{FF2B5EF4-FFF2-40B4-BE49-F238E27FC236}">
                  <a16:creationId xmlns:a16="http://schemas.microsoft.com/office/drawing/2014/main" id="{83139344-5DA4-D71B-CF7E-E6B40EE88812}"/>
                </a:ext>
              </a:extLst>
            </p:cNvPr>
            <p:cNvSpPr/>
            <p:nvPr/>
          </p:nvSpPr>
          <p:spPr>
            <a:xfrm>
              <a:off x="4646155" y="5613263"/>
              <a:ext cx="180000" cy="180000"/>
            </a:xfrm>
            <a:prstGeom prst="ellipse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zh-CN" sz="1000" b="1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黑体" panose="02010609060101010101" pitchFamily="49" charset="-122"/>
                <a:ea typeface="黑体" panose="02010609060101010101" pitchFamily="49" charset="-122"/>
                <a:cs typeface="Times New Roman" panose="02020603050405020304" pitchFamily="18" charset="0"/>
              </a:endParaRPr>
            </a:p>
          </p:txBody>
        </p:sp>
        <p:sp>
          <p:nvSpPr>
            <p:cNvPr id="32" name="椭圆 20">
              <a:extLst>
                <a:ext uri="{FF2B5EF4-FFF2-40B4-BE49-F238E27FC236}">
                  <a16:creationId xmlns:a16="http://schemas.microsoft.com/office/drawing/2014/main" id="{C44C5DCB-9789-4AF4-C0CB-225F9470F953}"/>
                </a:ext>
              </a:extLst>
            </p:cNvPr>
            <p:cNvSpPr/>
            <p:nvPr/>
          </p:nvSpPr>
          <p:spPr>
            <a:xfrm>
              <a:off x="4416419" y="4878154"/>
              <a:ext cx="180000" cy="180000"/>
            </a:xfrm>
            <a:prstGeom prst="ellipse">
              <a:avLst/>
            </a:prstGeom>
            <a:solidFill>
              <a:srgbClr val="00B050"/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000" b="1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黑体" panose="02010609060101010101" pitchFamily="49" charset="-122"/>
                  <a:ea typeface="黑体" panose="02010609060101010101" pitchFamily="49" charset="-122"/>
                  <a:cs typeface="Times New Roman" panose="02020603050405020304" pitchFamily="18" charset="0"/>
                  <a:sym typeface="+mn-ea"/>
                </a:rPr>
                <a:t>↓</a:t>
              </a:r>
            </a:p>
          </p:txBody>
        </p:sp>
        <p:sp>
          <p:nvSpPr>
            <p:cNvPr id="38" name="椭圆 178">
              <a:extLst>
                <a:ext uri="{FF2B5EF4-FFF2-40B4-BE49-F238E27FC236}">
                  <a16:creationId xmlns:a16="http://schemas.microsoft.com/office/drawing/2014/main" id="{FF4014C1-A973-5662-BD82-885B3E4E0D9F}"/>
                </a:ext>
              </a:extLst>
            </p:cNvPr>
            <p:cNvSpPr/>
            <p:nvPr/>
          </p:nvSpPr>
          <p:spPr>
            <a:xfrm>
              <a:off x="4644404" y="5856756"/>
              <a:ext cx="180000" cy="180000"/>
            </a:xfrm>
            <a:prstGeom prst="ellipse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000" b="1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黑体" panose="02010609060101010101" pitchFamily="49" charset="-122"/>
                  <a:ea typeface="黑体" panose="02010609060101010101" pitchFamily="49" charset="-122"/>
                  <a:cs typeface="Times New Roman" panose="02020603050405020304" pitchFamily="18" charset="0"/>
                  <a:sym typeface="+mn-ea"/>
                </a:rPr>
                <a:t>↓</a:t>
              </a:r>
            </a:p>
          </p:txBody>
        </p:sp>
        <p:sp>
          <p:nvSpPr>
            <p:cNvPr id="40" name="椭圆 20">
              <a:extLst>
                <a:ext uri="{FF2B5EF4-FFF2-40B4-BE49-F238E27FC236}">
                  <a16:creationId xmlns:a16="http://schemas.microsoft.com/office/drawing/2014/main" id="{5D6C107B-A614-5075-B4A0-A6FB2539A6EA}"/>
                </a:ext>
              </a:extLst>
            </p:cNvPr>
            <p:cNvSpPr/>
            <p:nvPr/>
          </p:nvSpPr>
          <p:spPr>
            <a:xfrm>
              <a:off x="3925320" y="5856756"/>
              <a:ext cx="180000" cy="180000"/>
            </a:xfrm>
            <a:prstGeom prst="ellipse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zh-CN" sz="1000" b="1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黑体" panose="02010609060101010101" pitchFamily="49" charset="-122"/>
                <a:ea typeface="黑体" panose="02010609060101010101" pitchFamily="49" charset="-122"/>
                <a:cs typeface="Times New Roman" panose="02020603050405020304" pitchFamily="18" charset="0"/>
              </a:endParaRPr>
            </a:p>
          </p:txBody>
        </p:sp>
        <p:sp>
          <p:nvSpPr>
            <p:cNvPr id="41" name="椭圆 20">
              <a:extLst>
                <a:ext uri="{FF2B5EF4-FFF2-40B4-BE49-F238E27FC236}">
                  <a16:creationId xmlns:a16="http://schemas.microsoft.com/office/drawing/2014/main" id="{590BFF5C-FCE5-1BFE-CDEA-DB6D24B66E56}"/>
                </a:ext>
              </a:extLst>
            </p:cNvPr>
            <p:cNvSpPr/>
            <p:nvPr/>
          </p:nvSpPr>
          <p:spPr>
            <a:xfrm>
              <a:off x="5376467" y="5856756"/>
              <a:ext cx="180000" cy="180000"/>
            </a:xfrm>
            <a:prstGeom prst="ellipse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zh-CN" sz="1000" b="1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黑体" panose="02010609060101010101" pitchFamily="49" charset="-122"/>
                <a:ea typeface="黑体" panose="02010609060101010101" pitchFamily="49" charset="-122"/>
                <a:cs typeface="Times New Roman" panose="02020603050405020304" pitchFamily="18" charset="0"/>
              </a:endParaRPr>
            </a:p>
          </p:txBody>
        </p:sp>
        <p:sp>
          <p:nvSpPr>
            <p:cNvPr id="42" name="椭圆 20">
              <a:extLst>
                <a:ext uri="{FF2B5EF4-FFF2-40B4-BE49-F238E27FC236}">
                  <a16:creationId xmlns:a16="http://schemas.microsoft.com/office/drawing/2014/main" id="{1850C0D2-FD2B-6AED-6387-86320D59FC55}"/>
                </a:ext>
              </a:extLst>
            </p:cNvPr>
            <p:cNvSpPr/>
            <p:nvPr/>
          </p:nvSpPr>
          <p:spPr>
            <a:xfrm>
              <a:off x="3927842" y="6101928"/>
              <a:ext cx="180000" cy="180000"/>
            </a:xfrm>
            <a:prstGeom prst="ellipse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zh-CN" sz="1000" b="1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黑体" panose="02010609060101010101" pitchFamily="49" charset="-122"/>
                <a:ea typeface="黑体" panose="02010609060101010101" pitchFamily="49" charset="-122"/>
                <a:cs typeface="Times New Roman" panose="02020603050405020304" pitchFamily="18" charset="0"/>
              </a:endParaRPr>
            </a:p>
          </p:txBody>
        </p:sp>
        <p:sp>
          <p:nvSpPr>
            <p:cNvPr id="43" name="椭圆 20">
              <a:extLst>
                <a:ext uri="{FF2B5EF4-FFF2-40B4-BE49-F238E27FC236}">
                  <a16:creationId xmlns:a16="http://schemas.microsoft.com/office/drawing/2014/main" id="{31F5A817-5D4F-11E8-ACB3-A854C2F5A60C}"/>
                </a:ext>
              </a:extLst>
            </p:cNvPr>
            <p:cNvSpPr/>
            <p:nvPr/>
          </p:nvSpPr>
          <p:spPr>
            <a:xfrm>
              <a:off x="5376467" y="6112417"/>
              <a:ext cx="180000" cy="180000"/>
            </a:xfrm>
            <a:prstGeom prst="ellipse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zh-CN" sz="1000" b="1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黑体" panose="02010609060101010101" pitchFamily="49" charset="-122"/>
                <a:ea typeface="黑体" panose="02010609060101010101" pitchFamily="49" charset="-122"/>
                <a:cs typeface="Times New Roman" panose="02020603050405020304" pitchFamily="18" charset="0"/>
              </a:endParaRPr>
            </a:p>
          </p:txBody>
        </p:sp>
        <p:sp>
          <p:nvSpPr>
            <p:cNvPr id="217" name="TextBox 57">
              <a:extLst>
                <a:ext uri="{FF2B5EF4-FFF2-40B4-BE49-F238E27FC236}">
                  <a16:creationId xmlns:a16="http://schemas.microsoft.com/office/drawing/2014/main" id="{700C5413-2AC7-57A7-B9B8-3E86A811E356}"/>
                </a:ext>
              </a:extLst>
            </p:cNvPr>
            <p:cNvSpPr txBox="1"/>
            <p:nvPr/>
          </p:nvSpPr>
          <p:spPr>
            <a:xfrm>
              <a:off x="587687" y="6452116"/>
              <a:ext cx="5656377" cy="8726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69900">
                <a:lnSpc>
                  <a:spcPct val="130000"/>
                </a:lnSpc>
                <a:tabLst>
                  <a:tab pos="263525" algn="l"/>
                  <a:tab pos="3586163" algn="l"/>
                </a:tabLst>
                <a:defRPr/>
              </a:pPr>
              <a:r>
                <a:rPr lang="en-US" altLang="zh-CN" sz="1000">
                  <a:solidFill>
                    <a:prstClr val="black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  <a:sym typeface="+mn-ea"/>
                </a:rPr>
                <a:t>= Direction of group differences larger for (pre)frail vs non-grail   </a:t>
              </a:r>
              <a:r>
                <a:rPr kumimoji="0" lang="en-US" altLang="zh-CN" sz="100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  <a:sym typeface="+mn-ea"/>
                </a:rPr>
                <a:t>      =  smaller for (pre)frail vs non-frail; </a:t>
              </a:r>
            </a:p>
            <a:p>
              <a:pPr marR="0" lvl="0" algn="l" defTabSz="449263" rtl="0" eaLnBrk="1" fontAlgn="auto" latinLnBrk="0" hangingPunct="1">
                <a:lnSpc>
                  <a:spcPct val="13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263525" algn="l"/>
                </a:tabLst>
                <a:defRPr/>
              </a:pPr>
              <a:r>
                <a:rPr kumimoji="0" lang="en-US" altLang="zh-CN" sz="100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  <a:sym typeface="+mn-ea"/>
                </a:rPr>
                <a:t>= Significance between groups</a:t>
              </a:r>
              <a:r>
                <a:rPr lang="en-US" altLang="zh-CN" sz="1000">
                  <a:solidFill>
                    <a:prstClr val="black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  <a:sym typeface="+mn-ea"/>
                </a:rPr>
                <a:t> </a:t>
              </a:r>
              <a:r>
                <a:rPr kumimoji="0" lang="en-US" altLang="zh-CN" sz="1000" i="1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  <a:sym typeface="+mn-ea"/>
                </a:rPr>
                <a:t>p</a:t>
              </a:r>
              <a:r>
                <a:rPr kumimoji="0" lang="en-US" altLang="zh-CN" sz="100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  <a:sym typeface="+mn-ea"/>
                </a:rPr>
                <a:t>&lt;0.05 &amp; Cohen’s d &gt;0.5</a:t>
              </a:r>
            </a:p>
            <a:p>
              <a:pPr marL="3586163" marR="0" lvl="0" indent="-3586163" algn="l" defTabSz="457200" rtl="0" eaLnBrk="1" fontAlgn="auto" latinLnBrk="0" hangingPunct="1">
                <a:lnSpc>
                  <a:spcPct val="13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3495675" algn="l"/>
                </a:tabLst>
                <a:defRPr/>
              </a:pPr>
              <a:r>
                <a:rPr lang="en-US" altLang="zh-CN" sz="1000">
                  <a:solidFill>
                    <a:prstClr val="black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  <a:sym typeface="+mn-ea"/>
                </a:rPr>
                <a:t>= </a:t>
              </a:r>
              <a:r>
                <a:rPr kumimoji="0" lang="en-US" altLang="zh-CN" sz="1000" i="1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  <a:sym typeface="+mn-ea"/>
                </a:rPr>
                <a:t>p</a:t>
              </a:r>
              <a:r>
                <a:rPr kumimoji="0" lang="en-US" altLang="zh-CN" sz="100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  <a:sym typeface="+mn-ea"/>
                </a:rPr>
                <a:t>&lt;0.05 &amp; </a:t>
              </a:r>
              <a:r>
                <a:rPr lang="en-US" altLang="zh-CN" sz="1000">
                  <a:solidFill>
                    <a:prstClr val="black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  <a:sym typeface="+mn-ea"/>
                </a:rPr>
                <a:t>effect size </a:t>
              </a:r>
              <a:r>
                <a:rPr kumimoji="0" lang="en-US" altLang="zh-CN" sz="100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  <a:sym typeface="+mn-ea"/>
                </a:rPr>
                <a:t>not reported or &lt;0.5 &amp; no direction reported;</a:t>
              </a:r>
            </a:p>
            <a:p>
              <a:pPr marR="0" lvl="0" algn="l" defTabSz="457200" rtl="0" eaLnBrk="1" fontAlgn="auto" latinLnBrk="0" hangingPunct="1">
                <a:lnSpc>
                  <a:spcPct val="13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263525" algn="l"/>
                </a:tabLst>
                <a:defRPr/>
              </a:pPr>
              <a:r>
                <a:rPr lang="en-US" altLang="zh-CN" sz="1000">
                  <a:solidFill>
                    <a:prstClr val="black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  <a:sym typeface="+mn-ea"/>
                </a:rPr>
                <a:t> = Not significant between groups: </a:t>
              </a:r>
              <a:r>
                <a:rPr kumimoji="0" lang="en-US" altLang="zh-CN" sz="1000" i="1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  <a:sym typeface="+mn-ea"/>
                </a:rPr>
                <a:t>p</a:t>
              </a:r>
              <a:r>
                <a:rPr lang="en-US" altLang="zh-CN" sz="1000">
                  <a:solidFill>
                    <a:prstClr val="black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  <a:sym typeface="+mn-ea"/>
                </a:rPr>
                <a:t>&gt;</a:t>
              </a:r>
              <a:r>
                <a:rPr kumimoji="0" lang="en-US" altLang="zh-CN" sz="100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  <a:sym typeface="+mn-ea"/>
                </a:rPr>
                <a:t>0.05 or not reported. </a:t>
              </a:r>
              <a:endParaRPr lang="en-US" altLang="zh-CN" sz="100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+mn-ea"/>
              </a:endParaRPr>
            </a:p>
          </p:txBody>
        </p:sp>
        <p:sp>
          <p:nvSpPr>
            <p:cNvPr id="225" name="Up Arrow 224">
              <a:extLst>
                <a:ext uri="{FF2B5EF4-FFF2-40B4-BE49-F238E27FC236}">
                  <a16:creationId xmlns:a16="http://schemas.microsoft.com/office/drawing/2014/main" id="{E3CBE83D-813C-AC1B-2716-5DDB46D8310B}"/>
                </a:ext>
              </a:extLst>
            </p:cNvPr>
            <p:cNvSpPr/>
            <p:nvPr/>
          </p:nvSpPr>
          <p:spPr>
            <a:xfrm rot="10800000">
              <a:off x="4160858" y="6549304"/>
              <a:ext cx="56715" cy="107985"/>
            </a:xfrm>
            <a:prstGeom prst="upArrow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8" name="椭圆 217">
              <a:extLst>
                <a:ext uri="{FF2B5EF4-FFF2-40B4-BE49-F238E27FC236}">
                  <a16:creationId xmlns:a16="http://schemas.microsoft.com/office/drawing/2014/main" id="{B9A1D9A3-82AD-C1BB-79F8-D2D937300968}"/>
                </a:ext>
              </a:extLst>
            </p:cNvPr>
            <p:cNvSpPr/>
            <p:nvPr/>
          </p:nvSpPr>
          <p:spPr>
            <a:xfrm>
              <a:off x="532938" y="6741358"/>
              <a:ext cx="113608" cy="107985"/>
            </a:xfrm>
            <a:prstGeom prst="ellipse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zh-CN" sz="1000" b="1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Times New Roman" panose="02020603050405020304" pitchFamily="18" charset="0"/>
                <a:ea typeface="等线 Light" panose="02010600030101010101" pitchFamily="2" charset="-122"/>
                <a:cs typeface="Times New Roman" panose="02020603050405020304" pitchFamily="18" charset="0"/>
                <a:sym typeface="+mn-ea"/>
              </a:endParaRPr>
            </a:p>
          </p:txBody>
        </p:sp>
        <p:sp>
          <p:nvSpPr>
            <p:cNvPr id="220" name="椭圆 219">
              <a:extLst>
                <a:ext uri="{FF2B5EF4-FFF2-40B4-BE49-F238E27FC236}">
                  <a16:creationId xmlns:a16="http://schemas.microsoft.com/office/drawing/2014/main" id="{315FB750-F579-6E8A-C3E3-3E4CF8A1F206}"/>
                </a:ext>
              </a:extLst>
            </p:cNvPr>
            <p:cNvSpPr/>
            <p:nvPr/>
          </p:nvSpPr>
          <p:spPr>
            <a:xfrm>
              <a:off x="530883" y="7138585"/>
              <a:ext cx="113608" cy="107985"/>
            </a:xfrm>
            <a:prstGeom prst="ellipse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zh-CN" sz="1000" b="1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Times New Roman" panose="02020603050405020304" pitchFamily="18" charset="0"/>
                <a:ea typeface="等线 Light" panose="02010600030101010101" pitchFamily="2" charset="-122"/>
                <a:cs typeface="Times New Roman" panose="02020603050405020304" pitchFamily="18" charset="0"/>
                <a:sym typeface="+mn-ea"/>
              </a:endParaRPr>
            </a:p>
          </p:txBody>
        </p:sp>
        <p:sp>
          <p:nvSpPr>
            <p:cNvPr id="5" name="椭圆 218">
              <a:extLst>
                <a:ext uri="{FF2B5EF4-FFF2-40B4-BE49-F238E27FC236}">
                  <a16:creationId xmlns:a16="http://schemas.microsoft.com/office/drawing/2014/main" id="{B42ECCA4-8505-F697-2C06-F94423ED3D12}"/>
                </a:ext>
              </a:extLst>
            </p:cNvPr>
            <p:cNvSpPr/>
            <p:nvPr/>
          </p:nvSpPr>
          <p:spPr>
            <a:xfrm rot="21318129">
              <a:off x="532160" y="6947971"/>
              <a:ext cx="113608" cy="107985"/>
            </a:xfrm>
            <a:prstGeom prst="ellipse">
              <a:avLst/>
            </a:prstGeom>
            <a:solidFill>
              <a:srgbClr val="00B050"/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zh-CN" sz="1000" b="1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Times New Roman" panose="02020603050405020304" pitchFamily="18" charset="0"/>
                <a:ea typeface="等线 Light" panose="02010600030101010101" pitchFamily="2" charset="-122"/>
                <a:cs typeface="Times New Roman" panose="02020603050405020304" pitchFamily="18" charset="0"/>
                <a:sym typeface="+mn-ea"/>
              </a:endParaRPr>
            </a:p>
          </p:txBody>
        </p:sp>
        <p:sp>
          <p:nvSpPr>
            <p:cNvPr id="224" name="Up Arrow 223">
              <a:extLst>
                <a:ext uri="{FF2B5EF4-FFF2-40B4-BE49-F238E27FC236}">
                  <a16:creationId xmlns:a16="http://schemas.microsoft.com/office/drawing/2014/main" id="{731F72EE-2864-988F-A70A-0BAE903813C8}"/>
                </a:ext>
              </a:extLst>
            </p:cNvPr>
            <p:cNvSpPr/>
            <p:nvPr/>
          </p:nvSpPr>
          <p:spPr>
            <a:xfrm>
              <a:off x="562278" y="6527329"/>
              <a:ext cx="56715" cy="107985"/>
            </a:xfrm>
            <a:prstGeom prst="upArrow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文本框 44">
              <a:extLst>
                <a:ext uri="{FF2B5EF4-FFF2-40B4-BE49-F238E27FC236}">
                  <a16:creationId xmlns:a16="http://schemas.microsoft.com/office/drawing/2014/main" id="{4AB6BF11-BBFB-E6F9-F205-072BBCF9A29D}"/>
                </a:ext>
              </a:extLst>
            </p:cNvPr>
            <p:cNvSpPr txBox="1"/>
            <p:nvPr/>
          </p:nvSpPr>
          <p:spPr>
            <a:xfrm>
              <a:off x="473338" y="7399801"/>
              <a:ext cx="5716135" cy="55399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  <a:sym typeface="+mn-ea"/>
                </a:rPr>
                <a:t>AP Anteroposterior; ML mediolateral; VT vertical; PSD Power Spectral Density; DPA Daily Physical Activity; </a:t>
              </a:r>
              <a:r>
                <a:rPr kumimoji="0" lang="en-US" altLang="zh-CN" sz="10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  <a:sym typeface="+mn-ea"/>
                </a:rPr>
                <a:t>CoV</a:t>
              </a:r>
              <a:r>
                <a:rPr kumimoji="0" lang="en-US" altLang="zh-CN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  <a:sym typeface="+mn-ea"/>
                </a:rPr>
                <a:t> Coefficient of Variation; </a:t>
              </a:r>
              <a:r>
                <a:rPr kumimoji="0" lang="en-US" altLang="zh-CN" sz="10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  <a:sym typeface="+mn-ea"/>
                </a:rPr>
                <a:t>StSi</a:t>
              </a:r>
              <a:r>
                <a:rPr kumimoji="0" lang="en-US" altLang="zh-CN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  <a:sym typeface="+mn-ea"/>
                </a:rPr>
                <a:t> Stand to Sit; </a:t>
              </a:r>
              <a:r>
                <a:rPr kumimoji="0" lang="en-US" altLang="zh-CN" sz="10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  <a:sym typeface="+mn-ea"/>
                </a:rPr>
                <a:t>SiSt</a:t>
              </a:r>
              <a:r>
                <a:rPr kumimoji="0" lang="en-US" altLang="zh-CN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  <a:sym typeface="+mn-ea"/>
                </a:rPr>
                <a:t> Sit to Stand; </a:t>
              </a:r>
              <a:r>
                <a:rPr lang="en-US" altLang="zh-CN" sz="1000" dirty="0">
                  <a:solidFill>
                    <a:prstClr val="black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  <a:sym typeface="+mn-ea"/>
                </a:rPr>
                <a:t> </a:t>
              </a:r>
              <a:r>
                <a:rPr kumimoji="0" lang="en-US" altLang="zh-CN" sz="10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  <a:sym typeface="+mn-ea"/>
                </a:rPr>
                <a:t>SVMg</a:t>
              </a:r>
              <a:r>
                <a:rPr kumimoji="0" lang="en-US" altLang="zh-CN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  <a:sym typeface="+mn-ea"/>
                </a:rPr>
                <a:t> Signal Vector Magnitude; NF </a:t>
              </a:r>
              <a:r>
                <a:rPr kumimoji="0" lang="en-US" altLang="zh-CN" sz="10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  <a:sym typeface="+mn-ea"/>
                </a:rPr>
                <a:t>= Non-frail</a:t>
              </a:r>
              <a:r>
                <a:rPr kumimoji="0" lang="en-US" altLang="zh-CN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  <a:sym typeface="+mn-ea"/>
                </a:rPr>
                <a:t>; PF = Pre-frail; F </a:t>
              </a:r>
              <a:r>
                <a:rPr kumimoji="0" lang="en-US" altLang="zh-CN" sz="10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  <a:sym typeface="+mn-ea"/>
                </a:rPr>
                <a:t>= Frail</a:t>
              </a:r>
              <a:r>
                <a:rPr kumimoji="0" lang="en-US" altLang="zh-CN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  <a:sym typeface="+mn-ea"/>
                </a:rPr>
                <a:t>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117842035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MWFkZDRiZTVmNzRhYjYyZTA4NGFlMGQ2M2ViOWQ4MzEifQ=="/>
</p:tagLst>
</file>

<file path=ppt/theme/theme1.xml><?xml version="1.0" encoding="utf-8"?>
<a:theme xmlns:a="http://schemas.openxmlformats.org/drawingml/2006/main" name="Office 2013 - 2022 主题">
  <a:themeElements>
    <a:clrScheme name="Office 2013 - 2022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主题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6B1FB4CC5F67741AF40022676243C0B" ma:contentTypeVersion="12" ma:contentTypeDescription="Create a new document." ma:contentTypeScope="" ma:versionID="80f6ac383ca0a283ad60b70aafd4816a">
  <xsd:schema xmlns:xsd="http://www.w3.org/2001/XMLSchema" xmlns:xs="http://www.w3.org/2001/XMLSchema" xmlns:p="http://schemas.microsoft.com/office/2006/metadata/properties" xmlns:ns2="2faa9c80-d220-4fab-bf08-ad115468d1ff" xmlns:ns3="b388cf2c-ed63-4ffb-a929-88a4cdaa35bf" targetNamespace="http://schemas.microsoft.com/office/2006/metadata/properties" ma:root="true" ma:fieldsID="e4ee64457a586f5c492350cb7fc8195b" ns2:_="" ns3:_="">
    <xsd:import namespace="2faa9c80-d220-4fab-bf08-ad115468d1ff"/>
    <xsd:import namespace="b388cf2c-ed63-4ffb-a929-88a4cdaa35bf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lcf76f155ced4ddcb4097134ff3c332f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ObjectDetectorVersions" minOccurs="0"/>
                <xsd:element ref="ns3:SharedWithUsers" minOccurs="0"/>
                <xsd:element ref="ns3:SharedWithDetails" minOccurs="0"/>
                <xsd:element ref="ns2:MediaServiceSearchProperties" minOccurs="0"/>
                <xsd:element ref="ns2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faa9c80-d220-4fab-bf08-ad115468d1ff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lcf76f155ced4ddcb4097134ff3c332f" ma:index="11" nillable="true" ma:taxonomy="true" ma:internalName="lcf76f155ced4ddcb4097134ff3c332f" ma:taxonomyFieldName="MediaServiceImageTags" ma:displayName="Image Tags" ma:readOnly="false" ma:fieldId="{5cf76f15-5ced-4ddc-b409-7134ff3c332f}" ma:taxonomyMulti="true" ma:sspId="135eabb5-a18a-4215-84c6-3aa8d4454c81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2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bjectDetectorVersions" ma:index="15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8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DateTaken" ma:index="19" nillable="true" ma:displayName="MediaServiceDateTaken" ma:hidden="true" ma:indexed="true" ma:internalName="MediaServiceDateTake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388cf2c-ed63-4ffb-a929-88a4cdaa35bf" elementFormDefault="qualified">
    <xsd:import namespace="http://schemas.microsoft.com/office/2006/documentManagement/types"/>
    <xsd:import namespace="http://schemas.microsoft.com/office/infopath/2007/PartnerControls"/>
    <xsd:element name="SharedWithUsers" ma:index="16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7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2faa9c80-d220-4fab-bf08-ad115468d1ff">
      <Terms xmlns="http://schemas.microsoft.com/office/infopath/2007/PartnerControls"/>
    </lcf76f155ced4ddcb4097134ff3c332f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4253E5A6-120E-481E-80CC-17E8A475E7EA}">
  <ds:schemaRefs/>
</ds:datastoreItem>
</file>

<file path=customXml/itemProps2.xml><?xml version="1.0" encoding="utf-8"?>
<ds:datastoreItem xmlns:ds="http://schemas.openxmlformats.org/officeDocument/2006/customXml" ds:itemID="{09E66866-9047-4A89-8530-56279C22D981}">
  <ds:schemaRefs>
    <ds:schemaRef ds:uri="2faa9c80-d220-4fab-bf08-ad115468d1ff"/>
    <ds:schemaRef ds:uri="b388cf2c-ed63-4ffb-a929-88a4cdaa35bf"/>
    <ds:schemaRef ds:uri="http://purl.org/dc/dcmitype/"/>
    <ds:schemaRef ds:uri="http://purl.org/dc/elements/1.1/"/>
    <ds:schemaRef ds:uri="http://purl.org/dc/terms/"/>
    <ds:schemaRef ds:uri="http://schemas.microsoft.com/office/2006/documentManagement/types"/>
    <ds:schemaRef ds:uri="http://schemas.microsoft.com/office/2006/metadata/properties"/>
    <ds:schemaRef ds:uri="http://schemas.microsoft.com/office/infopath/2007/PartnerControls"/>
    <ds:schemaRef ds:uri="http://schemas.openxmlformats.org/package/2006/metadata/core-properties"/>
    <ds:schemaRef ds:uri="http://www.w3.org/XML/1998/namespace"/>
  </ds:schemaRefs>
</ds:datastoreItem>
</file>

<file path=customXml/itemProps3.xml><?xml version="1.0" encoding="utf-8"?>
<ds:datastoreItem xmlns:ds="http://schemas.openxmlformats.org/officeDocument/2006/customXml" ds:itemID="{7741BCCC-F647-4F5D-A578-B0093946F8B2}">
  <ds:schemaRefs/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0</TotalTime>
  <Words>314</Words>
  <Application>Microsoft Office PowerPoint</Application>
  <PresentationFormat>A4 纸张(210x297 毫米)</PresentationFormat>
  <Paragraphs>56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黑体</vt:lpstr>
      <vt:lpstr>Arial</vt:lpstr>
      <vt:lpstr>Calibri</vt:lpstr>
      <vt:lpstr>Calibri Light</vt:lpstr>
      <vt:lpstr>Times New Roman</vt:lpstr>
      <vt:lpstr>Office 2013 - 2022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张鑫</dc:creator>
  <cp:lastModifiedBy>Zhang, X (bw)</cp:lastModifiedBy>
  <cp:revision>3</cp:revision>
  <dcterms:created xsi:type="dcterms:W3CDTF">2023-10-26T13:53:00Z</dcterms:created>
  <dcterms:modified xsi:type="dcterms:W3CDTF">2025-02-19T06:29:1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4E09DEA2B2BB48848A00A4A368402FA1_13</vt:lpwstr>
  </property>
  <property fmtid="{D5CDD505-2E9C-101B-9397-08002B2CF9AE}" pid="3" name="KSOProductBuildVer">
    <vt:lpwstr>2052-12.1.0.18912</vt:lpwstr>
  </property>
  <property fmtid="{D5CDD505-2E9C-101B-9397-08002B2CF9AE}" pid="4" name="ContentTypeId">
    <vt:lpwstr>0x010100C6B1FB4CC5F67741AF40022676243C0B</vt:lpwstr>
  </property>
  <property fmtid="{D5CDD505-2E9C-101B-9397-08002B2CF9AE}" pid="5" name="MediaServiceImageTags">
    <vt:lpwstr/>
  </property>
</Properties>
</file>